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5" r:id="rId2"/>
    <p:sldId id="261" r:id="rId3"/>
    <p:sldId id="264" r:id="rId4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himpei" initials="SM" lastIdx="5" clrIdx="0"/>
  <p:cmAuthor id="2" name="SunFlare User(mizokami)" initials="mizokami" lastIdx="1" clrIdx="1"/>
  <p:cmAuthor id="3" name="Author" initials="A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266" autoAdjust="0"/>
    <p:restoredTop sz="95332" autoAdjust="0"/>
  </p:normalViewPr>
  <p:slideViewPr>
    <p:cSldViewPr snapToGrid="0" showGuides="1">
      <p:cViewPr varScale="1">
        <p:scale>
          <a:sx n="93" d="100"/>
          <a:sy n="93" d="100"/>
        </p:scale>
        <p:origin x="4304" y="200"/>
      </p:cViewPr>
      <p:guideLst>
        <p:guide orient="horz" pos="2880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agawatamotsu/Desktop/Fig%20HR&#12354;&#12426;&#12288;2020Sep16%20&#35299;&#26512;&#28168;&#12415;/FigS1/FigS1%20A,B(C%20vs%20B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agawatamotsu/Desktop/Fig%20HR&#12354;&#12426;&#12288;2020Sep16%20&#35299;&#26512;&#28168;&#12415;/FigS1/FigS1%20C,D(Cmab%20L%20vs%20R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agawaho/Desktop/Fig%20HR&#12354;&#12426;&#12288;2020Sep21%20New%20&#35299;&#26512;&#12377;&#12441;&#12415;/FigS1/FigS1%20A,B(C%20vs%20B)Sep20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agawaho/Desktop/Fig%20HR&#12354;&#12426;&#12288;2020Sep21%20New%20&#35299;&#26512;&#12377;&#12441;&#12415;/FigS1/FigS1%20C,D(Cmab%20L%20vs%20R)Sep20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agawatamotsu/Desktop/Fig%20HR&#12354;&#12426;&#12288;2020Sep16%20&#35299;&#26512;&#28168;&#12415;/FigS1/FigS1%20E,F(Bmab%20L%20vs%20R)%20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agawaho/Desktop/Fig%20HR&#12354;&#12426;&#12288;2020Sep21%20New%20&#35299;&#26512;&#12377;&#12441;&#12415;/FigS1/FigS1%20E,F(Bmab%20L%20vs%20R)Sep20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158</c:f>
              <c:strCache>
                <c:ptCount val="1"/>
                <c:pt idx="0">
                  <c:v>系列1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Sheet2!$A$159:$A$247</c:f>
              <c:numCache>
                <c:formatCode>General</c:formatCode>
                <c:ptCount val="89"/>
                <c:pt idx="0">
                  <c:v>0</c:v>
                </c:pt>
                <c:pt idx="1">
                  <c:v>0.5</c:v>
                </c:pt>
                <c:pt idx="2">
                  <c:v>0.5</c:v>
                </c:pt>
                <c:pt idx="3">
                  <c:v>1.5</c:v>
                </c:pt>
                <c:pt idx="4">
                  <c:v>1.5</c:v>
                </c:pt>
                <c:pt idx="5">
                  <c:v>1.6</c:v>
                </c:pt>
                <c:pt idx="6">
                  <c:v>1.6</c:v>
                </c:pt>
                <c:pt idx="7">
                  <c:v>1.7</c:v>
                </c:pt>
                <c:pt idx="8">
                  <c:v>1.7</c:v>
                </c:pt>
                <c:pt idx="9">
                  <c:v>1.9</c:v>
                </c:pt>
                <c:pt idx="10">
                  <c:v>1.9</c:v>
                </c:pt>
                <c:pt idx="11">
                  <c:v>2</c:v>
                </c:pt>
                <c:pt idx="12">
                  <c:v>2</c:v>
                </c:pt>
                <c:pt idx="13">
                  <c:v>2.7</c:v>
                </c:pt>
                <c:pt idx="14">
                  <c:v>2.7</c:v>
                </c:pt>
                <c:pt idx="15">
                  <c:v>2.8</c:v>
                </c:pt>
                <c:pt idx="16">
                  <c:v>2.8</c:v>
                </c:pt>
                <c:pt idx="17">
                  <c:v>4</c:v>
                </c:pt>
                <c:pt idx="18">
                  <c:v>4</c:v>
                </c:pt>
                <c:pt idx="19">
                  <c:v>4.0999999999999996</c:v>
                </c:pt>
                <c:pt idx="20">
                  <c:v>4.0999999999999996</c:v>
                </c:pt>
                <c:pt idx="21">
                  <c:v>4.3</c:v>
                </c:pt>
                <c:pt idx="22">
                  <c:v>4.5999999999999996</c:v>
                </c:pt>
                <c:pt idx="23">
                  <c:v>4.5999999999999996</c:v>
                </c:pt>
                <c:pt idx="24">
                  <c:v>5.3</c:v>
                </c:pt>
                <c:pt idx="25">
                  <c:v>5.3</c:v>
                </c:pt>
                <c:pt idx="26">
                  <c:v>6.5</c:v>
                </c:pt>
                <c:pt idx="27">
                  <c:v>6.5</c:v>
                </c:pt>
                <c:pt idx="28">
                  <c:v>6.8</c:v>
                </c:pt>
                <c:pt idx="29">
                  <c:v>6.8</c:v>
                </c:pt>
                <c:pt idx="30">
                  <c:v>7.7</c:v>
                </c:pt>
                <c:pt idx="31">
                  <c:v>7.7</c:v>
                </c:pt>
                <c:pt idx="32">
                  <c:v>8.1</c:v>
                </c:pt>
                <c:pt idx="33">
                  <c:v>8.1</c:v>
                </c:pt>
                <c:pt idx="34">
                  <c:v>8.4</c:v>
                </c:pt>
                <c:pt idx="35">
                  <c:v>8.4</c:v>
                </c:pt>
                <c:pt idx="36">
                  <c:v>8.6999999999999993</c:v>
                </c:pt>
                <c:pt idx="37">
                  <c:v>10.3</c:v>
                </c:pt>
                <c:pt idx="38">
                  <c:v>10.3</c:v>
                </c:pt>
                <c:pt idx="39">
                  <c:v>11.4</c:v>
                </c:pt>
                <c:pt idx="40">
                  <c:v>11.4</c:v>
                </c:pt>
                <c:pt idx="41">
                  <c:v>12.3</c:v>
                </c:pt>
                <c:pt idx="42">
                  <c:v>12.3</c:v>
                </c:pt>
                <c:pt idx="43">
                  <c:v>12.5</c:v>
                </c:pt>
                <c:pt idx="44">
                  <c:v>12.5</c:v>
                </c:pt>
                <c:pt idx="45">
                  <c:v>12.6</c:v>
                </c:pt>
                <c:pt idx="46">
                  <c:v>12.6</c:v>
                </c:pt>
                <c:pt idx="47">
                  <c:v>13</c:v>
                </c:pt>
                <c:pt idx="48">
                  <c:v>13</c:v>
                </c:pt>
                <c:pt idx="49">
                  <c:v>13.8</c:v>
                </c:pt>
                <c:pt idx="50">
                  <c:v>13.8</c:v>
                </c:pt>
                <c:pt idx="51">
                  <c:v>14.6</c:v>
                </c:pt>
                <c:pt idx="52">
                  <c:v>14.6</c:v>
                </c:pt>
                <c:pt idx="53">
                  <c:v>15.8</c:v>
                </c:pt>
                <c:pt idx="54">
                  <c:v>15.8</c:v>
                </c:pt>
                <c:pt idx="55">
                  <c:v>16.3</c:v>
                </c:pt>
                <c:pt idx="56">
                  <c:v>16.3</c:v>
                </c:pt>
                <c:pt idx="57">
                  <c:v>16.600000000000001</c:v>
                </c:pt>
                <c:pt idx="58">
                  <c:v>16.600000000000001</c:v>
                </c:pt>
                <c:pt idx="59">
                  <c:v>17.2</c:v>
                </c:pt>
                <c:pt idx="60">
                  <c:v>17.2</c:v>
                </c:pt>
                <c:pt idx="61">
                  <c:v>18</c:v>
                </c:pt>
                <c:pt idx="62">
                  <c:v>18</c:v>
                </c:pt>
                <c:pt idx="63">
                  <c:v>18.399999999999999</c:v>
                </c:pt>
                <c:pt idx="64">
                  <c:v>18.399999999999999</c:v>
                </c:pt>
                <c:pt idx="65">
                  <c:v>19</c:v>
                </c:pt>
                <c:pt idx="66">
                  <c:v>19</c:v>
                </c:pt>
                <c:pt idx="67">
                  <c:v>20.6</c:v>
                </c:pt>
                <c:pt idx="68">
                  <c:v>20.6</c:v>
                </c:pt>
                <c:pt idx="69">
                  <c:v>21.3</c:v>
                </c:pt>
                <c:pt idx="70">
                  <c:v>21.3</c:v>
                </c:pt>
                <c:pt idx="71">
                  <c:v>21.4</c:v>
                </c:pt>
                <c:pt idx="72">
                  <c:v>21.4</c:v>
                </c:pt>
                <c:pt idx="73">
                  <c:v>22.3</c:v>
                </c:pt>
                <c:pt idx="74">
                  <c:v>22.3</c:v>
                </c:pt>
                <c:pt idx="75">
                  <c:v>23.7</c:v>
                </c:pt>
                <c:pt idx="76">
                  <c:v>23.7</c:v>
                </c:pt>
                <c:pt idx="77">
                  <c:v>32.299999999999997</c:v>
                </c:pt>
                <c:pt idx="78">
                  <c:v>34.700000000000003</c:v>
                </c:pt>
                <c:pt idx="79">
                  <c:v>34.700000000000003</c:v>
                </c:pt>
                <c:pt idx="80">
                  <c:v>46.6</c:v>
                </c:pt>
                <c:pt idx="81">
                  <c:v>46.6</c:v>
                </c:pt>
                <c:pt idx="82">
                  <c:v>55.1</c:v>
                </c:pt>
                <c:pt idx="83">
                  <c:v>55.1</c:v>
                </c:pt>
                <c:pt idx="84">
                  <c:v>65.8</c:v>
                </c:pt>
                <c:pt idx="85">
                  <c:v>66.400000000000006</c:v>
                </c:pt>
                <c:pt idx="86">
                  <c:v>66.400000000000006</c:v>
                </c:pt>
                <c:pt idx="87">
                  <c:v>70.5</c:v>
                </c:pt>
                <c:pt idx="88">
                  <c:v>77.099999999999994</c:v>
                </c:pt>
              </c:numCache>
            </c:numRef>
          </c:xVal>
          <c:yVal>
            <c:numRef>
              <c:f>Sheet2!$B$159:$B$247</c:f>
              <c:numCache>
                <c:formatCode>0.0000</c:formatCode>
                <c:ptCount val="89"/>
                <c:pt idx="0">
                  <c:v>1</c:v>
                </c:pt>
                <c:pt idx="1">
                  <c:v>1</c:v>
                </c:pt>
                <c:pt idx="2">
                  <c:v>0.98</c:v>
                </c:pt>
                <c:pt idx="3" formatCode="General">
                  <c:v>0.98</c:v>
                </c:pt>
                <c:pt idx="4">
                  <c:v>0.96</c:v>
                </c:pt>
                <c:pt idx="5" formatCode="General">
                  <c:v>0.96</c:v>
                </c:pt>
                <c:pt idx="6">
                  <c:v>0.94</c:v>
                </c:pt>
                <c:pt idx="7" formatCode="General">
                  <c:v>0.94</c:v>
                </c:pt>
                <c:pt idx="8">
                  <c:v>0.92</c:v>
                </c:pt>
                <c:pt idx="9" formatCode="General">
                  <c:v>0.92</c:v>
                </c:pt>
                <c:pt idx="10">
                  <c:v>0.9</c:v>
                </c:pt>
                <c:pt idx="11" formatCode="General">
                  <c:v>0.9</c:v>
                </c:pt>
                <c:pt idx="12">
                  <c:v>0.88</c:v>
                </c:pt>
                <c:pt idx="13" formatCode="General">
                  <c:v>0.88</c:v>
                </c:pt>
                <c:pt idx="14">
                  <c:v>0.86</c:v>
                </c:pt>
                <c:pt idx="15" formatCode="General">
                  <c:v>0.86</c:v>
                </c:pt>
                <c:pt idx="16">
                  <c:v>0.84</c:v>
                </c:pt>
                <c:pt idx="17" formatCode="General">
                  <c:v>0.84</c:v>
                </c:pt>
                <c:pt idx="18">
                  <c:v>0.82</c:v>
                </c:pt>
                <c:pt idx="19" formatCode="General">
                  <c:v>0.82</c:v>
                </c:pt>
                <c:pt idx="20">
                  <c:v>0.8</c:v>
                </c:pt>
                <c:pt idx="21">
                  <c:v>0.8</c:v>
                </c:pt>
                <c:pt idx="22" formatCode="General">
                  <c:v>0.8</c:v>
                </c:pt>
                <c:pt idx="23">
                  <c:v>0.75897435897435905</c:v>
                </c:pt>
                <c:pt idx="24" formatCode="General">
                  <c:v>0.75897435897435905</c:v>
                </c:pt>
                <c:pt idx="25">
                  <c:v>0.73846153846153795</c:v>
                </c:pt>
                <c:pt idx="26" formatCode="General">
                  <c:v>0.73846153846153795</c:v>
                </c:pt>
                <c:pt idx="27">
                  <c:v>0.71794871794871795</c:v>
                </c:pt>
                <c:pt idx="28" formatCode="General">
                  <c:v>0.71794871794871795</c:v>
                </c:pt>
                <c:pt idx="29">
                  <c:v>0.67692307692307696</c:v>
                </c:pt>
                <c:pt idx="30" formatCode="General">
                  <c:v>0.67692307692307696</c:v>
                </c:pt>
                <c:pt idx="31">
                  <c:v>0.65641025641025597</c:v>
                </c:pt>
                <c:pt idx="32" formatCode="General">
                  <c:v>0.65641025641025597</c:v>
                </c:pt>
                <c:pt idx="33">
                  <c:v>0.61538461538461497</c:v>
                </c:pt>
                <c:pt idx="34" formatCode="General">
                  <c:v>0.61538461538461497</c:v>
                </c:pt>
                <c:pt idx="35">
                  <c:v>0.59487179487179498</c:v>
                </c:pt>
                <c:pt idx="36">
                  <c:v>0.59487179487179498</c:v>
                </c:pt>
                <c:pt idx="37" formatCode="General">
                  <c:v>0.59487179487179498</c:v>
                </c:pt>
                <c:pt idx="38">
                  <c:v>0.57362637362637303</c:v>
                </c:pt>
                <c:pt idx="39" formatCode="General">
                  <c:v>0.57362637362637303</c:v>
                </c:pt>
                <c:pt idx="40">
                  <c:v>0.55238095238095197</c:v>
                </c:pt>
                <c:pt idx="41" formatCode="General">
                  <c:v>0.55238095238095197</c:v>
                </c:pt>
                <c:pt idx="42">
                  <c:v>0.53113553113553102</c:v>
                </c:pt>
                <c:pt idx="43" formatCode="General">
                  <c:v>0.53113553113553102</c:v>
                </c:pt>
                <c:pt idx="44">
                  <c:v>0.50989010989010997</c:v>
                </c:pt>
                <c:pt idx="45" formatCode="General">
                  <c:v>0.50989010989010997</c:v>
                </c:pt>
                <c:pt idx="46">
                  <c:v>0.48864468864468802</c:v>
                </c:pt>
                <c:pt idx="47" formatCode="General">
                  <c:v>0.48864468864468802</c:v>
                </c:pt>
                <c:pt idx="48">
                  <c:v>0.46739926739926702</c:v>
                </c:pt>
                <c:pt idx="49" formatCode="General">
                  <c:v>0.46739926739926702</c:v>
                </c:pt>
                <c:pt idx="50">
                  <c:v>0.44615384615384601</c:v>
                </c:pt>
                <c:pt idx="51" formatCode="General">
                  <c:v>0.44615384615384601</c:v>
                </c:pt>
                <c:pt idx="52">
                  <c:v>0.42490842490842501</c:v>
                </c:pt>
                <c:pt idx="53" formatCode="General">
                  <c:v>0.42490842490842501</c:v>
                </c:pt>
                <c:pt idx="54">
                  <c:v>0.40366300366300301</c:v>
                </c:pt>
                <c:pt idx="55" formatCode="General">
                  <c:v>0.40366300366300301</c:v>
                </c:pt>
                <c:pt idx="56">
                  <c:v>0.382417582417582</c:v>
                </c:pt>
                <c:pt idx="57" formatCode="General">
                  <c:v>0.382417582417582</c:v>
                </c:pt>
                <c:pt idx="58">
                  <c:v>0.361172161172161</c:v>
                </c:pt>
                <c:pt idx="59" formatCode="General">
                  <c:v>0.361172161172161</c:v>
                </c:pt>
                <c:pt idx="60">
                  <c:v>0.33992673992674</c:v>
                </c:pt>
                <c:pt idx="61" formatCode="General">
                  <c:v>0.33992673992674</c:v>
                </c:pt>
                <c:pt idx="62">
                  <c:v>0.31868131868131799</c:v>
                </c:pt>
                <c:pt idx="63" formatCode="General">
                  <c:v>0.31868131868131799</c:v>
                </c:pt>
                <c:pt idx="64">
                  <c:v>0.29743589743589699</c:v>
                </c:pt>
                <c:pt idx="65" formatCode="General">
                  <c:v>0.29743589743589699</c:v>
                </c:pt>
                <c:pt idx="66">
                  <c:v>0.27619047619047599</c:v>
                </c:pt>
                <c:pt idx="67" formatCode="General">
                  <c:v>0.27619047619047599</c:v>
                </c:pt>
                <c:pt idx="68">
                  <c:v>0.25494505494505498</c:v>
                </c:pt>
                <c:pt idx="69" formatCode="General">
                  <c:v>0.25494505494505498</c:v>
                </c:pt>
                <c:pt idx="70">
                  <c:v>0.23369963369963401</c:v>
                </c:pt>
                <c:pt idx="71" formatCode="General">
                  <c:v>0.23369963369963401</c:v>
                </c:pt>
                <c:pt idx="72">
                  <c:v>0.212454212454212</c:v>
                </c:pt>
                <c:pt idx="73" formatCode="General">
                  <c:v>0.212454212454212</c:v>
                </c:pt>
                <c:pt idx="74">
                  <c:v>0.191208791208791</c:v>
                </c:pt>
                <c:pt idx="75" formatCode="General">
                  <c:v>0.191208791208791</c:v>
                </c:pt>
                <c:pt idx="76">
                  <c:v>0.16996336996337</c:v>
                </c:pt>
                <c:pt idx="77">
                  <c:v>0.16996336996337</c:v>
                </c:pt>
                <c:pt idx="78" formatCode="General">
                  <c:v>0.16996336996337</c:v>
                </c:pt>
                <c:pt idx="79">
                  <c:v>0.145682888540031</c:v>
                </c:pt>
                <c:pt idx="80" formatCode="General">
                  <c:v>0.145682888540031</c:v>
                </c:pt>
                <c:pt idx="81">
                  <c:v>0.12140240711669301</c:v>
                </c:pt>
                <c:pt idx="82" formatCode="General">
                  <c:v>0.12140240711669301</c:v>
                </c:pt>
                <c:pt idx="83">
                  <c:v>9.7121925693354205E-2</c:v>
                </c:pt>
                <c:pt idx="84">
                  <c:v>9.7121925693354205E-2</c:v>
                </c:pt>
                <c:pt idx="85" formatCode="General">
                  <c:v>9.7121925693354205E-2</c:v>
                </c:pt>
                <c:pt idx="86">
                  <c:v>6.4747950462236095E-2</c:v>
                </c:pt>
                <c:pt idx="87">
                  <c:v>6.4747950462236095E-2</c:v>
                </c:pt>
                <c:pt idx="88">
                  <c:v>6.474795046223609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197-EA44-8E77-5EED2C0A1AC2}"/>
            </c:ext>
          </c:extLst>
        </c:ser>
        <c:ser>
          <c:idx val="1"/>
          <c:order val="1"/>
          <c:tx>
            <c:strRef>
              <c:f>Sheet2!$E$158</c:f>
              <c:strCache>
                <c:ptCount val="1"/>
                <c:pt idx="0">
                  <c:v>系列2</c:v>
                </c:pt>
              </c:strCache>
            </c:strRef>
          </c:tx>
          <c:spPr>
            <a:ln w="12700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Sheet2!$D$159:$D$260</c:f>
              <c:numCache>
                <c:formatCode>General</c:formatCode>
                <c:ptCount val="102"/>
                <c:pt idx="0">
                  <c:v>0</c:v>
                </c:pt>
                <c:pt idx="1">
                  <c:v>1.9</c:v>
                </c:pt>
                <c:pt idx="2">
                  <c:v>1.9</c:v>
                </c:pt>
                <c:pt idx="3">
                  <c:v>2.8</c:v>
                </c:pt>
                <c:pt idx="4">
                  <c:v>2.8</c:v>
                </c:pt>
                <c:pt idx="5">
                  <c:v>3.4</c:v>
                </c:pt>
                <c:pt idx="6">
                  <c:v>3.4</c:v>
                </c:pt>
                <c:pt idx="7">
                  <c:v>3.8</c:v>
                </c:pt>
                <c:pt idx="8">
                  <c:v>3.8</c:v>
                </c:pt>
                <c:pt idx="9">
                  <c:v>3.9</c:v>
                </c:pt>
                <c:pt idx="10">
                  <c:v>3.9</c:v>
                </c:pt>
                <c:pt idx="11">
                  <c:v>4.2</c:v>
                </c:pt>
                <c:pt idx="12">
                  <c:v>4.2</c:v>
                </c:pt>
                <c:pt idx="13">
                  <c:v>4.5</c:v>
                </c:pt>
                <c:pt idx="14">
                  <c:v>4.5</c:v>
                </c:pt>
                <c:pt idx="15">
                  <c:v>4.7</c:v>
                </c:pt>
                <c:pt idx="16">
                  <c:v>4.7</c:v>
                </c:pt>
                <c:pt idx="17">
                  <c:v>5.0999999999999996</c:v>
                </c:pt>
                <c:pt idx="18">
                  <c:v>5.0999999999999996</c:v>
                </c:pt>
                <c:pt idx="19">
                  <c:v>5.4</c:v>
                </c:pt>
                <c:pt idx="20">
                  <c:v>5.4</c:v>
                </c:pt>
                <c:pt idx="21">
                  <c:v>5.8</c:v>
                </c:pt>
                <c:pt idx="22">
                  <c:v>5.8</c:v>
                </c:pt>
                <c:pt idx="23">
                  <c:v>5.9</c:v>
                </c:pt>
                <c:pt idx="24">
                  <c:v>5.9</c:v>
                </c:pt>
                <c:pt idx="25">
                  <c:v>6.3</c:v>
                </c:pt>
                <c:pt idx="26">
                  <c:v>6.3</c:v>
                </c:pt>
                <c:pt idx="27">
                  <c:v>6.5</c:v>
                </c:pt>
                <c:pt idx="28">
                  <c:v>6.5</c:v>
                </c:pt>
                <c:pt idx="29">
                  <c:v>6.7</c:v>
                </c:pt>
                <c:pt idx="30">
                  <c:v>6.7</c:v>
                </c:pt>
                <c:pt idx="31">
                  <c:v>6.8</c:v>
                </c:pt>
                <c:pt idx="32">
                  <c:v>6.8</c:v>
                </c:pt>
                <c:pt idx="33">
                  <c:v>7</c:v>
                </c:pt>
                <c:pt idx="34">
                  <c:v>7</c:v>
                </c:pt>
                <c:pt idx="35">
                  <c:v>7.3</c:v>
                </c:pt>
                <c:pt idx="36">
                  <c:v>7.3</c:v>
                </c:pt>
                <c:pt idx="37">
                  <c:v>8.1999999999999993</c:v>
                </c:pt>
                <c:pt idx="38">
                  <c:v>8.1999999999999993</c:v>
                </c:pt>
                <c:pt idx="39">
                  <c:v>8.3000000000000007</c:v>
                </c:pt>
                <c:pt idx="40">
                  <c:v>8.3000000000000007</c:v>
                </c:pt>
                <c:pt idx="41">
                  <c:v>8.6999999999999993</c:v>
                </c:pt>
                <c:pt idx="42">
                  <c:v>8.6999999999999993</c:v>
                </c:pt>
                <c:pt idx="43">
                  <c:v>9.1</c:v>
                </c:pt>
                <c:pt idx="44">
                  <c:v>9.1</c:v>
                </c:pt>
                <c:pt idx="45">
                  <c:v>9.9</c:v>
                </c:pt>
                <c:pt idx="46">
                  <c:v>9.9</c:v>
                </c:pt>
                <c:pt idx="47">
                  <c:v>10.199999999999999</c:v>
                </c:pt>
                <c:pt idx="48">
                  <c:v>10.199999999999999</c:v>
                </c:pt>
                <c:pt idx="49">
                  <c:v>10.7</c:v>
                </c:pt>
                <c:pt idx="50">
                  <c:v>10.7</c:v>
                </c:pt>
                <c:pt idx="51">
                  <c:v>10.9</c:v>
                </c:pt>
                <c:pt idx="52">
                  <c:v>10.9</c:v>
                </c:pt>
                <c:pt idx="53">
                  <c:v>11.1</c:v>
                </c:pt>
                <c:pt idx="54">
                  <c:v>11.1</c:v>
                </c:pt>
                <c:pt idx="55">
                  <c:v>11.6</c:v>
                </c:pt>
                <c:pt idx="56">
                  <c:v>11.6</c:v>
                </c:pt>
                <c:pt idx="57">
                  <c:v>11.9</c:v>
                </c:pt>
                <c:pt idx="58">
                  <c:v>11.9</c:v>
                </c:pt>
                <c:pt idx="59">
                  <c:v>12.2</c:v>
                </c:pt>
                <c:pt idx="60">
                  <c:v>12.2</c:v>
                </c:pt>
                <c:pt idx="61">
                  <c:v>12.3</c:v>
                </c:pt>
                <c:pt idx="62">
                  <c:v>12.3</c:v>
                </c:pt>
                <c:pt idx="63">
                  <c:v>12.7</c:v>
                </c:pt>
                <c:pt idx="64">
                  <c:v>12.7</c:v>
                </c:pt>
                <c:pt idx="65">
                  <c:v>13.3</c:v>
                </c:pt>
                <c:pt idx="66">
                  <c:v>13.3</c:v>
                </c:pt>
                <c:pt idx="67">
                  <c:v>13.9</c:v>
                </c:pt>
                <c:pt idx="68">
                  <c:v>13.9</c:v>
                </c:pt>
                <c:pt idx="69">
                  <c:v>14.1</c:v>
                </c:pt>
                <c:pt idx="70">
                  <c:v>14.1</c:v>
                </c:pt>
                <c:pt idx="71">
                  <c:v>15</c:v>
                </c:pt>
                <c:pt idx="72">
                  <c:v>15</c:v>
                </c:pt>
                <c:pt idx="73">
                  <c:v>15.4</c:v>
                </c:pt>
                <c:pt idx="74">
                  <c:v>15.4</c:v>
                </c:pt>
                <c:pt idx="75">
                  <c:v>15.5</c:v>
                </c:pt>
                <c:pt idx="76">
                  <c:v>15.5</c:v>
                </c:pt>
                <c:pt idx="77">
                  <c:v>16.3</c:v>
                </c:pt>
                <c:pt idx="78">
                  <c:v>16.3</c:v>
                </c:pt>
                <c:pt idx="79">
                  <c:v>16.8</c:v>
                </c:pt>
                <c:pt idx="80">
                  <c:v>16.8</c:v>
                </c:pt>
                <c:pt idx="81">
                  <c:v>17.3</c:v>
                </c:pt>
                <c:pt idx="82">
                  <c:v>17.3</c:v>
                </c:pt>
                <c:pt idx="83">
                  <c:v>17.399999999999999</c:v>
                </c:pt>
                <c:pt idx="84">
                  <c:v>17.399999999999999</c:v>
                </c:pt>
                <c:pt idx="85">
                  <c:v>19.600000000000001</c:v>
                </c:pt>
                <c:pt idx="86">
                  <c:v>19.600000000000001</c:v>
                </c:pt>
                <c:pt idx="87">
                  <c:v>22.8</c:v>
                </c:pt>
                <c:pt idx="88">
                  <c:v>22.8</c:v>
                </c:pt>
                <c:pt idx="89">
                  <c:v>26</c:v>
                </c:pt>
                <c:pt idx="90">
                  <c:v>26</c:v>
                </c:pt>
                <c:pt idx="91">
                  <c:v>32</c:v>
                </c:pt>
                <c:pt idx="92">
                  <c:v>32</c:v>
                </c:pt>
                <c:pt idx="93">
                  <c:v>33.6</c:v>
                </c:pt>
                <c:pt idx="94">
                  <c:v>33.6</c:v>
                </c:pt>
                <c:pt idx="95">
                  <c:v>33.9</c:v>
                </c:pt>
                <c:pt idx="96">
                  <c:v>33.9</c:v>
                </c:pt>
                <c:pt idx="97">
                  <c:v>35.6</c:v>
                </c:pt>
                <c:pt idx="98">
                  <c:v>35.6</c:v>
                </c:pt>
                <c:pt idx="99">
                  <c:v>39.299999999999997</c:v>
                </c:pt>
                <c:pt idx="100">
                  <c:v>39.299999999999997</c:v>
                </c:pt>
                <c:pt idx="101">
                  <c:v>48.7</c:v>
                </c:pt>
              </c:numCache>
            </c:numRef>
          </c:xVal>
          <c:yVal>
            <c:numRef>
              <c:f>Sheet2!$E$159:$E$260</c:f>
              <c:numCache>
                <c:formatCode>0.0000</c:formatCode>
                <c:ptCount val="102"/>
                <c:pt idx="0">
                  <c:v>1</c:v>
                </c:pt>
                <c:pt idx="1">
                  <c:v>1</c:v>
                </c:pt>
                <c:pt idx="2">
                  <c:v>0.96666666666666701</c:v>
                </c:pt>
                <c:pt idx="3" formatCode="General">
                  <c:v>0.96666666666666701</c:v>
                </c:pt>
                <c:pt idx="4">
                  <c:v>0.95</c:v>
                </c:pt>
                <c:pt idx="5" formatCode="General">
                  <c:v>0.95</c:v>
                </c:pt>
                <c:pt idx="6">
                  <c:v>0.93333333333333302</c:v>
                </c:pt>
                <c:pt idx="7" formatCode="General">
                  <c:v>0.93333333333333302</c:v>
                </c:pt>
                <c:pt idx="8">
                  <c:v>0.91666666666666596</c:v>
                </c:pt>
                <c:pt idx="9" formatCode="General">
                  <c:v>0.91666666666666596</c:v>
                </c:pt>
                <c:pt idx="10">
                  <c:v>0.9</c:v>
                </c:pt>
                <c:pt idx="11" formatCode="General">
                  <c:v>0.9</c:v>
                </c:pt>
                <c:pt idx="12">
                  <c:v>0.86666666666666603</c:v>
                </c:pt>
                <c:pt idx="13" formatCode="General">
                  <c:v>0.86666666666666603</c:v>
                </c:pt>
                <c:pt idx="14">
                  <c:v>0.83333333333333304</c:v>
                </c:pt>
                <c:pt idx="15" formatCode="General">
                  <c:v>0.83333333333333304</c:v>
                </c:pt>
                <c:pt idx="16">
                  <c:v>0.81666666666666599</c:v>
                </c:pt>
                <c:pt idx="17" formatCode="General">
                  <c:v>0.81666666666666599</c:v>
                </c:pt>
                <c:pt idx="18">
                  <c:v>0.8</c:v>
                </c:pt>
                <c:pt idx="19" formatCode="General">
                  <c:v>0.8</c:v>
                </c:pt>
                <c:pt idx="20">
                  <c:v>0.76666666666666605</c:v>
                </c:pt>
                <c:pt idx="21" formatCode="General">
                  <c:v>0.76666666666666605</c:v>
                </c:pt>
                <c:pt idx="22">
                  <c:v>0.75</c:v>
                </c:pt>
                <c:pt idx="23" formatCode="General">
                  <c:v>0.75</c:v>
                </c:pt>
                <c:pt idx="24">
                  <c:v>0.73333333333333295</c:v>
                </c:pt>
                <c:pt idx="25" formatCode="General">
                  <c:v>0.73333333333333295</c:v>
                </c:pt>
                <c:pt idx="26">
                  <c:v>0.7</c:v>
                </c:pt>
                <c:pt idx="27" formatCode="General">
                  <c:v>0.7</c:v>
                </c:pt>
                <c:pt idx="28">
                  <c:v>0.68333333333333302</c:v>
                </c:pt>
                <c:pt idx="29" formatCode="General">
                  <c:v>0.68333333333333302</c:v>
                </c:pt>
                <c:pt idx="30">
                  <c:v>0.65</c:v>
                </c:pt>
                <c:pt idx="31" formatCode="General">
                  <c:v>0.65</c:v>
                </c:pt>
                <c:pt idx="32">
                  <c:v>0.63333333333333297</c:v>
                </c:pt>
                <c:pt idx="33" formatCode="General">
                  <c:v>0.63333333333333297</c:v>
                </c:pt>
                <c:pt idx="34">
                  <c:v>0.61666666666666603</c:v>
                </c:pt>
                <c:pt idx="35" formatCode="General">
                  <c:v>0.61666666666666603</c:v>
                </c:pt>
                <c:pt idx="36">
                  <c:v>0.6</c:v>
                </c:pt>
                <c:pt idx="37" formatCode="General">
                  <c:v>0.6</c:v>
                </c:pt>
                <c:pt idx="38">
                  <c:v>0.58333333333333304</c:v>
                </c:pt>
                <c:pt idx="39" formatCode="General">
                  <c:v>0.58333333333333304</c:v>
                </c:pt>
                <c:pt idx="40">
                  <c:v>0.56666666666666599</c:v>
                </c:pt>
                <c:pt idx="41" formatCode="General">
                  <c:v>0.56666666666666599</c:v>
                </c:pt>
                <c:pt idx="42">
                  <c:v>0.55000000000000004</c:v>
                </c:pt>
                <c:pt idx="43" formatCode="General">
                  <c:v>0.55000000000000004</c:v>
                </c:pt>
                <c:pt idx="44">
                  <c:v>0.53333333333333299</c:v>
                </c:pt>
                <c:pt idx="45" formatCode="General">
                  <c:v>0.53333333333333299</c:v>
                </c:pt>
                <c:pt idx="46">
                  <c:v>0.51666666666666605</c:v>
                </c:pt>
                <c:pt idx="47" formatCode="General">
                  <c:v>0.51666666666666605</c:v>
                </c:pt>
                <c:pt idx="48">
                  <c:v>0.5</c:v>
                </c:pt>
                <c:pt idx="49" formatCode="General">
                  <c:v>0.5</c:v>
                </c:pt>
                <c:pt idx="50">
                  <c:v>0.483333333333333</c:v>
                </c:pt>
                <c:pt idx="51" formatCode="General">
                  <c:v>0.483333333333333</c:v>
                </c:pt>
                <c:pt idx="52">
                  <c:v>0.46666666666666601</c:v>
                </c:pt>
                <c:pt idx="53" formatCode="General">
                  <c:v>0.46666666666666601</c:v>
                </c:pt>
                <c:pt idx="54">
                  <c:v>0.45</c:v>
                </c:pt>
                <c:pt idx="55" formatCode="General">
                  <c:v>0.45</c:v>
                </c:pt>
                <c:pt idx="56">
                  <c:v>0.43333333333333302</c:v>
                </c:pt>
                <c:pt idx="57" formatCode="General">
                  <c:v>0.43333333333333302</c:v>
                </c:pt>
                <c:pt idx="58">
                  <c:v>0.41666666666666602</c:v>
                </c:pt>
                <c:pt idx="59" formatCode="General">
                  <c:v>0.41666666666666602</c:v>
                </c:pt>
                <c:pt idx="60">
                  <c:v>0.4</c:v>
                </c:pt>
                <c:pt idx="61" formatCode="General">
                  <c:v>0.4</c:v>
                </c:pt>
                <c:pt idx="62">
                  <c:v>0.38333333333333303</c:v>
                </c:pt>
                <c:pt idx="63" formatCode="General">
                  <c:v>0.38333333333333303</c:v>
                </c:pt>
                <c:pt idx="64">
                  <c:v>0.36666666666666597</c:v>
                </c:pt>
                <c:pt idx="65" formatCode="General">
                  <c:v>0.36666666666666597</c:v>
                </c:pt>
                <c:pt idx="66">
                  <c:v>0.33333333333333298</c:v>
                </c:pt>
                <c:pt idx="67" formatCode="General">
                  <c:v>0.33333333333333298</c:v>
                </c:pt>
                <c:pt idx="68">
                  <c:v>0.31666666666666599</c:v>
                </c:pt>
                <c:pt idx="69" formatCode="General">
                  <c:v>0.31666666666666599</c:v>
                </c:pt>
                <c:pt idx="70">
                  <c:v>0.28333333333333299</c:v>
                </c:pt>
                <c:pt idx="71" formatCode="General">
                  <c:v>0.28333333333333299</c:v>
                </c:pt>
                <c:pt idx="72">
                  <c:v>0.25</c:v>
                </c:pt>
                <c:pt idx="73" formatCode="General">
                  <c:v>0.25</c:v>
                </c:pt>
                <c:pt idx="74">
                  <c:v>0.233333333333333</c:v>
                </c:pt>
                <c:pt idx="75" formatCode="General">
                  <c:v>0.233333333333333</c:v>
                </c:pt>
                <c:pt idx="76">
                  <c:v>0.21666666666666701</c:v>
                </c:pt>
                <c:pt idx="77" formatCode="General">
                  <c:v>0.21666666666666701</c:v>
                </c:pt>
                <c:pt idx="78">
                  <c:v>0.2</c:v>
                </c:pt>
                <c:pt idx="79" formatCode="General">
                  <c:v>0.2</c:v>
                </c:pt>
                <c:pt idx="80">
                  <c:v>0.18333333333333299</c:v>
                </c:pt>
                <c:pt idx="81" formatCode="General">
                  <c:v>0.18333333333333299</c:v>
                </c:pt>
                <c:pt idx="82">
                  <c:v>0.16666666666666699</c:v>
                </c:pt>
                <c:pt idx="83" formatCode="General">
                  <c:v>0.16666666666666699</c:v>
                </c:pt>
                <c:pt idx="84">
                  <c:v>0.15</c:v>
                </c:pt>
                <c:pt idx="85" formatCode="General">
                  <c:v>0.15</c:v>
                </c:pt>
                <c:pt idx="86">
                  <c:v>0.133333333333333</c:v>
                </c:pt>
                <c:pt idx="87" formatCode="General">
                  <c:v>0.133333333333333</c:v>
                </c:pt>
                <c:pt idx="88">
                  <c:v>0.116666666666667</c:v>
                </c:pt>
                <c:pt idx="89" formatCode="General">
                  <c:v>0.116666666666667</c:v>
                </c:pt>
                <c:pt idx="90">
                  <c:v>9.9999999999999895E-2</c:v>
                </c:pt>
                <c:pt idx="91" formatCode="General">
                  <c:v>9.9999999999999895E-2</c:v>
                </c:pt>
                <c:pt idx="92">
                  <c:v>8.3333333333333301E-2</c:v>
                </c:pt>
                <c:pt idx="93" formatCode="General">
                  <c:v>8.3333333333333301E-2</c:v>
                </c:pt>
                <c:pt idx="94">
                  <c:v>6.6666666666666596E-2</c:v>
                </c:pt>
                <c:pt idx="95" formatCode="General">
                  <c:v>6.6666666666666596E-2</c:v>
                </c:pt>
                <c:pt idx="96">
                  <c:v>0.05</c:v>
                </c:pt>
                <c:pt idx="97" formatCode="General">
                  <c:v>0.05</c:v>
                </c:pt>
                <c:pt idx="98">
                  <c:v>3.3333333333333298E-2</c:v>
                </c:pt>
                <c:pt idx="99" formatCode="General">
                  <c:v>3.3333333333333298E-2</c:v>
                </c:pt>
                <c:pt idx="100">
                  <c:v>1.6666666666666701E-2</c:v>
                </c:pt>
                <c:pt idx="101">
                  <c:v>1.666666666666670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197-EA44-8E77-5EED2C0A1A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4095168"/>
        <c:axId val="814099200"/>
      </c:scatterChart>
      <c:valAx>
        <c:axId val="814095168"/>
        <c:scaling>
          <c:orientation val="minMax"/>
          <c:max val="11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JP"/>
          </a:p>
        </c:txPr>
        <c:crossAx val="814099200"/>
        <c:crosses val="autoZero"/>
        <c:crossBetween val="midCat"/>
      </c:valAx>
      <c:valAx>
        <c:axId val="814099200"/>
        <c:scaling>
          <c:orientation val="minMax"/>
          <c:max val="1.1000000000000001"/>
          <c:min val="0"/>
        </c:scaling>
        <c:delete val="0"/>
        <c:axPos val="l"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JP"/>
          </a:p>
        </c:txPr>
        <c:crossAx val="814095168"/>
        <c:crosses val="autoZero"/>
        <c:crossBetween val="midCat"/>
        <c:majorUnit val="0.2"/>
      </c:valAx>
      <c:spPr>
        <a:noFill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900"/>
      </a:pPr>
      <a:endParaRPr lang="en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109</c:f>
              <c:strCache>
                <c:ptCount val="1"/>
                <c:pt idx="0">
                  <c:v>系列1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Sheet2!$A$110:$A$178</c:f>
              <c:numCache>
                <c:formatCode>General</c:formatCode>
                <c:ptCount val="69"/>
                <c:pt idx="0">
                  <c:v>0</c:v>
                </c:pt>
                <c:pt idx="1">
                  <c:v>0.5</c:v>
                </c:pt>
                <c:pt idx="2">
                  <c:v>0.5</c:v>
                </c:pt>
                <c:pt idx="3">
                  <c:v>1.7</c:v>
                </c:pt>
                <c:pt idx="4">
                  <c:v>1.7</c:v>
                </c:pt>
                <c:pt idx="5">
                  <c:v>2.7</c:v>
                </c:pt>
                <c:pt idx="6">
                  <c:v>2.7</c:v>
                </c:pt>
                <c:pt idx="7">
                  <c:v>4</c:v>
                </c:pt>
                <c:pt idx="8">
                  <c:v>4</c:v>
                </c:pt>
                <c:pt idx="9">
                  <c:v>4.0999999999999996</c:v>
                </c:pt>
                <c:pt idx="10">
                  <c:v>4.0999999999999996</c:v>
                </c:pt>
                <c:pt idx="11">
                  <c:v>4.3</c:v>
                </c:pt>
                <c:pt idx="12">
                  <c:v>4.5999999999999996</c:v>
                </c:pt>
                <c:pt idx="13">
                  <c:v>4.5999999999999996</c:v>
                </c:pt>
                <c:pt idx="14">
                  <c:v>5.3</c:v>
                </c:pt>
                <c:pt idx="15">
                  <c:v>5.3</c:v>
                </c:pt>
                <c:pt idx="16">
                  <c:v>6.5</c:v>
                </c:pt>
                <c:pt idx="17">
                  <c:v>6.5</c:v>
                </c:pt>
                <c:pt idx="18">
                  <c:v>8.1</c:v>
                </c:pt>
                <c:pt idx="19">
                  <c:v>8.1</c:v>
                </c:pt>
                <c:pt idx="20">
                  <c:v>8.4</c:v>
                </c:pt>
                <c:pt idx="21">
                  <c:v>8.4</c:v>
                </c:pt>
                <c:pt idx="22">
                  <c:v>10.3</c:v>
                </c:pt>
                <c:pt idx="23">
                  <c:v>10.3</c:v>
                </c:pt>
                <c:pt idx="24">
                  <c:v>11.4</c:v>
                </c:pt>
                <c:pt idx="25">
                  <c:v>11.4</c:v>
                </c:pt>
                <c:pt idx="26">
                  <c:v>12.3</c:v>
                </c:pt>
                <c:pt idx="27">
                  <c:v>12.3</c:v>
                </c:pt>
                <c:pt idx="28">
                  <c:v>12.5</c:v>
                </c:pt>
                <c:pt idx="29">
                  <c:v>12.5</c:v>
                </c:pt>
                <c:pt idx="30">
                  <c:v>12.6</c:v>
                </c:pt>
                <c:pt idx="31">
                  <c:v>12.6</c:v>
                </c:pt>
                <c:pt idx="32">
                  <c:v>13</c:v>
                </c:pt>
                <c:pt idx="33">
                  <c:v>13</c:v>
                </c:pt>
                <c:pt idx="34">
                  <c:v>13.8</c:v>
                </c:pt>
                <c:pt idx="35">
                  <c:v>13.8</c:v>
                </c:pt>
                <c:pt idx="36">
                  <c:v>15.8</c:v>
                </c:pt>
                <c:pt idx="37">
                  <c:v>15.8</c:v>
                </c:pt>
                <c:pt idx="38">
                  <c:v>16.3</c:v>
                </c:pt>
                <c:pt idx="39">
                  <c:v>16.3</c:v>
                </c:pt>
                <c:pt idx="40">
                  <c:v>16.600000000000001</c:v>
                </c:pt>
                <c:pt idx="41">
                  <c:v>16.600000000000001</c:v>
                </c:pt>
                <c:pt idx="42">
                  <c:v>17.2</c:v>
                </c:pt>
                <c:pt idx="43">
                  <c:v>17.2</c:v>
                </c:pt>
                <c:pt idx="44">
                  <c:v>18</c:v>
                </c:pt>
                <c:pt idx="45">
                  <c:v>18</c:v>
                </c:pt>
                <c:pt idx="46">
                  <c:v>18.399999999999999</c:v>
                </c:pt>
                <c:pt idx="47">
                  <c:v>18.399999999999999</c:v>
                </c:pt>
                <c:pt idx="48">
                  <c:v>19</c:v>
                </c:pt>
                <c:pt idx="49">
                  <c:v>19</c:v>
                </c:pt>
                <c:pt idx="50">
                  <c:v>20.6</c:v>
                </c:pt>
                <c:pt idx="51">
                  <c:v>20.6</c:v>
                </c:pt>
                <c:pt idx="52">
                  <c:v>21.3</c:v>
                </c:pt>
                <c:pt idx="53">
                  <c:v>21.3</c:v>
                </c:pt>
                <c:pt idx="54">
                  <c:v>21.4</c:v>
                </c:pt>
                <c:pt idx="55">
                  <c:v>21.4</c:v>
                </c:pt>
                <c:pt idx="56">
                  <c:v>22.3</c:v>
                </c:pt>
                <c:pt idx="57">
                  <c:v>22.3</c:v>
                </c:pt>
                <c:pt idx="58">
                  <c:v>23.7</c:v>
                </c:pt>
                <c:pt idx="59">
                  <c:v>23.7</c:v>
                </c:pt>
                <c:pt idx="60">
                  <c:v>32.299999999999997</c:v>
                </c:pt>
                <c:pt idx="61">
                  <c:v>46.6</c:v>
                </c:pt>
                <c:pt idx="62">
                  <c:v>46.6</c:v>
                </c:pt>
                <c:pt idx="63">
                  <c:v>55.1</c:v>
                </c:pt>
                <c:pt idx="64">
                  <c:v>55.1</c:v>
                </c:pt>
                <c:pt idx="65">
                  <c:v>65.8</c:v>
                </c:pt>
                <c:pt idx="66">
                  <c:v>66.400000000000006</c:v>
                </c:pt>
                <c:pt idx="67">
                  <c:v>66.400000000000006</c:v>
                </c:pt>
                <c:pt idx="68">
                  <c:v>77.099999999999994</c:v>
                </c:pt>
              </c:numCache>
            </c:numRef>
          </c:xVal>
          <c:yVal>
            <c:numRef>
              <c:f>Sheet2!$B$110:$B$178</c:f>
              <c:numCache>
                <c:formatCode>0.0000</c:formatCode>
                <c:ptCount val="69"/>
                <c:pt idx="0">
                  <c:v>1</c:v>
                </c:pt>
                <c:pt idx="1">
                  <c:v>1</c:v>
                </c:pt>
                <c:pt idx="2">
                  <c:v>0.97222222222222199</c:v>
                </c:pt>
                <c:pt idx="3" formatCode="General">
                  <c:v>0.97222222222222199</c:v>
                </c:pt>
                <c:pt idx="4">
                  <c:v>0.94444444444444398</c:v>
                </c:pt>
                <c:pt idx="5" formatCode="General">
                  <c:v>0.94444444444444398</c:v>
                </c:pt>
                <c:pt idx="6">
                  <c:v>0.91666666666666696</c:v>
                </c:pt>
                <c:pt idx="7" formatCode="General">
                  <c:v>0.91666666666666696</c:v>
                </c:pt>
                <c:pt idx="8">
                  <c:v>0.88888888888888895</c:v>
                </c:pt>
                <c:pt idx="9" formatCode="General">
                  <c:v>0.88888888888888895</c:v>
                </c:pt>
                <c:pt idx="10">
                  <c:v>0.86111111111111105</c:v>
                </c:pt>
                <c:pt idx="11">
                  <c:v>0.86111111111111105</c:v>
                </c:pt>
                <c:pt idx="12" formatCode="General">
                  <c:v>0.86111111111111105</c:v>
                </c:pt>
                <c:pt idx="13">
                  <c:v>0.83240740740740704</c:v>
                </c:pt>
                <c:pt idx="14" formatCode="General">
                  <c:v>0.83240740740740704</c:v>
                </c:pt>
                <c:pt idx="15">
                  <c:v>0.80370370370370403</c:v>
                </c:pt>
                <c:pt idx="16" formatCode="General">
                  <c:v>0.80370370370370403</c:v>
                </c:pt>
                <c:pt idx="17">
                  <c:v>0.77500000000000002</c:v>
                </c:pt>
                <c:pt idx="18" formatCode="General">
                  <c:v>0.77500000000000002</c:v>
                </c:pt>
                <c:pt idx="19">
                  <c:v>0.74629629629629601</c:v>
                </c:pt>
                <c:pt idx="20" formatCode="General">
                  <c:v>0.74629629629629601</c:v>
                </c:pt>
                <c:pt idx="21">
                  <c:v>0.717592592592592</c:v>
                </c:pt>
                <c:pt idx="22" formatCode="General">
                  <c:v>0.717592592592592</c:v>
                </c:pt>
                <c:pt idx="23">
                  <c:v>0.68888888888888899</c:v>
                </c:pt>
                <c:pt idx="24" formatCode="General">
                  <c:v>0.68888888888888899</c:v>
                </c:pt>
                <c:pt idx="25">
                  <c:v>0.66018518518518499</c:v>
                </c:pt>
                <c:pt idx="26" formatCode="General">
                  <c:v>0.66018518518518499</c:v>
                </c:pt>
                <c:pt idx="27">
                  <c:v>0.63148148148148098</c:v>
                </c:pt>
                <c:pt idx="28" formatCode="General">
                  <c:v>0.63148148148148098</c:v>
                </c:pt>
                <c:pt idx="29">
                  <c:v>0.60277777777777797</c:v>
                </c:pt>
                <c:pt idx="30" formatCode="General">
                  <c:v>0.60277777777777797</c:v>
                </c:pt>
                <c:pt idx="31">
                  <c:v>0.57407407407407396</c:v>
                </c:pt>
                <c:pt idx="32" formatCode="General">
                  <c:v>0.57407407407407396</c:v>
                </c:pt>
                <c:pt idx="33">
                  <c:v>0.54537037037036995</c:v>
                </c:pt>
                <c:pt idx="34" formatCode="General">
                  <c:v>0.54537037037036995</c:v>
                </c:pt>
                <c:pt idx="35">
                  <c:v>0.51666666666666705</c:v>
                </c:pt>
                <c:pt idx="36" formatCode="General">
                  <c:v>0.51666666666666705</c:v>
                </c:pt>
                <c:pt idx="37">
                  <c:v>0.48796296296296299</c:v>
                </c:pt>
                <c:pt idx="38" formatCode="General">
                  <c:v>0.48796296296296299</c:v>
                </c:pt>
                <c:pt idx="39">
                  <c:v>0.45925925925925898</c:v>
                </c:pt>
                <c:pt idx="40" formatCode="General">
                  <c:v>0.45925925925925898</c:v>
                </c:pt>
                <c:pt idx="41">
                  <c:v>0.43055555555555503</c:v>
                </c:pt>
                <c:pt idx="42" formatCode="General">
                  <c:v>0.43055555555555503</c:v>
                </c:pt>
                <c:pt idx="43">
                  <c:v>0.40185185185185202</c:v>
                </c:pt>
                <c:pt idx="44" formatCode="General">
                  <c:v>0.40185185185185202</c:v>
                </c:pt>
                <c:pt idx="45">
                  <c:v>0.37314814814814801</c:v>
                </c:pt>
                <c:pt idx="46" formatCode="General">
                  <c:v>0.37314814814814801</c:v>
                </c:pt>
                <c:pt idx="47">
                  <c:v>0.344444444444444</c:v>
                </c:pt>
                <c:pt idx="48" formatCode="General">
                  <c:v>0.344444444444444</c:v>
                </c:pt>
                <c:pt idx="49">
                  <c:v>0.31574074074074099</c:v>
                </c:pt>
                <c:pt idx="50" formatCode="General">
                  <c:v>0.31574074074074099</c:v>
                </c:pt>
                <c:pt idx="51">
                  <c:v>0.28703703703703698</c:v>
                </c:pt>
                <c:pt idx="52" formatCode="General">
                  <c:v>0.28703703703703698</c:v>
                </c:pt>
                <c:pt idx="53">
                  <c:v>0.25833333333333303</c:v>
                </c:pt>
                <c:pt idx="54" formatCode="General">
                  <c:v>0.25833333333333303</c:v>
                </c:pt>
                <c:pt idx="55">
                  <c:v>0.22962962962962999</c:v>
                </c:pt>
                <c:pt idx="56" formatCode="General">
                  <c:v>0.22962962962962999</c:v>
                </c:pt>
                <c:pt idx="57">
                  <c:v>0.20092592592592601</c:v>
                </c:pt>
                <c:pt idx="58" formatCode="General">
                  <c:v>0.20092592592592601</c:v>
                </c:pt>
                <c:pt idx="59">
                  <c:v>0.172222222222222</c:v>
                </c:pt>
                <c:pt idx="60">
                  <c:v>0.172222222222222</c:v>
                </c:pt>
                <c:pt idx="61" formatCode="General">
                  <c:v>0.172222222222222</c:v>
                </c:pt>
                <c:pt idx="62">
                  <c:v>0.137777777777778</c:v>
                </c:pt>
                <c:pt idx="63" formatCode="General">
                  <c:v>0.137777777777778</c:v>
                </c:pt>
                <c:pt idx="64">
                  <c:v>0.103333333333333</c:v>
                </c:pt>
                <c:pt idx="65">
                  <c:v>0.103333333333333</c:v>
                </c:pt>
                <c:pt idx="66" formatCode="General">
                  <c:v>0.103333333333333</c:v>
                </c:pt>
                <c:pt idx="67">
                  <c:v>5.1666666666666597E-2</c:v>
                </c:pt>
                <c:pt idx="68">
                  <c:v>5.166666666666659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D67-BB4E-8D7D-04587C8659BE}"/>
            </c:ext>
          </c:extLst>
        </c:ser>
        <c:ser>
          <c:idx val="1"/>
          <c:order val="1"/>
          <c:tx>
            <c:strRef>
              <c:f>Sheet2!$E$109</c:f>
              <c:strCache>
                <c:ptCount val="1"/>
                <c:pt idx="0">
                  <c:v>系列2</c:v>
                </c:pt>
              </c:strCache>
            </c:strRef>
          </c:tx>
          <c:spPr>
            <a:ln w="12700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Sheet2!$D$110:$D$134</c:f>
              <c:numCache>
                <c:formatCode>General</c:formatCode>
                <c:ptCount val="25"/>
                <c:pt idx="0">
                  <c:v>0</c:v>
                </c:pt>
                <c:pt idx="1">
                  <c:v>1.5</c:v>
                </c:pt>
                <c:pt idx="2">
                  <c:v>1.5</c:v>
                </c:pt>
                <c:pt idx="3">
                  <c:v>1.6</c:v>
                </c:pt>
                <c:pt idx="4">
                  <c:v>1.6</c:v>
                </c:pt>
                <c:pt idx="5">
                  <c:v>1.9</c:v>
                </c:pt>
                <c:pt idx="6">
                  <c:v>1.9</c:v>
                </c:pt>
                <c:pt idx="7">
                  <c:v>2</c:v>
                </c:pt>
                <c:pt idx="8">
                  <c:v>2</c:v>
                </c:pt>
                <c:pt idx="9">
                  <c:v>2.8</c:v>
                </c:pt>
                <c:pt idx="10">
                  <c:v>2.8</c:v>
                </c:pt>
                <c:pt idx="11">
                  <c:v>4.5999999999999996</c:v>
                </c:pt>
                <c:pt idx="12">
                  <c:v>4.5999999999999996</c:v>
                </c:pt>
                <c:pt idx="13">
                  <c:v>6.8</c:v>
                </c:pt>
                <c:pt idx="14">
                  <c:v>6.8</c:v>
                </c:pt>
                <c:pt idx="15">
                  <c:v>7.7</c:v>
                </c:pt>
                <c:pt idx="16">
                  <c:v>7.7</c:v>
                </c:pt>
                <c:pt idx="17">
                  <c:v>8.1</c:v>
                </c:pt>
                <c:pt idx="18">
                  <c:v>8.1</c:v>
                </c:pt>
                <c:pt idx="19">
                  <c:v>8.6999999999999993</c:v>
                </c:pt>
                <c:pt idx="20">
                  <c:v>14.6</c:v>
                </c:pt>
                <c:pt idx="21">
                  <c:v>14.6</c:v>
                </c:pt>
                <c:pt idx="22">
                  <c:v>34.700000000000003</c:v>
                </c:pt>
                <c:pt idx="23">
                  <c:v>34.700000000000003</c:v>
                </c:pt>
                <c:pt idx="24">
                  <c:v>70.5</c:v>
                </c:pt>
              </c:numCache>
            </c:numRef>
          </c:xVal>
          <c:yVal>
            <c:numRef>
              <c:f>Sheet2!$E$110:$E$134</c:f>
              <c:numCache>
                <c:formatCode>0.0000</c:formatCode>
                <c:ptCount val="25"/>
                <c:pt idx="0">
                  <c:v>1</c:v>
                </c:pt>
                <c:pt idx="1">
                  <c:v>1</c:v>
                </c:pt>
                <c:pt idx="2">
                  <c:v>0.92857142857142905</c:v>
                </c:pt>
                <c:pt idx="3" formatCode="General">
                  <c:v>0.92857142857142905</c:v>
                </c:pt>
                <c:pt idx="4">
                  <c:v>0.85714285714285698</c:v>
                </c:pt>
                <c:pt idx="5" formatCode="General">
                  <c:v>0.85714285714285698</c:v>
                </c:pt>
                <c:pt idx="6">
                  <c:v>0.78571428571428603</c:v>
                </c:pt>
                <c:pt idx="7" formatCode="General">
                  <c:v>0.78571428571428603</c:v>
                </c:pt>
                <c:pt idx="8">
                  <c:v>0.71428571428571397</c:v>
                </c:pt>
                <c:pt idx="9" formatCode="General">
                  <c:v>0.71428571428571397</c:v>
                </c:pt>
                <c:pt idx="10">
                  <c:v>0.64285714285714302</c:v>
                </c:pt>
                <c:pt idx="11" formatCode="General">
                  <c:v>0.64285714285714302</c:v>
                </c:pt>
                <c:pt idx="12">
                  <c:v>0.57142857142857095</c:v>
                </c:pt>
                <c:pt idx="13" formatCode="General">
                  <c:v>0.57142857142857095</c:v>
                </c:pt>
                <c:pt idx="14">
                  <c:v>0.42857142857142899</c:v>
                </c:pt>
                <c:pt idx="15" formatCode="General">
                  <c:v>0.42857142857142899</c:v>
                </c:pt>
                <c:pt idx="16">
                  <c:v>0.35714285714285698</c:v>
                </c:pt>
                <c:pt idx="17" formatCode="General">
                  <c:v>0.35714285714285698</c:v>
                </c:pt>
                <c:pt idx="18">
                  <c:v>0.28571428571428598</c:v>
                </c:pt>
                <c:pt idx="19">
                  <c:v>0.28571428571428598</c:v>
                </c:pt>
                <c:pt idx="20" formatCode="General">
                  <c:v>0.28571428571428598</c:v>
                </c:pt>
                <c:pt idx="21">
                  <c:v>0.19047619047618999</c:v>
                </c:pt>
                <c:pt idx="22" formatCode="General">
                  <c:v>0.19047619047618999</c:v>
                </c:pt>
                <c:pt idx="23">
                  <c:v>9.5238095238095205E-2</c:v>
                </c:pt>
                <c:pt idx="24">
                  <c:v>9.523809523809520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D67-BB4E-8D7D-04587C8659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5556064"/>
        <c:axId val="815560096"/>
      </c:scatterChart>
      <c:valAx>
        <c:axId val="815556064"/>
        <c:scaling>
          <c:orientation val="minMax"/>
          <c:max val="11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JP"/>
          </a:p>
        </c:txPr>
        <c:crossAx val="815560096"/>
        <c:crosses val="autoZero"/>
        <c:crossBetween val="midCat"/>
      </c:valAx>
      <c:valAx>
        <c:axId val="815560096"/>
        <c:scaling>
          <c:orientation val="minMax"/>
          <c:max val="1.1000000000000001"/>
          <c:min val="0"/>
        </c:scaling>
        <c:delete val="0"/>
        <c:axPos val="l"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JP"/>
          </a:p>
        </c:txPr>
        <c:crossAx val="815556064"/>
        <c:crosses val="autoZero"/>
        <c:crossBetween val="midCat"/>
        <c:majorUnit val="0.2"/>
      </c:valAx>
      <c:spPr>
        <a:noFill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900"/>
      </a:pPr>
      <a:endParaRPr lang="en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7!$B$167</c:f>
              <c:strCache>
                <c:ptCount val="1"/>
                <c:pt idx="0">
                  <c:v>系列1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Sheet7!$A$168:$A$249</c:f>
              <c:numCache>
                <c:formatCode>General</c:formatCode>
                <c:ptCount val="82"/>
                <c:pt idx="0">
                  <c:v>0</c:v>
                </c:pt>
                <c:pt idx="1">
                  <c:v>1.8</c:v>
                </c:pt>
                <c:pt idx="2">
                  <c:v>1.8</c:v>
                </c:pt>
                <c:pt idx="3">
                  <c:v>3.6</c:v>
                </c:pt>
                <c:pt idx="4">
                  <c:v>3.6</c:v>
                </c:pt>
                <c:pt idx="5">
                  <c:v>4.3</c:v>
                </c:pt>
                <c:pt idx="6">
                  <c:v>6.5</c:v>
                </c:pt>
                <c:pt idx="7">
                  <c:v>6.5</c:v>
                </c:pt>
                <c:pt idx="8">
                  <c:v>6.6</c:v>
                </c:pt>
                <c:pt idx="9">
                  <c:v>6.6</c:v>
                </c:pt>
                <c:pt idx="10">
                  <c:v>8.1</c:v>
                </c:pt>
                <c:pt idx="11">
                  <c:v>8.1</c:v>
                </c:pt>
                <c:pt idx="12">
                  <c:v>8.4</c:v>
                </c:pt>
                <c:pt idx="13">
                  <c:v>8.4</c:v>
                </c:pt>
                <c:pt idx="14">
                  <c:v>8.6999999999999993</c:v>
                </c:pt>
                <c:pt idx="15">
                  <c:v>8.9</c:v>
                </c:pt>
                <c:pt idx="16">
                  <c:v>8.9</c:v>
                </c:pt>
                <c:pt idx="17">
                  <c:v>9.6999999999999993</c:v>
                </c:pt>
                <c:pt idx="18">
                  <c:v>9.6999999999999993</c:v>
                </c:pt>
                <c:pt idx="19">
                  <c:v>10.4</c:v>
                </c:pt>
                <c:pt idx="20">
                  <c:v>10.4</c:v>
                </c:pt>
                <c:pt idx="21">
                  <c:v>10.5</c:v>
                </c:pt>
                <c:pt idx="22">
                  <c:v>10.5</c:v>
                </c:pt>
                <c:pt idx="23">
                  <c:v>11.3</c:v>
                </c:pt>
                <c:pt idx="24">
                  <c:v>11.3</c:v>
                </c:pt>
                <c:pt idx="25">
                  <c:v>13.2</c:v>
                </c:pt>
                <c:pt idx="26">
                  <c:v>13.2</c:v>
                </c:pt>
                <c:pt idx="27">
                  <c:v>13.7</c:v>
                </c:pt>
                <c:pt idx="28">
                  <c:v>13.7</c:v>
                </c:pt>
                <c:pt idx="29">
                  <c:v>16.3</c:v>
                </c:pt>
                <c:pt idx="30">
                  <c:v>16.3</c:v>
                </c:pt>
                <c:pt idx="31">
                  <c:v>17.600000000000001</c:v>
                </c:pt>
                <c:pt idx="32">
                  <c:v>17.600000000000001</c:v>
                </c:pt>
                <c:pt idx="33">
                  <c:v>21.1</c:v>
                </c:pt>
                <c:pt idx="34">
                  <c:v>21.1</c:v>
                </c:pt>
                <c:pt idx="35">
                  <c:v>22.7</c:v>
                </c:pt>
                <c:pt idx="36">
                  <c:v>22.7</c:v>
                </c:pt>
                <c:pt idx="37">
                  <c:v>22.8</c:v>
                </c:pt>
                <c:pt idx="38">
                  <c:v>22.8</c:v>
                </c:pt>
                <c:pt idx="39">
                  <c:v>23</c:v>
                </c:pt>
                <c:pt idx="40">
                  <c:v>23</c:v>
                </c:pt>
                <c:pt idx="41">
                  <c:v>27.5</c:v>
                </c:pt>
                <c:pt idx="42">
                  <c:v>27.5</c:v>
                </c:pt>
                <c:pt idx="43">
                  <c:v>28.3</c:v>
                </c:pt>
                <c:pt idx="44">
                  <c:v>28.3</c:v>
                </c:pt>
                <c:pt idx="45">
                  <c:v>30.8</c:v>
                </c:pt>
                <c:pt idx="46">
                  <c:v>30.8</c:v>
                </c:pt>
                <c:pt idx="47">
                  <c:v>33.200000000000003</c:v>
                </c:pt>
                <c:pt idx="48">
                  <c:v>34</c:v>
                </c:pt>
                <c:pt idx="49">
                  <c:v>34.299999999999997</c:v>
                </c:pt>
                <c:pt idx="50">
                  <c:v>34.299999999999997</c:v>
                </c:pt>
                <c:pt idx="51">
                  <c:v>35.9</c:v>
                </c:pt>
                <c:pt idx="52">
                  <c:v>38</c:v>
                </c:pt>
                <c:pt idx="53">
                  <c:v>38</c:v>
                </c:pt>
                <c:pt idx="54">
                  <c:v>39.700000000000003</c:v>
                </c:pt>
                <c:pt idx="55">
                  <c:v>39.700000000000003</c:v>
                </c:pt>
                <c:pt idx="56">
                  <c:v>39.799999999999997</c:v>
                </c:pt>
                <c:pt idx="57">
                  <c:v>39.799999999999997</c:v>
                </c:pt>
                <c:pt idx="58">
                  <c:v>41.7</c:v>
                </c:pt>
                <c:pt idx="59">
                  <c:v>44.8</c:v>
                </c:pt>
                <c:pt idx="60">
                  <c:v>50.6</c:v>
                </c:pt>
                <c:pt idx="61">
                  <c:v>50.6</c:v>
                </c:pt>
                <c:pt idx="62">
                  <c:v>54.5</c:v>
                </c:pt>
                <c:pt idx="63">
                  <c:v>54.5</c:v>
                </c:pt>
                <c:pt idx="64">
                  <c:v>56.3</c:v>
                </c:pt>
                <c:pt idx="65">
                  <c:v>56.3</c:v>
                </c:pt>
                <c:pt idx="66">
                  <c:v>57.8</c:v>
                </c:pt>
                <c:pt idx="67">
                  <c:v>58.1</c:v>
                </c:pt>
                <c:pt idx="68">
                  <c:v>65.2</c:v>
                </c:pt>
                <c:pt idx="69">
                  <c:v>65.2</c:v>
                </c:pt>
                <c:pt idx="70">
                  <c:v>65.7</c:v>
                </c:pt>
                <c:pt idx="71">
                  <c:v>65.7</c:v>
                </c:pt>
                <c:pt idx="72">
                  <c:v>70.5</c:v>
                </c:pt>
                <c:pt idx="73">
                  <c:v>77.7</c:v>
                </c:pt>
                <c:pt idx="74">
                  <c:v>78.3</c:v>
                </c:pt>
                <c:pt idx="75">
                  <c:v>78.3</c:v>
                </c:pt>
                <c:pt idx="76">
                  <c:v>80.7</c:v>
                </c:pt>
                <c:pt idx="77">
                  <c:v>83.3</c:v>
                </c:pt>
                <c:pt idx="78">
                  <c:v>86.8</c:v>
                </c:pt>
                <c:pt idx="79">
                  <c:v>89.1</c:v>
                </c:pt>
                <c:pt idx="80">
                  <c:v>91.4</c:v>
                </c:pt>
                <c:pt idx="81">
                  <c:v>103.2</c:v>
                </c:pt>
              </c:numCache>
            </c:numRef>
          </c:xVal>
          <c:yVal>
            <c:numRef>
              <c:f>Sheet7!$B$168:$B$249</c:f>
              <c:numCache>
                <c:formatCode>0.0000</c:formatCode>
                <c:ptCount val="82"/>
                <c:pt idx="0">
                  <c:v>1</c:v>
                </c:pt>
                <c:pt idx="1">
                  <c:v>1</c:v>
                </c:pt>
                <c:pt idx="2">
                  <c:v>0.98</c:v>
                </c:pt>
                <c:pt idx="3" formatCode="General">
                  <c:v>0.98</c:v>
                </c:pt>
                <c:pt idx="4">
                  <c:v>0.96</c:v>
                </c:pt>
                <c:pt idx="5">
                  <c:v>0.96</c:v>
                </c:pt>
                <c:pt idx="6" formatCode="General">
                  <c:v>0.96</c:v>
                </c:pt>
                <c:pt idx="7">
                  <c:v>0.93957446808510603</c:v>
                </c:pt>
                <c:pt idx="8" formatCode="General">
                  <c:v>0.93957446808510603</c:v>
                </c:pt>
                <c:pt idx="9">
                  <c:v>0.91914893617021298</c:v>
                </c:pt>
                <c:pt idx="10" formatCode="General">
                  <c:v>0.91914893617021298</c:v>
                </c:pt>
                <c:pt idx="11">
                  <c:v>0.89872340425531905</c:v>
                </c:pt>
                <c:pt idx="12" formatCode="General">
                  <c:v>0.89872340425531905</c:v>
                </c:pt>
                <c:pt idx="13">
                  <c:v>0.878297872340426</c:v>
                </c:pt>
                <c:pt idx="14">
                  <c:v>0.878297872340426</c:v>
                </c:pt>
                <c:pt idx="15" formatCode="General">
                  <c:v>0.878297872340426</c:v>
                </c:pt>
                <c:pt idx="16">
                  <c:v>0.85738601823708205</c:v>
                </c:pt>
                <c:pt idx="17" formatCode="General">
                  <c:v>0.85738601823708205</c:v>
                </c:pt>
                <c:pt idx="18">
                  <c:v>0.83647416413373799</c:v>
                </c:pt>
                <c:pt idx="19" formatCode="General">
                  <c:v>0.83647416413373799</c:v>
                </c:pt>
                <c:pt idx="20">
                  <c:v>0.81556231003039503</c:v>
                </c:pt>
                <c:pt idx="21" formatCode="General">
                  <c:v>0.81556231003039503</c:v>
                </c:pt>
                <c:pt idx="22">
                  <c:v>0.79465045592705097</c:v>
                </c:pt>
                <c:pt idx="23" formatCode="General">
                  <c:v>0.79465045592705097</c:v>
                </c:pt>
                <c:pt idx="24">
                  <c:v>0.77373860182370802</c:v>
                </c:pt>
                <c:pt idx="25" formatCode="General">
                  <c:v>0.77373860182370802</c:v>
                </c:pt>
                <c:pt idx="26">
                  <c:v>0.75282674772036495</c:v>
                </c:pt>
                <c:pt idx="27" formatCode="General">
                  <c:v>0.75282674772036495</c:v>
                </c:pt>
                <c:pt idx="28">
                  <c:v>0.71100303951367805</c:v>
                </c:pt>
                <c:pt idx="29" formatCode="General">
                  <c:v>0.71100303951367805</c:v>
                </c:pt>
                <c:pt idx="30">
                  <c:v>0.69009118541033398</c:v>
                </c:pt>
                <c:pt idx="31" formatCode="General">
                  <c:v>0.69009118541033398</c:v>
                </c:pt>
                <c:pt idx="32">
                  <c:v>0.66917933130699103</c:v>
                </c:pt>
                <c:pt idx="33" formatCode="General">
                  <c:v>0.66917933130699103</c:v>
                </c:pt>
                <c:pt idx="34">
                  <c:v>0.64826747720364697</c:v>
                </c:pt>
                <c:pt idx="35" formatCode="General">
                  <c:v>0.64826747720364697</c:v>
                </c:pt>
                <c:pt idx="36">
                  <c:v>0.62735562310030402</c:v>
                </c:pt>
                <c:pt idx="37" formatCode="General">
                  <c:v>0.62735562310030402</c:v>
                </c:pt>
                <c:pt idx="38">
                  <c:v>0.60644376899695995</c:v>
                </c:pt>
                <c:pt idx="39" formatCode="General">
                  <c:v>0.60644376899695995</c:v>
                </c:pt>
                <c:pt idx="40">
                  <c:v>0.585531914893617</c:v>
                </c:pt>
                <c:pt idx="41" formatCode="General">
                  <c:v>0.585531914893617</c:v>
                </c:pt>
                <c:pt idx="42">
                  <c:v>0.56462006079027405</c:v>
                </c:pt>
                <c:pt idx="43" formatCode="General">
                  <c:v>0.56462006079027405</c:v>
                </c:pt>
                <c:pt idx="44">
                  <c:v>0.54370820668692998</c:v>
                </c:pt>
                <c:pt idx="45" formatCode="General">
                  <c:v>0.54370820668692998</c:v>
                </c:pt>
                <c:pt idx="46">
                  <c:v>0.52279635258358703</c:v>
                </c:pt>
                <c:pt idx="47">
                  <c:v>0.52279635258358703</c:v>
                </c:pt>
                <c:pt idx="48">
                  <c:v>0.52279635258358703</c:v>
                </c:pt>
                <c:pt idx="49" formatCode="General">
                  <c:v>0.52279635258358703</c:v>
                </c:pt>
                <c:pt idx="50">
                  <c:v>0.50006607638430001</c:v>
                </c:pt>
                <c:pt idx="51">
                  <c:v>0.50006607638430001</c:v>
                </c:pt>
                <c:pt idx="52" formatCode="General">
                  <c:v>0.50006607638430001</c:v>
                </c:pt>
                <c:pt idx="53">
                  <c:v>0.47625340608028599</c:v>
                </c:pt>
                <c:pt idx="54" formatCode="General">
                  <c:v>0.47625340608028599</c:v>
                </c:pt>
                <c:pt idx="55">
                  <c:v>0.45244073577627197</c:v>
                </c:pt>
                <c:pt idx="56" formatCode="General">
                  <c:v>0.45244073577627197</c:v>
                </c:pt>
                <c:pt idx="57">
                  <c:v>0.42862806547225701</c:v>
                </c:pt>
                <c:pt idx="58">
                  <c:v>0.42862806547225701</c:v>
                </c:pt>
                <c:pt idx="59">
                  <c:v>0.42862806547225701</c:v>
                </c:pt>
                <c:pt idx="60" formatCode="General">
                  <c:v>0.42862806547225701</c:v>
                </c:pt>
                <c:pt idx="61">
                  <c:v>0.40183881138024102</c:v>
                </c:pt>
                <c:pt idx="62" formatCode="General">
                  <c:v>0.40183881138024102</c:v>
                </c:pt>
                <c:pt idx="63">
                  <c:v>0.37504955728822498</c:v>
                </c:pt>
                <c:pt idx="64" formatCode="General">
                  <c:v>0.37504955728822498</c:v>
                </c:pt>
                <c:pt idx="65">
                  <c:v>0.34826030319620899</c:v>
                </c:pt>
                <c:pt idx="66">
                  <c:v>0.34826030319620899</c:v>
                </c:pt>
                <c:pt idx="67">
                  <c:v>0.34826030319620899</c:v>
                </c:pt>
                <c:pt idx="68" formatCode="General">
                  <c:v>0.34826030319620899</c:v>
                </c:pt>
                <c:pt idx="69">
                  <c:v>0.31660027563291698</c:v>
                </c:pt>
                <c:pt idx="70" formatCode="General">
                  <c:v>0.31660027563291698</c:v>
                </c:pt>
                <c:pt idx="71">
                  <c:v>0.28494024806962598</c:v>
                </c:pt>
                <c:pt idx="72">
                  <c:v>0.28494024806962598</c:v>
                </c:pt>
                <c:pt idx="73">
                  <c:v>0.28494024806962598</c:v>
                </c:pt>
                <c:pt idx="74" formatCode="General">
                  <c:v>0.28494024806962598</c:v>
                </c:pt>
                <c:pt idx="75">
                  <c:v>0.24423449834539299</c:v>
                </c:pt>
                <c:pt idx="76">
                  <c:v>0.24423449834539299</c:v>
                </c:pt>
                <c:pt idx="77">
                  <c:v>0.24423449834539299</c:v>
                </c:pt>
                <c:pt idx="78">
                  <c:v>0.24423449834539299</c:v>
                </c:pt>
                <c:pt idx="79">
                  <c:v>0.24423449834539299</c:v>
                </c:pt>
                <c:pt idx="80">
                  <c:v>0.24423449834539299</c:v>
                </c:pt>
                <c:pt idx="81">
                  <c:v>0.244234498345392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E9C-8449-84FC-16712518DE83}"/>
            </c:ext>
          </c:extLst>
        </c:ser>
        <c:ser>
          <c:idx val="1"/>
          <c:order val="1"/>
          <c:tx>
            <c:strRef>
              <c:f>Sheet7!$E$167</c:f>
              <c:strCache>
                <c:ptCount val="1"/>
                <c:pt idx="0">
                  <c:v>系列2</c:v>
                </c:pt>
              </c:strCache>
            </c:strRef>
          </c:tx>
          <c:spPr>
            <a:ln w="12700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Sheet7!$D$168:$D$272</c:f>
              <c:numCache>
                <c:formatCode>General</c:formatCode>
                <c:ptCount val="105"/>
                <c:pt idx="0">
                  <c:v>0</c:v>
                </c:pt>
                <c:pt idx="1">
                  <c:v>1.4</c:v>
                </c:pt>
                <c:pt idx="2">
                  <c:v>8.1999999999999993</c:v>
                </c:pt>
                <c:pt idx="3">
                  <c:v>8.1999999999999993</c:v>
                </c:pt>
                <c:pt idx="4">
                  <c:v>8.4</c:v>
                </c:pt>
                <c:pt idx="5">
                  <c:v>8.6999999999999993</c:v>
                </c:pt>
                <c:pt idx="6">
                  <c:v>8.6999999999999993</c:v>
                </c:pt>
                <c:pt idx="7">
                  <c:v>8.8000000000000007</c:v>
                </c:pt>
                <c:pt idx="8">
                  <c:v>8.8000000000000007</c:v>
                </c:pt>
                <c:pt idx="9">
                  <c:v>9</c:v>
                </c:pt>
                <c:pt idx="10">
                  <c:v>9</c:v>
                </c:pt>
                <c:pt idx="11">
                  <c:v>9.6999999999999993</c:v>
                </c:pt>
                <c:pt idx="12">
                  <c:v>9.6999999999999993</c:v>
                </c:pt>
                <c:pt idx="13">
                  <c:v>10.1</c:v>
                </c:pt>
                <c:pt idx="14">
                  <c:v>10.1</c:v>
                </c:pt>
                <c:pt idx="15">
                  <c:v>10.4</c:v>
                </c:pt>
                <c:pt idx="16">
                  <c:v>10.4</c:v>
                </c:pt>
                <c:pt idx="17">
                  <c:v>10.7</c:v>
                </c:pt>
                <c:pt idx="18">
                  <c:v>10.7</c:v>
                </c:pt>
                <c:pt idx="19">
                  <c:v>11.6</c:v>
                </c:pt>
                <c:pt idx="20">
                  <c:v>12.1</c:v>
                </c:pt>
                <c:pt idx="21">
                  <c:v>12.8</c:v>
                </c:pt>
                <c:pt idx="22">
                  <c:v>12.8</c:v>
                </c:pt>
                <c:pt idx="23">
                  <c:v>14</c:v>
                </c:pt>
                <c:pt idx="24">
                  <c:v>14</c:v>
                </c:pt>
                <c:pt idx="25">
                  <c:v>14.4</c:v>
                </c:pt>
                <c:pt idx="26">
                  <c:v>14.4</c:v>
                </c:pt>
                <c:pt idx="27">
                  <c:v>15.4</c:v>
                </c:pt>
                <c:pt idx="28">
                  <c:v>15.4</c:v>
                </c:pt>
                <c:pt idx="29">
                  <c:v>16.2</c:v>
                </c:pt>
                <c:pt idx="30">
                  <c:v>16.2</c:v>
                </c:pt>
                <c:pt idx="31">
                  <c:v>16.3</c:v>
                </c:pt>
                <c:pt idx="32">
                  <c:v>16.3</c:v>
                </c:pt>
                <c:pt idx="33">
                  <c:v>17.3</c:v>
                </c:pt>
                <c:pt idx="34">
                  <c:v>17.3</c:v>
                </c:pt>
                <c:pt idx="35">
                  <c:v>18.3</c:v>
                </c:pt>
                <c:pt idx="36">
                  <c:v>18.3</c:v>
                </c:pt>
                <c:pt idx="37">
                  <c:v>18.7</c:v>
                </c:pt>
                <c:pt idx="38">
                  <c:v>18.7</c:v>
                </c:pt>
                <c:pt idx="39">
                  <c:v>19</c:v>
                </c:pt>
                <c:pt idx="40">
                  <c:v>19</c:v>
                </c:pt>
                <c:pt idx="41">
                  <c:v>19.100000000000001</c:v>
                </c:pt>
                <c:pt idx="42">
                  <c:v>19.100000000000001</c:v>
                </c:pt>
                <c:pt idx="43">
                  <c:v>19.5</c:v>
                </c:pt>
                <c:pt idx="44">
                  <c:v>19.5</c:v>
                </c:pt>
                <c:pt idx="45">
                  <c:v>19.600000000000001</c:v>
                </c:pt>
                <c:pt idx="46">
                  <c:v>19.600000000000001</c:v>
                </c:pt>
                <c:pt idx="47">
                  <c:v>19.7</c:v>
                </c:pt>
                <c:pt idx="48">
                  <c:v>19.7</c:v>
                </c:pt>
                <c:pt idx="49">
                  <c:v>19.899999999999999</c:v>
                </c:pt>
                <c:pt idx="50">
                  <c:v>19.899999999999999</c:v>
                </c:pt>
                <c:pt idx="51">
                  <c:v>21.8</c:v>
                </c:pt>
                <c:pt idx="52">
                  <c:v>24.2</c:v>
                </c:pt>
                <c:pt idx="53">
                  <c:v>24.2</c:v>
                </c:pt>
                <c:pt idx="54">
                  <c:v>24.5</c:v>
                </c:pt>
                <c:pt idx="55">
                  <c:v>24.5</c:v>
                </c:pt>
                <c:pt idx="56">
                  <c:v>24.6</c:v>
                </c:pt>
                <c:pt idx="57">
                  <c:v>24.6</c:v>
                </c:pt>
                <c:pt idx="58">
                  <c:v>25.6</c:v>
                </c:pt>
                <c:pt idx="59">
                  <c:v>25.6</c:v>
                </c:pt>
                <c:pt idx="60">
                  <c:v>25.7</c:v>
                </c:pt>
                <c:pt idx="61">
                  <c:v>25.7</c:v>
                </c:pt>
                <c:pt idx="62">
                  <c:v>26.8</c:v>
                </c:pt>
                <c:pt idx="63">
                  <c:v>26.8</c:v>
                </c:pt>
                <c:pt idx="64">
                  <c:v>26.9</c:v>
                </c:pt>
                <c:pt idx="65">
                  <c:v>26.9</c:v>
                </c:pt>
                <c:pt idx="66">
                  <c:v>27.8</c:v>
                </c:pt>
                <c:pt idx="67">
                  <c:v>27.8</c:v>
                </c:pt>
                <c:pt idx="68">
                  <c:v>28</c:v>
                </c:pt>
                <c:pt idx="69">
                  <c:v>28</c:v>
                </c:pt>
                <c:pt idx="70">
                  <c:v>28.4</c:v>
                </c:pt>
                <c:pt idx="71">
                  <c:v>28.4</c:v>
                </c:pt>
                <c:pt idx="72">
                  <c:v>28.7</c:v>
                </c:pt>
                <c:pt idx="73">
                  <c:v>28.7</c:v>
                </c:pt>
                <c:pt idx="74">
                  <c:v>32.799999999999997</c:v>
                </c:pt>
                <c:pt idx="75">
                  <c:v>32.799999999999997</c:v>
                </c:pt>
                <c:pt idx="76">
                  <c:v>33.299999999999997</c:v>
                </c:pt>
                <c:pt idx="77">
                  <c:v>33.299999999999997</c:v>
                </c:pt>
                <c:pt idx="78">
                  <c:v>33.5</c:v>
                </c:pt>
                <c:pt idx="79">
                  <c:v>33.5</c:v>
                </c:pt>
                <c:pt idx="80">
                  <c:v>36.200000000000003</c:v>
                </c:pt>
                <c:pt idx="81">
                  <c:v>36.200000000000003</c:v>
                </c:pt>
                <c:pt idx="82">
                  <c:v>36.4</c:v>
                </c:pt>
                <c:pt idx="83">
                  <c:v>37.5</c:v>
                </c:pt>
                <c:pt idx="84">
                  <c:v>38.299999999999997</c:v>
                </c:pt>
                <c:pt idx="85">
                  <c:v>38.299999999999997</c:v>
                </c:pt>
                <c:pt idx="86">
                  <c:v>46.2</c:v>
                </c:pt>
                <c:pt idx="87">
                  <c:v>46.2</c:v>
                </c:pt>
                <c:pt idx="88">
                  <c:v>48</c:v>
                </c:pt>
                <c:pt idx="89">
                  <c:v>48</c:v>
                </c:pt>
                <c:pt idx="90">
                  <c:v>48.7</c:v>
                </c:pt>
                <c:pt idx="91">
                  <c:v>49.6</c:v>
                </c:pt>
                <c:pt idx="92">
                  <c:v>49.6</c:v>
                </c:pt>
                <c:pt idx="93">
                  <c:v>54.8</c:v>
                </c:pt>
                <c:pt idx="94">
                  <c:v>54.8</c:v>
                </c:pt>
                <c:pt idx="95">
                  <c:v>57.4</c:v>
                </c:pt>
                <c:pt idx="96">
                  <c:v>57.4</c:v>
                </c:pt>
                <c:pt idx="97">
                  <c:v>63.4</c:v>
                </c:pt>
                <c:pt idx="98">
                  <c:v>63.9</c:v>
                </c:pt>
                <c:pt idx="99">
                  <c:v>71.3</c:v>
                </c:pt>
                <c:pt idx="100">
                  <c:v>71.3</c:v>
                </c:pt>
                <c:pt idx="101">
                  <c:v>82.5</c:v>
                </c:pt>
                <c:pt idx="102">
                  <c:v>85.4</c:v>
                </c:pt>
                <c:pt idx="103">
                  <c:v>93.6</c:v>
                </c:pt>
                <c:pt idx="104">
                  <c:v>93.6</c:v>
                </c:pt>
              </c:numCache>
            </c:numRef>
          </c:xVal>
          <c:yVal>
            <c:numRef>
              <c:f>Sheet7!$E$168:$E$272</c:f>
              <c:numCache>
                <c:formatCode>0.0000</c:formatCode>
                <c:ptCount val="105"/>
                <c:pt idx="0">
                  <c:v>1</c:v>
                </c:pt>
                <c:pt idx="1">
                  <c:v>1</c:v>
                </c:pt>
                <c:pt idx="2" formatCode="General">
                  <c:v>1</c:v>
                </c:pt>
                <c:pt idx="3">
                  <c:v>0.98305084745762705</c:v>
                </c:pt>
                <c:pt idx="4">
                  <c:v>0.98305084745762705</c:v>
                </c:pt>
                <c:pt idx="5" formatCode="General">
                  <c:v>0.98305084745762705</c:v>
                </c:pt>
                <c:pt idx="6">
                  <c:v>0.96580434136187898</c:v>
                </c:pt>
                <c:pt idx="7" formatCode="General">
                  <c:v>0.96580434136187898</c:v>
                </c:pt>
                <c:pt idx="8">
                  <c:v>0.94855783526613102</c:v>
                </c:pt>
                <c:pt idx="9" formatCode="General">
                  <c:v>0.94855783526613102</c:v>
                </c:pt>
                <c:pt idx="10">
                  <c:v>0.93131132917038395</c:v>
                </c:pt>
                <c:pt idx="11" formatCode="General">
                  <c:v>0.93131132917038395</c:v>
                </c:pt>
                <c:pt idx="12">
                  <c:v>0.91406482307463599</c:v>
                </c:pt>
                <c:pt idx="13" formatCode="General">
                  <c:v>0.91406482307463599</c:v>
                </c:pt>
                <c:pt idx="14">
                  <c:v>0.89681831697888803</c:v>
                </c:pt>
                <c:pt idx="15" formatCode="General">
                  <c:v>0.89681831697888803</c:v>
                </c:pt>
                <c:pt idx="16">
                  <c:v>0.87957181088313996</c:v>
                </c:pt>
                <c:pt idx="17" formatCode="General">
                  <c:v>0.87957181088313996</c:v>
                </c:pt>
                <c:pt idx="18">
                  <c:v>0.862325304787392</c:v>
                </c:pt>
                <c:pt idx="19">
                  <c:v>0.862325304787392</c:v>
                </c:pt>
                <c:pt idx="20">
                  <c:v>0.862325304787392</c:v>
                </c:pt>
                <c:pt idx="21" formatCode="General">
                  <c:v>0.862325304787392</c:v>
                </c:pt>
                <c:pt idx="22">
                  <c:v>0.84436019427098796</c:v>
                </c:pt>
                <c:pt idx="23" formatCode="General">
                  <c:v>0.84436019427098796</c:v>
                </c:pt>
                <c:pt idx="24">
                  <c:v>0.82639508375458404</c:v>
                </c:pt>
                <c:pt idx="25" formatCode="General">
                  <c:v>0.82639508375458404</c:v>
                </c:pt>
                <c:pt idx="26">
                  <c:v>0.80842997323818</c:v>
                </c:pt>
                <c:pt idx="27" formatCode="General">
                  <c:v>0.80842997323818</c:v>
                </c:pt>
                <c:pt idx="28">
                  <c:v>0.77249975220537204</c:v>
                </c:pt>
                <c:pt idx="29" formatCode="General">
                  <c:v>0.77249975220537204</c:v>
                </c:pt>
                <c:pt idx="30">
                  <c:v>0.754534641688968</c:v>
                </c:pt>
                <c:pt idx="31" formatCode="General">
                  <c:v>0.754534641688968</c:v>
                </c:pt>
                <c:pt idx="32">
                  <c:v>0.73656953117256396</c:v>
                </c:pt>
                <c:pt idx="33" formatCode="General">
                  <c:v>0.73656953117256396</c:v>
                </c:pt>
                <c:pt idx="34">
                  <c:v>0.71860442065616004</c:v>
                </c:pt>
                <c:pt idx="35" formatCode="General">
                  <c:v>0.71860442065616004</c:v>
                </c:pt>
                <c:pt idx="36">
                  <c:v>0.700639310139756</c:v>
                </c:pt>
                <c:pt idx="37" formatCode="General">
                  <c:v>0.700639310139756</c:v>
                </c:pt>
                <c:pt idx="38">
                  <c:v>0.68267419962335196</c:v>
                </c:pt>
                <c:pt idx="39" formatCode="General">
                  <c:v>0.68267419962335196</c:v>
                </c:pt>
                <c:pt idx="40">
                  <c:v>0.646743978590544</c:v>
                </c:pt>
                <c:pt idx="41" formatCode="General">
                  <c:v>0.646743978590544</c:v>
                </c:pt>
                <c:pt idx="42">
                  <c:v>0.62877886807413996</c:v>
                </c:pt>
                <c:pt idx="43" formatCode="General">
                  <c:v>0.62877886807413996</c:v>
                </c:pt>
                <c:pt idx="44">
                  <c:v>0.61081375755773604</c:v>
                </c:pt>
                <c:pt idx="45" formatCode="General">
                  <c:v>0.61081375755773604</c:v>
                </c:pt>
                <c:pt idx="46">
                  <c:v>0.592848647041332</c:v>
                </c:pt>
                <c:pt idx="47" formatCode="General">
                  <c:v>0.592848647041332</c:v>
                </c:pt>
                <c:pt idx="48">
                  <c:v>0.57488353652492796</c:v>
                </c:pt>
                <c:pt idx="49" formatCode="General">
                  <c:v>0.57488353652492796</c:v>
                </c:pt>
                <c:pt idx="50">
                  <c:v>0.55691842600852404</c:v>
                </c:pt>
                <c:pt idx="51">
                  <c:v>0.55691842600852404</c:v>
                </c:pt>
                <c:pt idx="52" formatCode="General">
                  <c:v>0.55691842600852404</c:v>
                </c:pt>
                <c:pt idx="53">
                  <c:v>0.53835447847490603</c:v>
                </c:pt>
                <c:pt idx="54" formatCode="General">
                  <c:v>0.53835447847490603</c:v>
                </c:pt>
                <c:pt idx="55">
                  <c:v>0.51979053094128902</c:v>
                </c:pt>
                <c:pt idx="56" formatCode="General">
                  <c:v>0.51979053094128902</c:v>
                </c:pt>
                <c:pt idx="57">
                  <c:v>0.50122658340767101</c:v>
                </c:pt>
                <c:pt idx="58" formatCode="General">
                  <c:v>0.50122658340767101</c:v>
                </c:pt>
                <c:pt idx="59">
                  <c:v>0.482662635874054</c:v>
                </c:pt>
                <c:pt idx="60" formatCode="General">
                  <c:v>0.482662635874054</c:v>
                </c:pt>
                <c:pt idx="61">
                  <c:v>0.46409868834043599</c:v>
                </c:pt>
                <c:pt idx="62" formatCode="General">
                  <c:v>0.46409868834043599</c:v>
                </c:pt>
                <c:pt idx="63">
                  <c:v>0.44553474080681899</c:v>
                </c:pt>
                <c:pt idx="64" formatCode="General">
                  <c:v>0.44553474080681899</c:v>
                </c:pt>
                <c:pt idx="65">
                  <c:v>0.42697079327320198</c:v>
                </c:pt>
                <c:pt idx="66" formatCode="General">
                  <c:v>0.42697079327320198</c:v>
                </c:pt>
                <c:pt idx="67">
                  <c:v>0.40840684573958402</c:v>
                </c:pt>
                <c:pt idx="68" formatCode="General">
                  <c:v>0.40840684573958402</c:v>
                </c:pt>
                <c:pt idx="69">
                  <c:v>0.38984289820596701</c:v>
                </c:pt>
                <c:pt idx="70" formatCode="General">
                  <c:v>0.38984289820596701</c:v>
                </c:pt>
                <c:pt idx="71">
                  <c:v>0.37127895067234901</c:v>
                </c:pt>
                <c:pt idx="72" formatCode="General">
                  <c:v>0.37127895067234901</c:v>
                </c:pt>
                <c:pt idx="73">
                  <c:v>0.352715003138732</c:v>
                </c:pt>
                <c:pt idx="74" formatCode="General">
                  <c:v>0.352715003138732</c:v>
                </c:pt>
                <c:pt idx="75">
                  <c:v>0.33415105560511399</c:v>
                </c:pt>
                <c:pt idx="76" formatCode="General">
                  <c:v>0.33415105560511399</c:v>
                </c:pt>
                <c:pt idx="77">
                  <c:v>0.31558710807149698</c:v>
                </c:pt>
                <c:pt idx="78" formatCode="General">
                  <c:v>0.31558710807149698</c:v>
                </c:pt>
                <c:pt idx="79">
                  <c:v>0.29702316053787903</c:v>
                </c:pt>
                <c:pt idx="80" formatCode="General">
                  <c:v>0.29702316053787903</c:v>
                </c:pt>
                <c:pt idx="81">
                  <c:v>0.27845921300426202</c:v>
                </c:pt>
                <c:pt idx="82">
                  <c:v>0.27845921300426202</c:v>
                </c:pt>
                <c:pt idx="83">
                  <c:v>0.27845921300426202</c:v>
                </c:pt>
                <c:pt idx="84" formatCode="General">
                  <c:v>0.27845921300426202</c:v>
                </c:pt>
                <c:pt idx="85">
                  <c:v>0.25703927354239597</c:v>
                </c:pt>
                <c:pt idx="86" formatCode="General">
                  <c:v>0.25703927354239597</c:v>
                </c:pt>
                <c:pt idx="87">
                  <c:v>0.23561933408052901</c:v>
                </c:pt>
                <c:pt idx="88" formatCode="General">
                  <c:v>0.23561933408052901</c:v>
                </c:pt>
                <c:pt idx="89">
                  <c:v>0.214199394618663</c:v>
                </c:pt>
                <c:pt idx="90">
                  <c:v>0.214199394618663</c:v>
                </c:pt>
                <c:pt idx="91" formatCode="General">
                  <c:v>0.214199394618663</c:v>
                </c:pt>
                <c:pt idx="92">
                  <c:v>0.19039946188325599</c:v>
                </c:pt>
                <c:pt idx="93" formatCode="General">
                  <c:v>0.19039946188325599</c:v>
                </c:pt>
                <c:pt idx="94">
                  <c:v>0.16659952914784901</c:v>
                </c:pt>
                <c:pt idx="95" formatCode="General">
                  <c:v>0.16659952914784901</c:v>
                </c:pt>
                <c:pt idx="96">
                  <c:v>0.142799596412442</c:v>
                </c:pt>
                <c:pt idx="97">
                  <c:v>0.142799596412442</c:v>
                </c:pt>
                <c:pt idx="98">
                  <c:v>0.142799596412442</c:v>
                </c:pt>
                <c:pt idx="99" formatCode="General">
                  <c:v>0.142799596412442</c:v>
                </c:pt>
                <c:pt idx="100">
                  <c:v>0.107099697309331</c:v>
                </c:pt>
                <c:pt idx="101">
                  <c:v>0.107099697309331</c:v>
                </c:pt>
                <c:pt idx="102">
                  <c:v>0.107099697309331</c:v>
                </c:pt>
                <c:pt idx="103" formatCode="General">
                  <c:v>0.107099697309331</c:v>
                </c:pt>
                <c:pt idx="10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E9C-8449-84FC-16712518DE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94336288"/>
        <c:axId val="-294332800"/>
      </c:scatterChart>
      <c:valAx>
        <c:axId val="-294336288"/>
        <c:scaling>
          <c:orientation val="minMax"/>
          <c:max val="11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JP"/>
          </a:p>
        </c:txPr>
        <c:crossAx val="-294332800"/>
        <c:crosses val="autoZero"/>
        <c:crossBetween val="midCat"/>
      </c:valAx>
      <c:valAx>
        <c:axId val="-294332800"/>
        <c:scaling>
          <c:orientation val="minMax"/>
          <c:max val="1.1000000000000001"/>
          <c:min val="0"/>
        </c:scaling>
        <c:delete val="0"/>
        <c:axPos val="l"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JP"/>
          </a:p>
        </c:txPr>
        <c:crossAx val="-294336288"/>
        <c:crosses val="autoZero"/>
        <c:crossBetween val="midCat"/>
        <c:majorUnit val="0.2"/>
      </c:valAx>
      <c:spPr>
        <a:noFill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900"/>
      </a:pPr>
      <a:endParaRPr lang="en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5!$B$110</c:f>
              <c:strCache>
                <c:ptCount val="1"/>
                <c:pt idx="0">
                  <c:v>系列1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Sheet5!$A$111:$A$168</c:f>
              <c:numCache>
                <c:formatCode>General</c:formatCode>
                <c:ptCount val="58"/>
                <c:pt idx="0">
                  <c:v>0</c:v>
                </c:pt>
                <c:pt idx="1">
                  <c:v>4.3</c:v>
                </c:pt>
                <c:pt idx="2">
                  <c:v>6.5</c:v>
                </c:pt>
                <c:pt idx="3">
                  <c:v>6.5</c:v>
                </c:pt>
                <c:pt idx="4">
                  <c:v>6.6</c:v>
                </c:pt>
                <c:pt idx="5">
                  <c:v>6.6</c:v>
                </c:pt>
                <c:pt idx="6">
                  <c:v>8.1</c:v>
                </c:pt>
                <c:pt idx="7">
                  <c:v>8.1</c:v>
                </c:pt>
                <c:pt idx="8">
                  <c:v>8.9</c:v>
                </c:pt>
                <c:pt idx="9">
                  <c:v>8.9</c:v>
                </c:pt>
                <c:pt idx="10">
                  <c:v>13.7</c:v>
                </c:pt>
                <c:pt idx="11">
                  <c:v>13.7</c:v>
                </c:pt>
                <c:pt idx="12">
                  <c:v>16.3</c:v>
                </c:pt>
                <c:pt idx="13">
                  <c:v>16.3</c:v>
                </c:pt>
                <c:pt idx="14">
                  <c:v>17.600000000000001</c:v>
                </c:pt>
                <c:pt idx="15">
                  <c:v>17.600000000000001</c:v>
                </c:pt>
                <c:pt idx="16">
                  <c:v>21.1</c:v>
                </c:pt>
                <c:pt idx="17">
                  <c:v>21.1</c:v>
                </c:pt>
                <c:pt idx="18">
                  <c:v>22.7</c:v>
                </c:pt>
                <c:pt idx="19">
                  <c:v>22.7</c:v>
                </c:pt>
                <c:pt idx="20">
                  <c:v>22.8</c:v>
                </c:pt>
                <c:pt idx="21">
                  <c:v>22.8</c:v>
                </c:pt>
                <c:pt idx="22">
                  <c:v>23</c:v>
                </c:pt>
                <c:pt idx="23">
                  <c:v>23</c:v>
                </c:pt>
                <c:pt idx="24">
                  <c:v>27.5</c:v>
                </c:pt>
                <c:pt idx="25">
                  <c:v>27.5</c:v>
                </c:pt>
                <c:pt idx="26">
                  <c:v>28.3</c:v>
                </c:pt>
                <c:pt idx="27">
                  <c:v>28.3</c:v>
                </c:pt>
                <c:pt idx="28">
                  <c:v>30.8</c:v>
                </c:pt>
                <c:pt idx="29">
                  <c:v>30.8</c:v>
                </c:pt>
                <c:pt idx="30">
                  <c:v>33.200000000000003</c:v>
                </c:pt>
                <c:pt idx="31">
                  <c:v>34</c:v>
                </c:pt>
                <c:pt idx="32">
                  <c:v>35.9</c:v>
                </c:pt>
                <c:pt idx="33">
                  <c:v>38</c:v>
                </c:pt>
                <c:pt idx="34">
                  <c:v>38</c:v>
                </c:pt>
                <c:pt idx="35">
                  <c:v>39.799999999999997</c:v>
                </c:pt>
                <c:pt idx="36">
                  <c:v>39.799999999999997</c:v>
                </c:pt>
                <c:pt idx="37">
                  <c:v>41.7</c:v>
                </c:pt>
                <c:pt idx="38">
                  <c:v>44.8</c:v>
                </c:pt>
                <c:pt idx="39">
                  <c:v>50.6</c:v>
                </c:pt>
                <c:pt idx="40">
                  <c:v>50.6</c:v>
                </c:pt>
                <c:pt idx="41">
                  <c:v>54.5</c:v>
                </c:pt>
                <c:pt idx="42">
                  <c:v>54.5</c:v>
                </c:pt>
                <c:pt idx="43">
                  <c:v>56.3</c:v>
                </c:pt>
                <c:pt idx="44">
                  <c:v>56.3</c:v>
                </c:pt>
                <c:pt idx="45">
                  <c:v>57.8</c:v>
                </c:pt>
                <c:pt idx="46">
                  <c:v>58.1</c:v>
                </c:pt>
                <c:pt idx="47">
                  <c:v>65.7</c:v>
                </c:pt>
                <c:pt idx="48">
                  <c:v>65.7</c:v>
                </c:pt>
                <c:pt idx="49">
                  <c:v>77.7</c:v>
                </c:pt>
                <c:pt idx="50">
                  <c:v>78.3</c:v>
                </c:pt>
                <c:pt idx="51">
                  <c:v>78.3</c:v>
                </c:pt>
                <c:pt idx="52">
                  <c:v>80.7</c:v>
                </c:pt>
                <c:pt idx="53">
                  <c:v>83.3</c:v>
                </c:pt>
                <c:pt idx="54">
                  <c:v>86.8</c:v>
                </c:pt>
                <c:pt idx="55">
                  <c:v>89.1</c:v>
                </c:pt>
                <c:pt idx="56">
                  <c:v>91.4</c:v>
                </c:pt>
                <c:pt idx="57">
                  <c:v>103.2</c:v>
                </c:pt>
              </c:numCache>
            </c:numRef>
          </c:xVal>
          <c:yVal>
            <c:numRef>
              <c:f>Sheet5!$B$111:$B$168</c:f>
              <c:numCache>
                <c:formatCode>0.0000</c:formatCode>
                <c:ptCount val="58"/>
                <c:pt idx="0">
                  <c:v>1</c:v>
                </c:pt>
                <c:pt idx="1">
                  <c:v>1</c:v>
                </c:pt>
                <c:pt idx="2" formatCode="General">
                  <c:v>1</c:v>
                </c:pt>
                <c:pt idx="3">
                  <c:v>0.97142857142857097</c:v>
                </c:pt>
                <c:pt idx="4" formatCode="General">
                  <c:v>0.97142857142857097</c:v>
                </c:pt>
                <c:pt idx="5">
                  <c:v>0.94285714285714295</c:v>
                </c:pt>
                <c:pt idx="6" formatCode="General">
                  <c:v>0.94285714285714295</c:v>
                </c:pt>
                <c:pt idx="7">
                  <c:v>0.91428571428571404</c:v>
                </c:pt>
                <c:pt idx="8" formatCode="General">
                  <c:v>0.91428571428571404</c:v>
                </c:pt>
                <c:pt idx="9">
                  <c:v>0.88571428571428601</c:v>
                </c:pt>
                <c:pt idx="10" formatCode="General">
                  <c:v>0.88571428571428601</c:v>
                </c:pt>
                <c:pt idx="11">
                  <c:v>0.85714285714285698</c:v>
                </c:pt>
                <c:pt idx="12" formatCode="General">
                  <c:v>0.85714285714285698</c:v>
                </c:pt>
                <c:pt idx="13">
                  <c:v>0.82857142857142796</c:v>
                </c:pt>
                <c:pt idx="14" formatCode="General">
                  <c:v>0.82857142857142796</c:v>
                </c:pt>
                <c:pt idx="15">
                  <c:v>0.8</c:v>
                </c:pt>
                <c:pt idx="16" formatCode="General">
                  <c:v>0.8</c:v>
                </c:pt>
                <c:pt idx="17">
                  <c:v>0.77142857142857102</c:v>
                </c:pt>
                <c:pt idx="18" formatCode="General">
                  <c:v>0.77142857142857102</c:v>
                </c:pt>
                <c:pt idx="19">
                  <c:v>0.74285714285714299</c:v>
                </c:pt>
                <c:pt idx="20" formatCode="General">
                  <c:v>0.74285714285714299</c:v>
                </c:pt>
                <c:pt idx="21">
                  <c:v>0.71428571428571397</c:v>
                </c:pt>
                <c:pt idx="22" formatCode="General">
                  <c:v>0.71428571428571397</c:v>
                </c:pt>
                <c:pt idx="23">
                  <c:v>0.68571428571428605</c:v>
                </c:pt>
                <c:pt idx="24" formatCode="General">
                  <c:v>0.68571428571428605</c:v>
                </c:pt>
                <c:pt idx="25">
                  <c:v>0.65714285714285703</c:v>
                </c:pt>
                <c:pt idx="26" formatCode="General">
                  <c:v>0.65714285714285703</c:v>
                </c:pt>
                <c:pt idx="27">
                  <c:v>0.628571428571428</c:v>
                </c:pt>
                <c:pt idx="28" formatCode="General">
                  <c:v>0.628571428571428</c:v>
                </c:pt>
                <c:pt idx="29">
                  <c:v>0.6</c:v>
                </c:pt>
                <c:pt idx="30">
                  <c:v>0.6</c:v>
                </c:pt>
                <c:pt idx="31">
                  <c:v>0.6</c:v>
                </c:pt>
                <c:pt idx="32">
                  <c:v>0.6</c:v>
                </c:pt>
                <c:pt idx="33" formatCode="General">
                  <c:v>0.6</c:v>
                </c:pt>
                <c:pt idx="34">
                  <c:v>0.56666666666666698</c:v>
                </c:pt>
                <c:pt idx="35" formatCode="General">
                  <c:v>0.56666666666666698</c:v>
                </c:pt>
                <c:pt idx="36">
                  <c:v>0.53333333333333299</c:v>
                </c:pt>
                <c:pt idx="37">
                  <c:v>0.53333333333333299</c:v>
                </c:pt>
                <c:pt idx="38">
                  <c:v>0.53333333333333299</c:v>
                </c:pt>
                <c:pt idx="39" formatCode="General">
                  <c:v>0.53333333333333299</c:v>
                </c:pt>
                <c:pt idx="40">
                  <c:v>0.49523809523809498</c:v>
                </c:pt>
                <c:pt idx="41" formatCode="General">
                  <c:v>0.49523809523809498</c:v>
                </c:pt>
                <c:pt idx="42">
                  <c:v>0.45714285714285702</c:v>
                </c:pt>
                <c:pt idx="43" formatCode="General">
                  <c:v>0.45714285714285702</c:v>
                </c:pt>
                <c:pt idx="44">
                  <c:v>0.419047619047619</c:v>
                </c:pt>
                <c:pt idx="45">
                  <c:v>0.419047619047619</c:v>
                </c:pt>
                <c:pt idx="46">
                  <c:v>0.419047619047619</c:v>
                </c:pt>
                <c:pt idx="47" formatCode="General">
                  <c:v>0.419047619047619</c:v>
                </c:pt>
                <c:pt idx="48">
                  <c:v>0.37248677248677198</c:v>
                </c:pt>
                <c:pt idx="49">
                  <c:v>0.37248677248677198</c:v>
                </c:pt>
                <c:pt idx="50" formatCode="General">
                  <c:v>0.37248677248677198</c:v>
                </c:pt>
                <c:pt idx="51">
                  <c:v>0.319274376417233</c:v>
                </c:pt>
                <c:pt idx="52">
                  <c:v>0.319274376417233</c:v>
                </c:pt>
                <c:pt idx="53">
                  <c:v>0.319274376417233</c:v>
                </c:pt>
                <c:pt idx="54">
                  <c:v>0.319274376417233</c:v>
                </c:pt>
                <c:pt idx="55">
                  <c:v>0.319274376417233</c:v>
                </c:pt>
                <c:pt idx="56">
                  <c:v>0.319274376417233</c:v>
                </c:pt>
                <c:pt idx="57">
                  <c:v>0.3192743764172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0EE-E84C-A69F-D74D24D44DCE}"/>
            </c:ext>
          </c:extLst>
        </c:ser>
        <c:ser>
          <c:idx val="1"/>
          <c:order val="1"/>
          <c:tx>
            <c:strRef>
              <c:f>Sheet5!$E$110</c:f>
              <c:strCache>
                <c:ptCount val="1"/>
                <c:pt idx="0">
                  <c:v>系列2</c:v>
                </c:pt>
              </c:strCache>
            </c:strRef>
          </c:tx>
          <c:spPr>
            <a:ln w="12700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Sheet5!$D$111:$D$137</c:f>
              <c:numCache>
                <c:formatCode>General</c:formatCode>
                <c:ptCount val="27"/>
                <c:pt idx="0">
                  <c:v>0</c:v>
                </c:pt>
                <c:pt idx="1">
                  <c:v>1.8</c:v>
                </c:pt>
                <c:pt idx="2">
                  <c:v>1.8</c:v>
                </c:pt>
                <c:pt idx="3">
                  <c:v>3.6</c:v>
                </c:pt>
                <c:pt idx="4">
                  <c:v>3.6</c:v>
                </c:pt>
                <c:pt idx="5">
                  <c:v>8.4</c:v>
                </c:pt>
                <c:pt idx="6">
                  <c:v>8.4</c:v>
                </c:pt>
                <c:pt idx="7">
                  <c:v>8.6999999999999993</c:v>
                </c:pt>
                <c:pt idx="8">
                  <c:v>9.6999999999999993</c:v>
                </c:pt>
                <c:pt idx="9">
                  <c:v>9.6999999999999993</c:v>
                </c:pt>
                <c:pt idx="10">
                  <c:v>10.4</c:v>
                </c:pt>
                <c:pt idx="11">
                  <c:v>10.4</c:v>
                </c:pt>
                <c:pt idx="12">
                  <c:v>10.5</c:v>
                </c:pt>
                <c:pt idx="13">
                  <c:v>10.5</c:v>
                </c:pt>
                <c:pt idx="14">
                  <c:v>11.3</c:v>
                </c:pt>
                <c:pt idx="15">
                  <c:v>11.3</c:v>
                </c:pt>
                <c:pt idx="16">
                  <c:v>13.2</c:v>
                </c:pt>
                <c:pt idx="17">
                  <c:v>13.2</c:v>
                </c:pt>
                <c:pt idx="18">
                  <c:v>13.7</c:v>
                </c:pt>
                <c:pt idx="19">
                  <c:v>13.7</c:v>
                </c:pt>
                <c:pt idx="20">
                  <c:v>34.299999999999997</c:v>
                </c:pt>
                <c:pt idx="21">
                  <c:v>34.299999999999997</c:v>
                </c:pt>
                <c:pt idx="22">
                  <c:v>39.700000000000003</c:v>
                </c:pt>
                <c:pt idx="23">
                  <c:v>39.700000000000003</c:v>
                </c:pt>
                <c:pt idx="24">
                  <c:v>65.2</c:v>
                </c:pt>
                <c:pt idx="25">
                  <c:v>65.2</c:v>
                </c:pt>
                <c:pt idx="26">
                  <c:v>70.5</c:v>
                </c:pt>
              </c:numCache>
            </c:numRef>
          </c:xVal>
          <c:yVal>
            <c:numRef>
              <c:f>Sheet5!$E$111:$E$137</c:f>
              <c:numCache>
                <c:formatCode>0.0000</c:formatCode>
                <c:ptCount val="27"/>
                <c:pt idx="0">
                  <c:v>1</c:v>
                </c:pt>
                <c:pt idx="1">
                  <c:v>1</c:v>
                </c:pt>
                <c:pt idx="2">
                  <c:v>0.92857142857142905</c:v>
                </c:pt>
                <c:pt idx="3" formatCode="General">
                  <c:v>0.92857142857142905</c:v>
                </c:pt>
                <c:pt idx="4">
                  <c:v>0.85714285714285698</c:v>
                </c:pt>
                <c:pt idx="5" formatCode="General">
                  <c:v>0.85714285714285698</c:v>
                </c:pt>
                <c:pt idx="6">
                  <c:v>0.78571428571428603</c:v>
                </c:pt>
                <c:pt idx="7">
                  <c:v>0.78571428571428603</c:v>
                </c:pt>
                <c:pt idx="8" formatCode="General">
                  <c:v>0.78571428571428603</c:v>
                </c:pt>
                <c:pt idx="9">
                  <c:v>0.70714285714285696</c:v>
                </c:pt>
                <c:pt idx="10" formatCode="General">
                  <c:v>0.70714285714285696</c:v>
                </c:pt>
                <c:pt idx="11">
                  <c:v>0.628571428571428</c:v>
                </c:pt>
                <c:pt idx="12" formatCode="General">
                  <c:v>0.628571428571428</c:v>
                </c:pt>
                <c:pt idx="13">
                  <c:v>0.55000000000000004</c:v>
                </c:pt>
                <c:pt idx="14" formatCode="General">
                  <c:v>0.55000000000000004</c:v>
                </c:pt>
                <c:pt idx="15">
                  <c:v>0.47142857142857097</c:v>
                </c:pt>
                <c:pt idx="16" formatCode="General">
                  <c:v>0.47142857142857097</c:v>
                </c:pt>
                <c:pt idx="17">
                  <c:v>0.39285714285714302</c:v>
                </c:pt>
                <c:pt idx="18" formatCode="General">
                  <c:v>0.39285714285714302</c:v>
                </c:pt>
                <c:pt idx="19">
                  <c:v>0.314285714285714</c:v>
                </c:pt>
                <c:pt idx="20" formatCode="General">
                  <c:v>0.314285714285714</c:v>
                </c:pt>
                <c:pt idx="21">
                  <c:v>0.23571428571428599</c:v>
                </c:pt>
                <c:pt idx="22" formatCode="General">
                  <c:v>0.23571428571428599</c:v>
                </c:pt>
                <c:pt idx="23">
                  <c:v>0.157142857142857</c:v>
                </c:pt>
                <c:pt idx="24" formatCode="General">
                  <c:v>0.157142857142857</c:v>
                </c:pt>
                <c:pt idx="25">
                  <c:v>7.8571428571428598E-2</c:v>
                </c:pt>
                <c:pt idx="26">
                  <c:v>7.8571428571428598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0EE-E84C-A69F-D74D24D44D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96043696"/>
        <c:axId val="-257810064"/>
      </c:scatterChart>
      <c:valAx>
        <c:axId val="-296043696"/>
        <c:scaling>
          <c:orientation val="minMax"/>
          <c:max val="11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JP"/>
          </a:p>
        </c:txPr>
        <c:crossAx val="-257810064"/>
        <c:crosses val="autoZero"/>
        <c:crossBetween val="midCat"/>
      </c:valAx>
      <c:valAx>
        <c:axId val="-257810064"/>
        <c:scaling>
          <c:orientation val="minMax"/>
          <c:max val="1.1000000000000001"/>
          <c:min val="0"/>
        </c:scaling>
        <c:delete val="0"/>
        <c:axPos val="l"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JP"/>
          </a:p>
        </c:txPr>
        <c:crossAx val="-296043696"/>
        <c:crosses val="autoZero"/>
        <c:crossBetween val="midCat"/>
        <c:majorUnit val="0.2"/>
      </c:valAx>
      <c:spPr>
        <a:noFill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900"/>
      </a:pPr>
      <a:endParaRPr lang="en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116</c:f>
              <c:strCache>
                <c:ptCount val="1"/>
                <c:pt idx="0">
                  <c:v>系列1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Sheet2!$A$117:$A$191</c:f>
              <c:numCache>
                <c:formatCode>General</c:formatCode>
                <c:ptCount val="75"/>
                <c:pt idx="0">
                  <c:v>0</c:v>
                </c:pt>
                <c:pt idx="1">
                  <c:v>1.9</c:v>
                </c:pt>
                <c:pt idx="2">
                  <c:v>1.9</c:v>
                </c:pt>
                <c:pt idx="3">
                  <c:v>2.8</c:v>
                </c:pt>
                <c:pt idx="4">
                  <c:v>2.8</c:v>
                </c:pt>
                <c:pt idx="5">
                  <c:v>3.4</c:v>
                </c:pt>
                <c:pt idx="6">
                  <c:v>3.4</c:v>
                </c:pt>
                <c:pt idx="7">
                  <c:v>3.9</c:v>
                </c:pt>
                <c:pt idx="8">
                  <c:v>3.9</c:v>
                </c:pt>
                <c:pt idx="9">
                  <c:v>4.2</c:v>
                </c:pt>
                <c:pt idx="10">
                  <c:v>4.2</c:v>
                </c:pt>
                <c:pt idx="11">
                  <c:v>4.5</c:v>
                </c:pt>
                <c:pt idx="12">
                  <c:v>4.5</c:v>
                </c:pt>
                <c:pt idx="13">
                  <c:v>5.4</c:v>
                </c:pt>
                <c:pt idx="14">
                  <c:v>5.4</c:v>
                </c:pt>
                <c:pt idx="15">
                  <c:v>5.9</c:v>
                </c:pt>
                <c:pt idx="16">
                  <c:v>5.9</c:v>
                </c:pt>
                <c:pt idx="17">
                  <c:v>6.3</c:v>
                </c:pt>
                <c:pt idx="18">
                  <c:v>6.3</c:v>
                </c:pt>
                <c:pt idx="19">
                  <c:v>6.8</c:v>
                </c:pt>
                <c:pt idx="20">
                  <c:v>6.8</c:v>
                </c:pt>
                <c:pt idx="21">
                  <c:v>7</c:v>
                </c:pt>
                <c:pt idx="22">
                  <c:v>7</c:v>
                </c:pt>
                <c:pt idx="23">
                  <c:v>8.1999999999999993</c:v>
                </c:pt>
                <c:pt idx="24">
                  <c:v>8.1999999999999993</c:v>
                </c:pt>
                <c:pt idx="25">
                  <c:v>8.6999999999999993</c:v>
                </c:pt>
                <c:pt idx="26">
                  <c:v>8.6999999999999993</c:v>
                </c:pt>
                <c:pt idx="27">
                  <c:v>10.7</c:v>
                </c:pt>
                <c:pt idx="28">
                  <c:v>10.7</c:v>
                </c:pt>
                <c:pt idx="29">
                  <c:v>10.9</c:v>
                </c:pt>
                <c:pt idx="30">
                  <c:v>10.9</c:v>
                </c:pt>
                <c:pt idx="31">
                  <c:v>11.1</c:v>
                </c:pt>
                <c:pt idx="32">
                  <c:v>11.1</c:v>
                </c:pt>
                <c:pt idx="33">
                  <c:v>11.6</c:v>
                </c:pt>
                <c:pt idx="34">
                  <c:v>11.6</c:v>
                </c:pt>
                <c:pt idx="35">
                  <c:v>11.9</c:v>
                </c:pt>
                <c:pt idx="36">
                  <c:v>11.9</c:v>
                </c:pt>
                <c:pt idx="37">
                  <c:v>12.2</c:v>
                </c:pt>
                <c:pt idx="38">
                  <c:v>12.2</c:v>
                </c:pt>
                <c:pt idx="39">
                  <c:v>12.3</c:v>
                </c:pt>
                <c:pt idx="40">
                  <c:v>12.3</c:v>
                </c:pt>
                <c:pt idx="41">
                  <c:v>12.7</c:v>
                </c:pt>
                <c:pt idx="42">
                  <c:v>12.7</c:v>
                </c:pt>
                <c:pt idx="43">
                  <c:v>13.3</c:v>
                </c:pt>
                <c:pt idx="44">
                  <c:v>13.3</c:v>
                </c:pt>
                <c:pt idx="45">
                  <c:v>13.9</c:v>
                </c:pt>
                <c:pt idx="46">
                  <c:v>13.9</c:v>
                </c:pt>
                <c:pt idx="47">
                  <c:v>14.1</c:v>
                </c:pt>
                <c:pt idx="48">
                  <c:v>14.1</c:v>
                </c:pt>
                <c:pt idx="49">
                  <c:v>15</c:v>
                </c:pt>
                <c:pt idx="50">
                  <c:v>15</c:v>
                </c:pt>
                <c:pt idx="51">
                  <c:v>15.4</c:v>
                </c:pt>
                <c:pt idx="52">
                  <c:v>15.4</c:v>
                </c:pt>
                <c:pt idx="53">
                  <c:v>15.5</c:v>
                </c:pt>
                <c:pt idx="54">
                  <c:v>15.5</c:v>
                </c:pt>
                <c:pt idx="55">
                  <c:v>16.8</c:v>
                </c:pt>
                <c:pt idx="56">
                  <c:v>16.8</c:v>
                </c:pt>
                <c:pt idx="57">
                  <c:v>17.3</c:v>
                </c:pt>
                <c:pt idx="58">
                  <c:v>17.3</c:v>
                </c:pt>
                <c:pt idx="59">
                  <c:v>19.600000000000001</c:v>
                </c:pt>
                <c:pt idx="60">
                  <c:v>19.600000000000001</c:v>
                </c:pt>
                <c:pt idx="61">
                  <c:v>22.8</c:v>
                </c:pt>
                <c:pt idx="62">
                  <c:v>22.8</c:v>
                </c:pt>
                <c:pt idx="63">
                  <c:v>26</c:v>
                </c:pt>
                <c:pt idx="64">
                  <c:v>26</c:v>
                </c:pt>
                <c:pt idx="65">
                  <c:v>32</c:v>
                </c:pt>
                <c:pt idx="66">
                  <c:v>32</c:v>
                </c:pt>
                <c:pt idx="67">
                  <c:v>33.6</c:v>
                </c:pt>
                <c:pt idx="68">
                  <c:v>33.6</c:v>
                </c:pt>
                <c:pt idx="69">
                  <c:v>33.9</c:v>
                </c:pt>
                <c:pt idx="70">
                  <c:v>33.9</c:v>
                </c:pt>
                <c:pt idx="71">
                  <c:v>35.6</c:v>
                </c:pt>
                <c:pt idx="72">
                  <c:v>35.6</c:v>
                </c:pt>
                <c:pt idx="73">
                  <c:v>39.299999999999997</c:v>
                </c:pt>
                <c:pt idx="74">
                  <c:v>39.299999999999997</c:v>
                </c:pt>
              </c:numCache>
            </c:numRef>
          </c:xVal>
          <c:yVal>
            <c:numRef>
              <c:f>Sheet2!$B$117:$B$191</c:f>
              <c:numCache>
                <c:formatCode>0.0000</c:formatCode>
                <c:ptCount val="75"/>
                <c:pt idx="0">
                  <c:v>1</c:v>
                </c:pt>
                <c:pt idx="1">
                  <c:v>1</c:v>
                </c:pt>
                <c:pt idx="2">
                  <c:v>0.97499999999999998</c:v>
                </c:pt>
                <c:pt idx="3" formatCode="General">
                  <c:v>0.97499999999999998</c:v>
                </c:pt>
                <c:pt idx="4">
                  <c:v>0.95</c:v>
                </c:pt>
                <c:pt idx="5" formatCode="General">
                  <c:v>0.95</c:v>
                </c:pt>
                <c:pt idx="6">
                  <c:v>0.92500000000000004</c:v>
                </c:pt>
                <c:pt idx="7" formatCode="General">
                  <c:v>0.92500000000000004</c:v>
                </c:pt>
                <c:pt idx="8">
                  <c:v>0.9</c:v>
                </c:pt>
                <c:pt idx="9" formatCode="General">
                  <c:v>0.9</c:v>
                </c:pt>
                <c:pt idx="10">
                  <c:v>0.85</c:v>
                </c:pt>
                <c:pt idx="11" formatCode="General">
                  <c:v>0.85</c:v>
                </c:pt>
                <c:pt idx="12">
                  <c:v>0.82499999999999996</c:v>
                </c:pt>
                <c:pt idx="13" formatCode="General">
                  <c:v>0.82499999999999996</c:v>
                </c:pt>
                <c:pt idx="14">
                  <c:v>0.77500000000000002</c:v>
                </c:pt>
                <c:pt idx="15" formatCode="General">
                  <c:v>0.77500000000000002</c:v>
                </c:pt>
                <c:pt idx="16">
                  <c:v>0.75</c:v>
                </c:pt>
                <c:pt idx="17" formatCode="General">
                  <c:v>0.75</c:v>
                </c:pt>
                <c:pt idx="18">
                  <c:v>0.72499999999999998</c:v>
                </c:pt>
                <c:pt idx="19" formatCode="General">
                  <c:v>0.72499999999999998</c:v>
                </c:pt>
                <c:pt idx="20">
                  <c:v>0.7</c:v>
                </c:pt>
                <c:pt idx="21" formatCode="General">
                  <c:v>0.7</c:v>
                </c:pt>
                <c:pt idx="22">
                  <c:v>0.67500000000000004</c:v>
                </c:pt>
                <c:pt idx="23" formatCode="General">
                  <c:v>0.67500000000000004</c:v>
                </c:pt>
                <c:pt idx="24">
                  <c:v>0.65</c:v>
                </c:pt>
                <c:pt idx="25" formatCode="General">
                  <c:v>0.65</c:v>
                </c:pt>
                <c:pt idx="26">
                  <c:v>0.625</c:v>
                </c:pt>
                <c:pt idx="27" formatCode="General">
                  <c:v>0.625</c:v>
                </c:pt>
                <c:pt idx="28">
                  <c:v>0.6</c:v>
                </c:pt>
                <c:pt idx="29" formatCode="General">
                  <c:v>0.6</c:v>
                </c:pt>
                <c:pt idx="30">
                  <c:v>0.57499999999999996</c:v>
                </c:pt>
                <c:pt idx="31" formatCode="General">
                  <c:v>0.57499999999999996</c:v>
                </c:pt>
                <c:pt idx="32">
                  <c:v>0.55000000000000004</c:v>
                </c:pt>
                <c:pt idx="33" formatCode="General">
                  <c:v>0.55000000000000004</c:v>
                </c:pt>
                <c:pt idx="34">
                  <c:v>0.52500000000000002</c:v>
                </c:pt>
                <c:pt idx="35" formatCode="General">
                  <c:v>0.52500000000000002</c:v>
                </c:pt>
                <c:pt idx="36">
                  <c:v>0.5</c:v>
                </c:pt>
                <c:pt idx="37" formatCode="General">
                  <c:v>0.5</c:v>
                </c:pt>
                <c:pt idx="38">
                  <c:v>0.47499999999999998</c:v>
                </c:pt>
                <c:pt idx="39" formatCode="General">
                  <c:v>0.47499999999999998</c:v>
                </c:pt>
                <c:pt idx="40">
                  <c:v>0.45</c:v>
                </c:pt>
                <c:pt idx="41" formatCode="General">
                  <c:v>0.45</c:v>
                </c:pt>
                <c:pt idx="42">
                  <c:v>0.42499999999999999</c:v>
                </c:pt>
                <c:pt idx="43" formatCode="General">
                  <c:v>0.42499999999999999</c:v>
                </c:pt>
                <c:pt idx="44">
                  <c:v>0.4</c:v>
                </c:pt>
                <c:pt idx="45" formatCode="General">
                  <c:v>0.4</c:v>
                </c:pt>
                <c:pt idx="46">
                  <c:v>0.375</c:v>
                </c:pt>
                <c:pt idx="47" formatCode="General">
                  <c:v>0.375</c:v>
                </c:pt>
                <c:pt idx="48">
                  <c:v>0.32500000000000001</c:v>
                </c:pt>
                <c:pt idx="49" formatCode="General">
                  <c:v>0.32500000000000001</c:v>
                </c:pt>
                <c:pt idx="50">
                  <c:v>0.3</c:v>
                </c:pt>
                <c:pt idx="51" formatCode="General">
                  <c:v>0.3</c:v>
                </c:pt>
                <c:pt idx="52">
                  <c:v>0.27500000000000002</c:v>
                </c:pt>
                <c:pt idx="53" formatCode="General">
                  <c:v>0.27500000000000002</c:v>
                </c:pt>
                <c:pt idx="54">
                  <c:v>0.25</c:v>
                </c:pt>
                <c:pt idx="55" formatCode="General">
                  <c:v>0.25</c:v>
                </c:pt>
                <c:pt idx="56">
                  <c:v>0.22500000000000001</c:v>
                </c:pt>
                <c:pt idx="57" formatCode="General">
                  <c:v>0.22500000000000001</c:v>
                </c:pt>
                <c:pt idx="58">
                  <c:v>0.2</c:v>
                </c:pt>
                <c:pt idx="59" formatCode="General">
                  <c:v>0.2</c:v>
                </c:pt>
                <c:pt idx="60">
                  <c:v>0.17499999999999999</c:v>
                </c:pt>
                <c:pt idx="61" formatCode="General">
                  <c:v>0.17499999999999999</c:v>
                </c:pt>
                <c:pt idx="62">
                  <c:v>0.15</c:v>
                </c:pt>
                <c:pt idx="63" formatCode="General">
                  <c:v>0.15</c:v>
                </c:pt>
                <c:pt idx="64">
                  <c:v>0.125</c:v>
                </c:pt>
                <c:pt idx="65" formatCode="General">
                  <c:v>0.125</c:v>
                </c:pt>
                <c:pt idx="66">
                  <c:v>9.9999999999999895E-2</c:v>
                </c:pt>
                <c:pt idx="67" formatCode="General">
                  <c:v>9.9999999999999895E-2</c:v>
                </c:pt>
                <c:pt idx="68">
                  <c:v>7.49999999999999E-2</c:v>
                </c:pt>
                <c:pt idx="69" formatCode="General">
                  <c:v>7.49999999999999E-2</c:v>
                </c:pt>
                <c:pt idx="70">
                  <c:v>0.05</c:v>
                </c:pt>
                <c:pt idx="71" formatCode="General">
                  <c:v>0.05</c:v>
                </c:pt>
                <c:pt idx="72">
                  <c:v>2.5000000000000001E-2</c:v>
                </c:pt>
                <c:pt idx="73" formatCode="General">
                  <c:v>2.5000000000000001E-2</c:v>
                </c:pt>
                <c:pt idx="7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9DA-1548-91F7-7CD331552F75}"/>
            </c:ext>
          </c:extLst>
        </c:ser>
        <c:ser>
          <c:idx val="1"/>
          <c:order val="1"/>
          <c:tx>
            <c:strRef>
              <c:f>Sheet2!$E$116</c:f>
              <c:strCache>
                <c:ptCount val="1"/>
                <c:pt idx="0">
                  <c:v>系列2</c:v>
                </c:pt>
              </c:strCache>
            </c:strRef>
          </c:tx>
          <c:spPr>
            <a:ln w="12700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Sheet2!$D$117:$D$154</c:f>
              <c:numCache>
                <c:formatCode>General</c:formatCode>
                <c:ptCount val="38"/>
                <c:pt idx="0">
                  <c:v>0</c:v>
                </c:pt>
                <c:pt idx="1">
                  <c:v>1.9</c:v>
                </c:pt>
                <c:pt idx="2">
                  <c:v>1.9</c:v>
                </c:pt>
                <c:pt idx="3">
                  <c:v>3.8</c:v>
                </c:pt>
                <c:pt idx="4">
                  <c:v>3.8</c:v>
                </c:pt>
                <c:pt idx="5">
                  <c:v>4.5</c:v>
                </c:pt>
                <c:pt idx="6">
                  <c:v>4.5</c:v>
                </c:pt>
                <c:pt idx="7">
                  <c:v>4.7</c:v>
                </c:pt>
                <c:pt idx="8">
                  <c:v>4.7</c:v>
                </c:pt>
                <c:pt idx="9">
                  <c:v>5.0999999999999996</c:v>
                </c:pt>
                <c:pt idx="10">
                  <c:v>5.0999999999999996</c:v>
                </c:pt>
                <c:pt idx="11">
                  <c:v>5.8</c:v>
                </c:pt>
                <c:pt idx="12">
                  <c:v>5.8</c:v>
                </c:pt>
                <c:pt idx="13">
                  <c:v>6.3</c:v>
                </c:pt>
                <c:pt idx="14">
                  <c:v>6.3</c:v>
                </c:pt>
                <c:pt idx="15">
                  <c:v>6.5</c:v>
                </c:pt>
                <c:pt idx="16">
                  <c:v>6.5</c:v>
                </c:pt>
                <c:pt idx="17">
                  <c:v>6.7</c:v>
                </c:pt>
                <c:pt idx="18">
                  <c:v>6.7</c:v>
                </c:pt>
                <c:pt idx="19">
                  <c:v>7.3</c:v>
                </c:pt>
                <c:pt idx="20">
                  <c:v>7.3</c:v>
                </c:pt>
                <c:pt idx="21">
                  <c:v>8.3000000000000007</c:v>
                </c:pt>
                <c:pt idx="22">
                  <c:v>8.3000000000000007</c:v>
                </c:pt>
                <c:pt idx="23">
                  <c:v>9.1</c:v>
                </c:pt>
                <c:pt idx="24">
                  <c:v>9.1</c:v>
                </c:pt>
                <c:pt idx="25">
                  <c:v>9.9</c:v>
                </c:pt>
                <c:pt idx="26">
                  <c:v>9.9</c:v>
                </c:pt>
                <c:pt idx="27">
                  <c:v>10.199999999999999</c:v>
                </c:pt>
                <c:pt idx="28">
                  <c:v>10.199999999999999</c:v>
                </c:pt>
                <c:pt idx="29">
                  <c:v>13.3</c:v>
                </c:pt>
                <c:pt idx="30">
                  <c:v>13.3</c:v>
                </c:pt>
                <c:pt idx="31">
                  <c:v>15</c:v>
                </c:pt>
                <c:pt idx="32">
                  <c:v>15</c:v>
                </c:pt>
                <c:pt idx="33">
                  <c:v>16.3</c:v>
                </c:pt>
                <c:pt idx="34">
                  <c:v>16.3</c:v>
                </c:pt>
                <c:pt idx="35">
                  <c:v>17.399999999999999</c:v>
                </c:pt>
                <c:pt idx="36">
                  <c:v>17.399999999999999</c:v>
                </c:pt>
                <c:pt idx="37">
                  <c:v>48.7</c:v>
                </c:pt>
              </c:numCache>
            </c:numRef>
          </c:xVal>
          <c:yVal>
            <c:numRef>
              <c:f>Sheet2!$E$117:$E$154</c:f>
              <c:numCache>
                <c:formatCode>0.0000</c:formatCode>
                <c:ptCount val="38"/>
                <c:pt idx="0">
                  <c:v>1</c:v>
                </c:pt>
                <c:pt idx="1">
                  <c:v>1</c:v>
                </c:pt>
                <c:pt idx="2">
                  <c:v>0.95</c:v>
                </c:pt>
                <c:pt idx="3" formatCode="General">
                  <c:v>0.95</c:v>
                </c:pt>
                <c:pt idx="4">
                  <c:v>0.9</c:v>
                </c:pt>
                <c:pt idx="5" formatCode="General">
                  <c:v>0.9</c:v>
                </c:pt>
                <c:pt idx="6">
                  <c:v>0.85</c:v>
                </c:pt>
                <c:pt idx="7" formatCode="General">
                  <c:v>0.85</c:v>
                </c:pt>
                <c:pt idx="8">
                  <c:v>0.8</c:v>
                </c:pt>
                <c:pt idx="9" formatCode="General">
                  <c:v>0.8</c:v>
                </c:pt>
                <c:pt idx="10">
                  <c:v>0.75</c:v>
                </c:pt>
                <c:pt idx="11" formatCode="General">
                  <c:v>0.75</c:v>
                </c:pt>
                <c:pt idx="12">
                  <c:v>0.7</c:v>
                </c:pt>
                <c:pt idx="13" formatCode="General">
                  <c:v>0.7</c:v>
                </c:pt>
                <c:pt idx="14">
                  <c:v>0.65</c:v>
                </c:pt>
                <c:pt idx="15" formatCode="General">
                  <c:v>0.65</c:v>
                </c:pt>
                <c:pt idx="16">
                  <c:v>0.6</c:v>
                </c:pt>
                <c:pt idx="17" formatCode="General">
                  <c:v>0.6</c:v>
                </c:pt>
                <c:pt idx="18">
                  <c:v>0.5</c:v>
                </c:pt>
                <c:pt idx="19" formatCode="General">
                  <c:v>0.5</c:v>
                </c:pt>
                <c:pt idx="20">
                  <c:v>0.45</c:v>
                </c:pt>
                <c:pt idx="21" formatCode="General">
                  <c:v>0.45</c:v>
                </c:pt>
                <c:pt idx="22">
                  <c:v>0.4</c:v>
                </c:pt>
                <c:pt idx="23" formatCode="General">
                  <c:v>0.4</c:v>
                </c:pt>
                <c:pt idx="24">
                  <c:v>0.35</c:v>
                </c:pt>
                <c:pt idx="25" formatCode="General">
                  <c:v>0.35</c:v>
                </c:pt>
                <c:pt idx="26">
                  <c:v>0.3</c:v>
                </c:pt>
                <c:pt idx="27" formatCode="General">
                  <c:v>0.3</c:v>
                </c:pt>
                <c:pt idx="28">
                  <c:v>0.25</c:v>
                </c:pt>
                <c:pt idx="29" formatCode="General">
                  <c:v>0.25</c:v>
                </c:pt>
                <c:pt idx="30">
                  <c:v>0.2</c:v>
                </c:pt>
                <c:pt idx="31" formatCode="General">
                  <c:v>0.2</c:v>
                </c:pt>
                <c:pt idx="32">
                  <c:v>0.15</c:v>
                </c:pt>
                <c:pt idx="33" formatCode="General">
                  <c:v>0.15</c:v>
                </c:pt>
                <c:pt idx="34">
                  <c:v>0.1</c:v>
                </c:pt>
                <c:pt idx="35" formatCode="General">
                  <c:v>0.1</c:v>
                </c:pt>
                <c:pt idx="36">
                  <c:v>0.05</c:v>
                </c:pt>
                <c:pt idx="37">
                  <c:v>0.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9DA-1548-91F7-7CD331552F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94684480"/>
        <c:axId val="-294108624"/>
      </c:scatterChart>
      <c:valAx>
        <c:axId val="-294684480"/>
        <c:scaling>
          <c:orientation val="minMax"/>
          <c:max val="11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JP"/>
          </a:p>
        </c:txPr>
        <c:crossAx val="-294108624"/>
        <c:crosses val="autoZero"/>
        <c:crossBetween val="midCat"/>
      </c:valAx>
      <c:valAx>
        <c:axId val="-294108624"/>
        <c:scaling>
          <c:orientation val="minMax"/>
          <c:max val="1.1000000000000001"/>
          <c:min val="0"/>
        </c:scaling>
        <c:delete val="0"/>
        <c:axPos val="l"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JP"/>
          </a:p>
        </c:txPr>
        <c:crossAx val="-294684480"/>
        <c:crosses val="autoZero"/>
        <c:crossBetween val="midCat"/>
        <c:majorUnit val="0.2"/>
      </c:valAx>
      <c:spPr>
        <a:noFill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900"/>
      </a:pPr>
      <a:endParaRPr lang="en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5!$B$120</c:f>
              <c:strCache>
                <c:ptCount val="1"/>
                <c:pt idx="0">
                  <c:v>系列1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Sheet5!$A$121:$A$193</c:f>
              <c:numCache>
                <c:formatCode>General</c:formatCode>
                <c:ptCount val="73"/>
                <c:pt idx="0">
                  <c:v>0</c:v>
                </c:pt>
                <c:pt idx="1">
                  <c:v>8.1999999999999993</c:v>
                </c:pt>
                <c:pt idx="2">
                  <c:v>8.1999999999999993</c:v>
                </c:pt>
                <c:pt idx="3">
                  <c:v>9.6999999999999993</c:v>
                </c:pt>
                <c:pt idx="4">
                  <c:v>9.6999999999999993</c:v>
                </c:pt>
                <c:pt idx="5">
                  <c:v>10.7</c:v>
                </c:pt>
                <c:pt idx="6">
                  <c:v>10.7</c:v>
                </c:pt>
                <c:pt idx="7">
                  <c:v>11.6</c:v>
                </c:pt>
                <c:pt idx="8">
                  <c:v>12.1</c:v>
                </c:pt>
                <c:pt idx="9">
                  <c:v>12.8</c:v>
                </c:pt>
                <c:pt idx="10">
                  <c:v>12.8</c:v>
                </c:pt>
                <c:pt idx="11">
                  <c:v>14</c:v>
                </c:pt>
                <c:pt idx="12">
                  <c:v>14</c:v>
                </c:pt>
                <c:pt idx="13">
                  <c:v>14.4</c:v>
                </c:pt>
                <c:pt idx="14">
                  <c:v>14.4</c:v>
                </c:pt>
                <c:pt idx="15">
                  <c:v>15.4</c:v>
                </c:pt>
                <c:pt idx="16">
                  <c:v>15.4</c:v>
                </c:pt>
                <c:pt idx="17">
                  <c:v>17.3</c:v>
                </c:pt>
                <c:pt idx="18">
                  <c:v>17.3</c:v>
                </c:pt>
                <c:pt idx="19">
                  <c:v>18.3</c:v>
                </c:pt>
                <c:pt idx="20">
                  <c:v>18.3</c:v>
                </c:pt>
                <c:pt idx="21">
                  <c:v>18.7</c:v>
                </c:pt>
                <c:pt idx="22">
                  <c:v>18.7</c:v>
                </c:pt>
                <c:pt idx="23">
                  <c:v>19</c:v>
                </c:pt>
                <c:pt idx="24">
                  <c:v>19</c:v>
                </c:pt>
                <c:pt idx="25">
                  <c:v>19.100000000000001</c:v>
                </c:pt>
                <c:pt idx="26">
                  <c:v>19.100000000000001</c:v>
                </c:pt>
                <c:pt idx="27">
                  <c:v>19.600000000000001</c:v>
                </c:pt>
                <c:pt idx="28">
                  <c:v>19.600000000000001</c:v>
                </c:pt>
                <c:pt idx="29">
                  <c:v>19.899999999999999</c:v>
                </c:pt>
                <c:pt idx="30">
                  <c:v>19.899999999999999</c:v>
                </c:pt>
                <c:pt idx="31">
                  <c:v>24.5</c:v>
                </c:pt>
                <c:pt idx="32">
                  <c:v>24.5</c:v>
                </c:pt>
                <c:pt idx="33">
                  <c:v>24.6</c:v>
                </c:pt>
                <c:pt idx="34">
                  <c:v>24.6</c:v>
                </c:pt>
                <c:pt idx="35">
                  <c:v>25.6</c:v>
                </c:pt>
                <c:pt idx="36">
                  <c:v>25.6</c:v>
                </c:pt>
                <c:pt idx="37">
                  <c:v>25.7</c:v>
                </c:pt>
                <c:pt idx="38">
                  <c:v>25.7</c:v>
                </c:pt>
                <c:pt idx="39">
                  <c:v>26.8</c:v>
                </c:pt>
                <c:pt idx="40">
                  <c:v>26.8</c:v>
                </c:pt>
                <c:pt idx="41">
                  <c:v>27.8</c:v>
                </c:pt>
                <c:pt idx="42">
                  <c:v>27.8</c:v>
                </c:pt>
                <c:pt idx="43">
                  <c:v>28.4</c:v>
                </c:pt>
                <c:pt idx="44">
                  <c:v>28.4</c:v>
                </c:pt>
                <c:pt idx="45">
                  <c:v>32.799999999999997</c:v>
                </c:pt>
                <c:pt idx="46">
                  <c:v>32.799999999999997</c:v>
                </c:pt>
                <c:pt idx="47">
                  <c:v>33.299999999999997</c:v>
                </c:pt>
                <c:pt idx="48">
                  <c:v>33.299999999999997</c:v>
                </c:pt>
                <c:pt idx="49">
                  <c:v>33.5</c:v>
                </c:pt>
                <c:pt idx="50">
                  <c:v>33.5</c:v>
                </c:pt>
                <c:pt idx="51">
                  <c:v>36.200000000000003</c:v>
                </c:pt>
                <c:pt idx="52">
                  <c:v>36.200000000000003</c:v>
                </c:pt>
                <c:pt idx="53">
                  <c:v>36.4</c:v>
                </c:pt>
                <c:pt idx="54">
                  <c:v>37.5</c:v>
                </c:pt>
                <c:pt idx="55">
                  <c:v>38.299999999999997</c:v>
                </c:pt>
                <c:pt idx="56">
                  <c:v>38.299999999999997</c:v>
                </c:pt>
                <c:pt idx="57">
                  <c:v>46.2</c:v>
                </c:pt>
                <c:pt idx="58">
                  <c:v>46.2</c:v>
                </c:pt>
                <c:pt idx="59">
                  <c:v>49.6</c:v>
                </c:pt>
                <c:pt idx="60">
                  <c:v>49.6</c:v>
                </c:pt>
                <c:pt idx="61">
                  <c:v>54.8</c:v>
                </c:pt>
                <c:pt idx="62">
                  <c:v>54.8</c:v>
                </c:pt>
                <c:pt idx="63">
                  <c:v>57.4</c:v>
                </c:pt>
                <c:pt idx="64">
                  <c:v>57.4</c:v>
                </c:pt>
                <c:pt idx="65">
                  <c:v>63.4</c:v>
                </c:pt>
                <c:pt idx="66">
                  <c:v>63.9</c:v>
                </c:pt>
                <c:pt idx="67">
                  <c:v>71.3</c:v>
                </c:pt>
                <c:pt idx="68">
                  <c:v>71.3</c:v>
                </c:pt>
                <c:pt idx="69">
                  <c:v>82.5</c:v>
                </c:pt>
                <c:pt idx="70">
                  <c:v>85.4</c:v>
                </c:pt>
                <c:pt idx="71">
                  <c:v>93.6</c:v>
                </c:pt>
                <c:pt idx="72">
                  <c:v>93.6</c:v>
                </c:pt>
              </c:numCache>
            </c:numRef>
          </c:xVal>
          <c:yVal>
            <c:numRef>
              <c:f>Sheet5!$B$121:$B$193</c:f>
              <c:numCache>
                <c:formatCode>0.0000</c:formatCode>
                <c:ptCount val="73"/>
                <c:pt idx="0">
                  <c:v>1</c:v>
                </c:pt>
                <c:pt idx="1">
                  <c:v>1</c:v>
                </c:pt>
                <c:pt idx="2">
                  <c:v>0.97499999999999998</c:v>
                </c:pt>
                <c:pt idx="3" formatCode="General">
                  <c:v>0.97499999999999998</c:v>
                </c:pt>
                <c:pt idx="4">
                  <c:v>0.95</c:v>
                </c:pt>
                <c:pt idx="5" formatCode="General">
                  <c:v>0.95</c:v>
                </c:pt>
                <c:pt idx="6">
                  <c:v>0.92500000000000004</c:v>
                </c:pt>
                <c:pt idx="7">
                  <c:v>0.92500000000000004</c:v>
                </c:pt>
                <c:pt idx="8">
                  <c:v>0.92500000000000004</c:v>
                </c:pt>
                <c:pt idx="9" formatCode="General">
                  <c:v>0.92500000000000004</c:v>
                </c:pt>
                <c:pt idx="10">
                  <c:v>0.89857142857142802</c:v>
                </c:pt>
                <c:pt idx="11" formatCode="General">
                  <c:v>0.89857142857142802</c:v>
                </c:pt>
                <c:pt idx="12">
                  <c:v>0.872142857142857</c:v>
                </c:pt>
                <c:pt idx="13" formatCode="General">
                  <c:v>0.872142857142857</c:v>
                </c:pt>
                <c:pt idx="14">
                  <c:v>0.84571428571428597</c:v>
                </c:pt>
                <c:pt idx="15" formatCode="General">
                  <c:v>0.84571428571428597</c:v>
                </c:pt>
                <c:pt idx="16">
                  <c:v>0.81928571428571395</c:v>
                </c:pt>
                <c:pt idx="17" formatCode="General">
                  <c:v>0.81928571428571395</c:v>
                </c:pt>
                <c:pt idx="18">
                  <c:v>0.79285714285714304</c:v>
                </c:pt>
                <c:pt idx="19" formatCode="General">
                  <c:v>0.79285714285714304</c:v>
                </c:pt>
                <c:pt idx="20">
                  <c:v>0.76642857142857101</c:v>
                </c:pt>
                <c:pt idx="21" formatCode="General">
                  <c:v>0.76642857142857101</c:v>
                </c:pt>
                <c:pt idx="22">
                  <c:v>0.74</c:v>
                </c:pt>
                <c:pt idx="23" formatCode="General">
                  <c:v>0.74</c:v>
                </c:pt>
                <c:pt idx="24">
                  <c:v>0.71357142857142797</c:v>
                </c:pt>
                <c:pt idx="25" formatCode="General">
                  <c:v>0.71357142857142797</c:v>
                </c:pt>
                <c:pt idx="26">
                  <c:v>0.68714285714285706</c:v>
                </c:pt>
                <c:pt idx="27" formatCode="General">
                  <c:v>0.68714285714285706</c:v>
                </c:pt>
                <c:pt idx="28">
                  <c:v>0.66071428571428603</c:v>
                </c:pt>
                <c:pt idx="29" formatCode="General">
                  <c:v>0.66071428571428603</c:v>
                </c:pt>
                <c:pt idx="30">
                  <c:v>0.63428571428571401</c:v>
                </c:pt>
                <c:pt idx="31" formatCode="General">
                  <c:v>0.63428571428571401</c:v>
                </c:pt>
                <c:pt idx="32">
                  <c:v>0.60785714285714298</c:v>
                </c:pt>
                <c:pt idx="33" formatCode="General">
                  <c:v>0.60785714285714298</c:v>
                </c:pt>
                <c:pt idx="34">
                  <c:v>0.58142857142857196</c:v>
                </c:pt>
                <c:pt idx="35" formatCode="General">
                  <c:v>0.58142857142857196</c:v>
                </c:pt>
                <c:pt idx="36">
                  <c:v>0.55500000000000005</c:v>
                </c:pt>
                <c:pt idx="37" formatCode="General">
                  <c:v>0.55500000000000005</c:v>
                </c:pt>
                <c:pt idx="38">
                  <c:v>0.52857142857142903</c:v>
                </c:pt>
                <c:pt idx="39" formatCode="General">
                  <c:v>0.52857142857142903</c:v>
                </c:pt>
                <c:pt idx="40">
                  <c:v>0.502142857142857</c:v>
                </c:pt>
                <c:pt idx="41" formatCode="General">
                  <c:v>0.502142857142857</c:v>
                </c:pt>
                <c:pt idx="42">
                  <c:v>0.47571428571428598</c:v>
                </c:pt>
                <c:pt idx="43" formatCode="General">
                  <c:v>0.47571428571428598</c:v>
                </c:pt>
                <c:pt idx="44">
                  <c:v>0.44928571428571401</c:v>
                </c:pt>
                <c:pt idx="45" formatCode="General">
                  <c:v>0.44928571428571401</c:v>
                </c:pt>
                <c:pt idx="46">
                  <c:v>0.42285714285714299</c:v>
                </c:pt>
                <c:pt idx="47" formatCode="General">
                  <c:v>0.42285714285714299</c:v>
                </c:pt>
                <c:pt idx="48">
                  <c:v>0.39642857142857102</c:v>
                </c:pt>
                <c:pt idx="49" formatCode="General">
                  <c:v>0.39642857142857102</c:v>
                </c:pt>
                <c:pt idx="50">
                  <c:v>0.37</c:v>
                </c:pt>
                <c:pt idx="51" formatCode="General">
                  <c:v>0.37</c:v>
                </c:pt>
                <c:pt idx="52">
                  <c:v>0.34357142857142903</c:v>
                </c:pt>
                <c:pt idx="53">
                  <c:v>0.34357142857142903</c:v>
                </c:pt>
                <c:pt idx="54">
                  <c:v>0.34357142857142903</c:v>
                </c:pt>
                <c:pt idx="55" formatCode="General">
                  <c:v>0.34357142857142903</c:v>
                </c:pt>
                <c:pt idx="56">
                  <c:v>0.31233766233766203</c:v>
                </c:pt>
                <c:pt idx="57" formatCode="General">
                  <c:v>0.31233766233766203</c:v>
                </c:pt>
                <c:pt idx="58">
                  <c:v>0.28110389610389602</c:v>
                </c:pt>
                <c:pt idx="59" formatCode="General">
                  <c:v>0.28110389610389602</c:v>
                </c:pt>
                <c:pt idx="60">
                  <c:v>0.24987012987012999</c:v>
                </c:pt>
                <c:pt idx="61" formatCode="General">
                  <c:v>0.24987012987012999</c:v>
                </c:pt>
                <c:pt idx="62">
                  <c:v>0.21863636363636399</c:v>
                </c:pt>
                <c:pt idx="63" formatCode="General">
                  <c:v>0.21863636363636399</c:v>
                </c:pt>
                <c:pt idx="64">
                  <c:v>0.18740259740259699</c:v>
                </c:pt>
                <c:pt idx="65">
                  <c:v>0.18740259740259699</c:v>
                </c:pt>
                <c:pt idx="66">
                  <c:v>0.18740259740259699</c:v>
                </c:pt>
                <c:pt idx="67" formatCode="General">
                  <c:v>0.18740259740259699</c:v>
                </c:pt>
                <c:pt idx="68">
                  <c:v>0.14055194805194801</c:v>
                </c:pt>
                <c:pt idx="69">
                  <c:v>0.14055194805194801</c:v>
                </c:pt>
                <c:pt idx="70">
                  <c:v>0.14055194805194801</c:v>
                </c:pt>
                <c:pt idx="71" formatCode="General">
                  <c:v>0.14055194805194801</c:v>
                </c:pt>
                <c:pt idx="72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582-414F-BD06-4B8CF8F41D07}"/>
            </c:ext>
          </c:extLst>
        </c:ser>
        <c:ser>
          <c:idx val="1"/>
          <c:order val="1"/>
          <c:tx>
            <c:strRef>
              <c:f>Sheet5!$E$120</c:f>
              <c:strCache>
                <c:ptCount val="1"/>
                <c:pt idx="0">
                  <c:v>系列2</c:v>
                </c:pt>
              </c:strCache>
            </c:strRef>
          </c:tx>
          <c:spPr>
            <a:ln w="12700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Sheet5!$D$121:$D$157</c:f>
              <c:numCache>
                <c:formatCode>General</c:formatCode>
                <c:ptCount val="37"/>
                <c:pt idx="0">
                  <c:v>0</c:v>
                </c:pt>
                <c:pt idx="1">
                  <c:v>1.4</c:v>
                </c:pt>
                <c:pt idx="2">
                  <c:v>8.4</c:v>
                </c:pt>
                <c:pt idx="3">
                  <c:v>8.6999999999999993</c:v>
                </c:pt>
                <c:pt idx="4">
                  <c:v>8.6999999999999993</c:v>
                </c:pt>
                <c:pt idx="5">
                  <c:v>8.8000000000000007</c:v>
                </c:pt>
                <c:pt idx="6">
                  <c:v>8.8000000000000007</c:v>
                </c:pt>
                <c:pt idx="7">
                  <c:v>9</c:v>
                </c:pt>
                <c:pt idx="8">
                  <c:v>9</c:v>
                </c:pt>
                <c:pt idx="9">
                  <c:v>10.1</c:v>
                </c:pt>
                <c:pt idx="10">
                  <c:v>10.1</c:v>
                </c:pt>
                <c:pt idx="11">
                  <c:v>10.4</c:v>
                </c:pt>
                <c:pt idx="12">
                  <c:v>10.4</c:v>
                </c:pt>
                <c:pt idx="13">
                  <c:v>15.4</c:v>
                </c:pt>
                <c:pt idx="14">
                  <c:v>15.4</c:v>
                </c:pt>
                <c:pt idx="15">
                  <c:v>16.2</c:v>
                </c:pt>
                <c:pt idx="16">
                  <c:v>16.2</c:v>
                </c:pt>
                <c:pt idx="17">
                  <c:v>16.3</c:v>
                </c:pt>
                <c:pt idx="18">
                  <c:v>16.3</c:v>
                </c:pt>
                <c:pt idx="19">
                  <c:v>19</c:v>
                </c:pt>
                <c:pt idx="20">
                  <c:v>19</c:v>
                </c:pt>
                <c:pt idx="21">
                  <c:v>19.5</c:v>
                </c:pt>
                <c:pt idx="22">
                  <c:v>19.5</c:v>
                </c:pt>
                <c:pt idx="23">
                  <c:v>19.7</c:v>
                </c:pt>
                <c:pt idx="24">
                  <c:v>19.7</c:v>
                </c:pt>
                <c:pt idx="25">
                  <c:v>21.8</c:v>
                </c:pt>
                <c:pt idx="26">
                  <c:v>24.2</c:v>
                </c:pt>
                <c:pt idx="27">
                  <c:v>24.2</c:v>
                </c:pt>
                <c:pt idx="28">
                  <c:v>26.9</c:v>
                </c:pt>
                <c:pt idx="29">
                  <c:v>26.9</c:v>
                </c:pt>
                <c:pt idx="30">
                  <c:v>28</c:v>
                </c:pt>
                <c:pt idx="31">
                  <c:v>28</c:v>
                </c:pt>
                <c:pt idx="32">
                  <c:v>28.7</c:v>
                </c:pt>
                <c:pt idx="33">
                  <c:v>28.7</c:v>
                </c:pt>
                <c:pt idx="34">
                  <c:v>48</c:v>
                </c:pt>
                <c:pt idx="35">
                  <c:v>48</c:v>
                </c:pt>
                <c:pt idx="36">
                  <c:v>48.7</c:v>
                </c:pt>
              </c:numCache>
            </c:numRef>
          </c:xVal>
          <c:yVal>
            <c:numRef>
              <c:f>Sheet5!$E$121:$E$157</c:f>
              <c:numCache>
                <c:formatCode>0.0000</c:formatCode>
                <c:ptCount val="3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 formatCode="General">
                  <c:v>1</c:v>
                </c:pt>
                <c:pt idx="4">
                  <c:v>0.94444444444444398</c:v>
                </c:pt>
                <c:pt idx="5" formatCode="General">
                  <c:v>0.94444444444444398</c:v>
                </c:pt>
                <c:pt idx="6">
                  <c:v>0.88888888888888895</c:v>
                </c:pt>
                <c:pt idx="7" formatCode="General">
                  <c:v>0.88888888888888895</c:v>
                </c:pt>
                <c:pt idx="8">
                  <c:v>0.83333333333333304</c:v>
                </c:pt>
                <c:pt idx="9" formatCode="General">
                  <c:v>0.83333333333333304</c:v>
                </c:pt>
                <c:pt idx="10">
                  <c:v>0.77777777777777801</c:v>
                </c:pt>
                <c:pt idx="11" formatCode="General">
                  <c:v>0.77777777777777801</c:v>
                </c:pt>
                <c:pt idx="12">
                  <c:v>0.72222222222222199</c:v>
                </c:pt>
                <c:pt idx="13" formatCode="General">
                  <c:v>0.72222222222222199</c:v>
                </c:pt>
                <c:pt idx="14">
                  <c:v>0.66666666666666696</c:v>
                </c:pt>
                <c:pt idx="15" formatCode="General">
                  <c:v>0.66666666666666696</c:v>
                </c:pt>
                <c:pt idx="16">
                  <c:v>0.61111111111111105</c:v>
                </c:pt>
                <c:pt idx="17" formatCode="General">
                  <c:v>0.61111111111111105</c:v>
                </c:pt>
                <c:pt idx="18">
                  <c:v>0.55555555555555602</c:v>
                </c:pt>
                <c:pt idx="19" formatCode="General">
                  <c:v>0.55555555555555602</c:v>
                </c:pt>
                <c:pt idx="20">
                  <c:v>0.5</c:v>
                </c:pt>
                <c:pt idx="21" formatCode="General">
                  <c:v>0.5</c:v>
                </c:pt>
                <c:pt idx="22">
                  <c:v>0.44444444444444398</c:v>
                </c:pt>
                <c:pt idx="23" formatCode="General">
                  <c:v>0.44444444444444398</c:v>
                </c:pt>
                <c:pt idx="24">
                  <c:v>0.38888888888888901</c:v>
                </c:pt>
                <c:pt idx="25">
                  <c:v>0.38888888888888901</c:v>
                </c:pt>
                <c:pt idx="26" formatCode="General">
                  <c:v>0.38888888888888901</c:v>
                </c:pt>
                <c:pt idx="27">
                  <c:v>0.32407407407407401</c:v>
                </c:pt>
                <c:pt idx="28" formatCode="General">
                  <c:v>0.32407407407407401</c:v>
                </c:pt>
                <c:pt idx="29">
                  <c:v>0.25925925925925902</c:v>
                </c:pt>
                <c:pt idx="30" formatCode="General">
                  <c:v>0.25925925925925902</c:v>
                </c:pt>
                <c:pt idx="31">
                  <c:v>0.194444444444444</c:v>
                </c:pt>
                <c:pt idx="32" formatCode="General">
                  <c:v>0.194444444444444</c:v>
                </c:pt>
                <c:pt idx="33">
                  <c:v>0.12962962962963001</c:v>
                </c:pt>
                <c:pt idx="34" formatCode="General">
                  <c:v>0.12962962962963001</c:v>
                </c:pt>
                <c:pt idx="35">
                  <c:v>6.4814814814814797E-2</c:v>
                </c:pt>
                <c:pt idx="36">
                  <c:v>6.481481481481479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582-414F-BD06-4B8CF8F41D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58476496"/>
        <c:axId val="-158373920"/>
      </c:scatterChart>
      <c:valAx>
        <c:axId val="-158476496"/>
        <c:scaling>
          <c:orientation val="minMax"/>
          <c:max val="11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JP"/>
          </a:p>
        </c:txPr>
        <c:crossAx val="-158373920"/>
        <c:crosses val="autoZero"/>
        <c:crossBetween val="midCat"/>
      </c:valAx>
      <c:valAx>
        <c:axId val="-158373920"/>
        <c:scaling>
          <c:orientation val="minMax"/>
          <c:max val="1.1000000000000001"/>
          <c:min val="0"/>
        </c:scaling>
        <c:delete val="0"/>
        <c:axPos val="l"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JP"/>
          </a:p>
        </c:txPr>
        <c:crossAx val="-158476496"/>
        <c:crosses val="autoZero"/>
        <c:crossBetween val="midCat"/>
        <c:majorUnit val="0.2"/>
      </c:valAx>
      <c:spPr>
        <a:noFill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900"/>
      </a:pPr>
      <a:endParaRPr lang="en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7882F-FDFE-4DFD-A46D-E60A3AE70CA8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42F6-B02B-4690-A839-672C86094F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5528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7882F-FDFE-4DFD-A46D-E60A3AE70CA8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42F6-B02B-4690-A839-672C86094F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070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7882F-FDFE-4DFD-A46D-E60A3AE70CA8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42F6-B02B-4690-A839-672C86094F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7036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7882F-FDFE-4DFD-A46D-E60A3AE70CA8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42F6-B02B-4690-A839-672C86094F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0107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7882F-FDFE-4DFD-A46D-E60A3AE70CA8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42F6-B02B-4690-A839-672C86094F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5351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7882F-FDFE-4DFD-A46D-E60A3AE70CA8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42F6-B02B-4690-A839-672C86094F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3643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7882F-FDFE-4DFD-A46D-E60A3AE70CA8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42F6-B02B-4690-A839-672C86094F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3675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7882F-FDFE-4DFD-A46D-E60A3AE70CA8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42F6-B02B-4690-A839-672C86094F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649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7882F-FDFE-4DFD-A46D-E60A3AE70CA8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42F6-B02B-4690-A839-672C86094F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8806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7882F-FDFE-4DFD-A46D-E60A3AE70CA8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42F6-B02B-4690-A839-672C86094F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9865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7882F-FDFE-4DFD-A46D-E60A3AE70CA8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342F6-B02B-4690-A839-672C86094F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2292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17882F-FDFE-4DFD-A46D-E60A3AE70CA8}" type="datetimeFigureOut">
              <a:rPr kumimoji="1" lang="ja-JP" altLang="en-US" smtClean="0"/>
              <a:t>2020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F342F6-B02B-4690-A839-672C86094F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413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yasushis2012@gmail.com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FD93E5-C0E1-1541-99A2-E7B693C358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7" y="842821"/>
            <a:ext cx="5915025" cy="1591346"/>
          </a:xfrm>
        </p:spPr>
        <p:txBody>
          <a:bodyPr>
            <a:noAutofit/>
          </a:bodyPr>
          <a:lstStyle/>
          <a:p>
            <a:r>
              <a:rPr lang="en-US" sz="1800" b="1" u="sng" dirty="0">
                <a:latin typeface="Helvetica" pitchFamily="2" charset="0"/>
              </a:rPr>
              <a:t>Supplementary Information</a:t>
            </a:r>
            <a:br>
              <a:rPr lang="en-US" sz="2000" dirty="0">
                <a:latin typeface="Helvetica" pitchFamily="2" charset="0"/>
              </a:rPr>
            </a:br>
            <a:br>
              <a:rPr lang="en-US" sz="2000" dirty="0">
                <a:latin typeface="Helvetica" pitchFamily="2" charset="0"/>
              </a:rPr>
            </a:br>
            <a:r>
              <a:rPr lang="en-GB" sz="2000" b="1" dirty="0">
                <a:latin typeface="Helvetica" pitchFamily="2" charset="0"/>
              </a:rPr>
              <a:t>Clinical impact of primary tumour location, early tumour shrinkage, and depth of response in the treatment of metastatic colorectal cancer with first-line chemotherapy plus cetuximab or bevacizumab</a:t>
            </a:r>
            <a:br>
              <a:rPr lang="en-JP" sz="2800" dirty="0">
                <a:latin typeface="Helvetica" pitchFamily="2" charset="0"/>
              </a:rPr>
            </a:br>
            <a:endParaRPr lang="en-JP" sz="2800" dirty="0">
              <a:latin typeface="Helvetica" pitchFamily="2" charset="0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5FCB5B-42FC-6943-AD71-C045450CA0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8" y="2434167"/>
            <a:ext cx="5915025" cy="6474306"/>
          </a:xfrm>
        </p:spPr>
        <p:txBody>
          <a:bodyPr>
            <a:normAutofit fontScale="55000" lnSpcReduction="20000"/>
          </a:bodyPr>
          <a:lstStyle/>
          <a:p>
            <a:pPr marL="0" indent="0">
              <a:buNone/>
            </a:pPr>
            <a:r>
              <a:rPr lang="en-GB" dirty="0">
                <a:latin typeface="Helvetica" pitchFamily="2" charset="0"/>
              </a:rPr>
              <a:t> </a:t>
            </a:r>
            <a:endParaRPr lang="en-JP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dirty="0">
                <a:latin typeface="Helvetica" pitchFamily="2" charset="0"/>
              </a:rPr>
              <a:t>Tamotsu Sagawa</a:t>
            </a:r>
            <a:r>
              <a:rPr lang="en-GB" sz="2500" baseline="30000" dirty="0">
                <a:latin typeface="Helvetica" pitchFamily="2" charset="0"/>
              </a:rPr>
              <a:t>1, #</a:t>
            </a:r>
            <a:r>
              <a:rPr lang="en-GB" sz="2500" dirty="0">
                <a:latin typeface="Helvetica" pitchFamily="2" charset="0"/>
              </a:rPr>
              <a:t>, Yasushi Sato*</a:t>
            </a:r>
            <a:r>
              <a:rPr lang="en-GB" sz="2500" baseline="30000" dirty="0">
                <a:latin typeface="Helvetica" pitchFamily="2" charset="0"/>
              </a:rPr>
              <a:t>2, #</a:t>
            </a:r>
            <a:r>
              <a:rPr lang="en-GB" sz="2500" dirty="0">
                <a:latin typeface="Helvetica" pitchFamily="2" charset="0"/>
              </a:rPr>
              <a:t>, Masahiro Hirakawa</a:t>
            </a:r>
            <a:r>
              <a:rPr lang="en-GB" sz="2500" baseline="30000" dirty="0">
                <a:latin typeface="Helvetica" pitchFamily="2" charset="0"/>
              </a:rPr>
              <a:t>1</a:t>
            </a:r>
            <a:r>
              <a:rPr lang="en-GB" sz="2500" dirty="0">
                <a:latin typeface="Helvetica" pitchFamily="2" charset="0"/>
              </a:rPr>
              <a:t>, Kyoko Hamaguchi</a:t>
            </a:r>
            <a:r>
              <a:rPr lang="en-GB" sz="2500" baseline="30000" dirty="0">
                <a:latin typeface="Helvetica" pitchFamily="2" charset="0"/>
              </a:rPr>
              <a:t>1</a:t>
            </a:r>
            <a:r>
              <a:rPr lang="en-GB" sz="2500" dirty="0">
                <a:latin typeface="Helvetica" pitchFamily="2" charset="0"/>
              </a:rPr>
              <a:t>, Akira Fukuya</a:t>
            </a:r>
            <a:r>
              <a:rPr lang="en-GB" sz="2500" baseline="30000" dirty="0">
                <a:latin typeface="Helvetica" pitchFamily="2" charset="0"/>
              </a:rPr>
              <a:t>3</a:t>
            </a:r>
            <a:r>
              <a:rPr lang="en-IN" sz="2500" dirty="0">
                <a:latin typeface="Helvetica" pitchFamily="2" charset="0"/>
              </a:rPr>
              <a:t>,</a:t>
            </a:r>
            <a:r>
              <a:rPr lang="en-IN" sz="2500" baseline="30000" dirty="0">
                <a:latin typeface="Helvetica" pitchFamily="2" charset="0"/>
              </a:rPr>
              <a:t> </a:t>
            </a:r>
            <a:r>
              <a:rPr lang="en-IN" sz="2500" dirty="0">
                <a:latin typeface="Helvetica" pitchFamily="2" charset="0"/>
              </a:rPr>
              <a:t>Koichi Okamoto</a:t>
            </a:r>
            <a:r>
              <a:rPr lang="en-IN" sz="2500" baseline="30000" dirty="0">
                <a:latin typeface="Helvetica" pitchFamily="2" charset="0"/>
              </a:rPr>
              <a:t>3</a:t>
            </a:r>
            <a:r>
              <a:rPr lang="en-IN" sz="2500" dirty="0">
                <a:latin typeface="Helvetica" pitchFamily="2" charset="0"/>
              </a:rPr>
              <a:t>, Hiroshi Miyamoto</a:t>
            </a:r>
            <a:r>
              <a:rPr lang="en-IN" sz="2500" baseline="30000" dirty="0">
                <a:latin typeface="Helvetica" pitchFamily="2" charset="0"/>
              </a:rPr>
              <a:t>3</a:t>
            </a:r>
            <a:r>
              <a:rPr lang="en-IN" sz="2500" dirty="0">
                <a:latin typeface="Helvetica" pitchFamily="2" charset="0"/>
              </a:rPr>
              <a:t>, Naoki Muguruma</a:t>
            </a:r>
            <a:r>
              <a:rPr lang="en-IN" sz="2500" baseline="30000" dirty="0">
                <a:latin typeface="Helvetica" pitchFamily="2" charset="0"/>
              </a:rPr>
              <a:t>3</a:t>
            </a:r>
            <a:r>
              <a:rPr lang="en-IN" sz="2500" dirty="0">
                <a:latin typeface="Helvetica" pitchFamily="2" charset="0"/>
              </a:rPr>
              <a:t>, </a:t>
            </a:r>
            <a:r>
              <a:rPr lang="en-IN" sz="2500" dirty="0" err="1">
                <a:latin typeface="Helvetica" pitchFamily="2" charset="0"/>
              </a:rPr>
              <a:t>Koshi</a:t>
            </a:r>
            <a:r>
              <a:rPr lang="en-IN" sz="2500" dirty="0">
                <a:latin typeface="Helvetica" pitchFamily="2" charset="0"/>
              </a:rPr>
              <a:t> Fujikawa</a:t>
            </a:r>
            <a:r>
              <a:rPr lang="en-IN" sz="2500" baseline="30000" dirty="0">
                <a:latin typeface="Helvetica" pitchFamily="2" charset="0"/>
              </a:rPr>
              <a:t>1</a:t>
            </a:r>
            <a:r>
              <a:rPr lang="en-GB" sz="2500" dirty="0">
                <a:latin typeface="Helvetica" pitchFamily="2" charset="0"/>
              </a:rPr>
              <a:t>, Yasuo Takahashi</a:t>
            </a:r>
            <a:r>
              <a:rPr lang="en-GB" sz="2500" baseline="30000" dirty="0">
                <a:latin typeface="Helvetica" pitchFamily="2" charset="0"/>
              </a:rPr>
              <a:t>1</a:t>
            </a:r>
            <a:r>
              <a:rPr lang="en-GB" sz="2500" dirty="0">
                <a:latin typeface="Helvetica" pitchFamily="2" charset="0"/>
              </a:rPr>
              <a:t> &amp; </a:t>
            </a:r>
            <a:r>
              <a:rPr lang="en-GB" sz="2500" dirty="0" err="1">
                <a:latin typeface="Helvetica" pitchFamily="2" charset="0"/>
              </a:rPr>
              <a:t>Tetuji</a:t>
            </a:r>
            <a:r>
              <a:rPr lang="en-GB" sz="2500" dirty="0">
                <a:latin typeface="Helvetica" pitchFamily="2" charset="0"/>
              </a:rPr>
              <a:t> Tamakama</a:t>
            </a:r>
            <a:r>
              <a:rPr lang="en-GB" sz="2500" baseline="30000" dirty="0">
                <a:latin typeface="Helvetica" pitchFamily="2" charset="0"/>
              </a:rPr>
              <a:t>3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dirty="0">
                <a:latin typeface="Helvetica" pitchFamily="2" charset="0"/>
              </a:rPr>
              <a:t> 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baseline="30000" dirty="0">
                <a:latin typeface="Helvetica" pitchFamily="2" charset="0"/>
              </a:rPr>
              <a:t>1</a:t>
            </a:r>
            <a:r>
              <a:rPr lang="en-GB" sz="2500" dirty="0">
                <a:latin typeface="Helvetica" pitchFamily="2" charset="0"/>
              </a:rPr>
              <a:t>Department of Gastroenterology, Hokkaido Cancer </a:t>
            </a:r>
            <a:r>
              <a:rPr lang="en-GB" sz="2500" dirty="0" err="1">
                <a:latin typeface="Helvetica" pitchFamily="2" charset="0"/>
              </a:rPr>
              <a:t>Center</a:t>
            </a:r>
            <a:r>
              <a:rPr lang="en-GB" sz="2500" dirty="0">
                <a:latin typeface="Helvetica" pitchFamily="2" charset="0"/>
              </a:rPr>
              <a:t>, Sapporo, Hokkaido, Japan.</a:t>
            </a:r>
            <a:r>
              <a:rPr lang="en-GB" sz="2500" baseline="30000" dirty="0">
                <a:latin typeface="Helvetica" pitchFamily="2" charset="0"/>
              </a:rPr>
              <a:t> 2</a:t>
            </a:r>
            <a:r>
              <a:rPr lang="en-GB" sz="2500" dirty="0">
                <a:latin typeface="Helvetica" pitchFamily="2" charset="0"/>
              </a:rPr>
              <a:t>Department of Community Medicine for Gastroenterology and Oncology, 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dirty="0">
                <a:latin typeface="Helvetica" pitchFamily="2" charset="0"/>
              </a:rPr>
              <a:t>Tokushima University Graduate School of Biomedical Sciences, Tokushima, Japan.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baseline="30000" dirty="0">
                <a:latin typeface="Helvetica" pitchFamily="2" charset="0"/>
              </a:rPr>
              <a:t>3</a:t>
            </a:r>
            <a:r>
              <a:rPr lang="en-GB" sz="2500" dirty="0">
                <a:latin typeface="Helvetica" pitchFamily="2" charset="0"/>
              </a:rPr>
              <a:t>Department of Gastroenterology and Oncology, Tokushima University Graduate School of Biomedical Sciences, Tokushima, Japan.</a:t>
            </a:r>
            <a:r>
              <a:rPr lang="en-GB" sz="2500" baseline="30000" dirty="0">
                <a:latin typeface="Helvetica" pitchFamily="2" charset="0"/>
              </a:rPr>
              <a:t> 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baseline="30000" dirty="0">
                <a:latin typeface="Helvetica" pitchFamily="2" charset="0"/>
              </a:rPr>
              <a:t>#</a:t>
            </a:r>
            <a:r>
              <a:rPr lang="en-GB" sz="2500" dirty="0">
                <a:latin typeface="Helvetica" pitchFamily="2" charset="0"/>
              </a:rPr>
              <a:t>These authors contributed equally: Tamotsu Sagawa and Yasushi Sato.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dirty="0">
                <a:latin typeface="Helvetica" pitchFamily="2" charset="0"/>
              </a:rPr>
              <a:t> 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dirty="0">
                <a:latin typeface="Helvetica" pitchFamily="2" charset="0"/>
              </a:rPr>
              <a:t>*Corresponding author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dirty="0">
                <a:latin typeface="Helvetica" pitchFamily="2" charset="0"/>
              </a:rPr>
              <a:t>Yasushi Sato, Ph.D., MD.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dirty="0">
                <a:latin typeface="Helvetica" pitchFamily="2" charset="0"/>
              </a:rPr>
              <a:t>Department of Community Medicine for Gastroenterology and Oncology, 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dirty="0">
                <a:latin typeface="Helvetica" pitchFamily="2" charset="0"/>
              </a:rPr>
              <a:t>Tokushima University Graduate School of Biomedical Sciences, 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dirty="0">
                <a:latin typeface="Helvetica" pitchFamily="2" charset="0"/>
              </a:rPr>
              <a:t>Tokushima, Japan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IN" sz="2500" dirty="0">
                <a:latin typeface="Helvetica" pitchFamily="2" charset="0"/>
              </a:rPr>
              <a:t>Tel: +81-88-633-7122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IN" sz="2500" dirty="0">
                <a:latin typeface="Helvetica" pitchFamily="2" charset="0"/>
              </a:rPr>
              <a:t>Fax: +81-88-633-9235</a:t>
            </a:r>
            <a:endParaRPr lang="en-JP" sz="2500" dirty="0">
              <a:latin typeface="Helvetica" pitchFamily="2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2500" dirty="0">
                <a:latin typeface="Helvetica" pitchFamily="2" charset="0"/>
              </a:rPr>
              <a:t>E-mail: </a:t>
            </a:r>
            <a:r>
              <a:rPr lang="en-GB" sz="2500" u="sng" dirty="0">
                <a:latin typeface="Helvetica" pitchFamily="2" charset="0"/>
                <a:hlinkClick r:id="rId2"/>
              </a:rPr>
              <a:t>yasushis2012@gmail.com</a:t>
            </a:r>
            <a:endParaRPr lang="en-JP" sz="2500" dirty="0">
              <a:latin typeface="Helvetica" pitchFamily="2" charset="0"/>
            </a:endParaRPr>
          </a:p>
          <a:p>
            <a:endParaRPr lang="en-JP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02259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5F49458-83C2-7340-8EE6-66D03D7F1C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9890578"/>
              </p:ext>
            </p:extLst>
          </p:nvPr>
        </p:nvGraphicFramePr>
        <p:xfrm>
          <a:off x="221556" y="2137500"/>
          <a:ext cx="6354423" cy="226960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072552">
                  <a:extLst>
                    <a:ext uri="{9D8B030D-6E8A-4147-A177-3AD203B41FA5}">
                      <a16:colId xmlns:a16="http://schemas.microsoft.com/office/drawing/2014/main" val="2225190837"/>
                    </a:ext>
                  </a:extLst>
                </a:gridCol>
                <a:gridCol w="794040">
                  <a:extLst>
                    <a:ext uri="{9D8B030D-6E8A-4147-A177-3AD203B41FA5}">
                      <a16:colId xmlns:a16="http://schemas.microsoft.com/office/drawing/2014/main" val="3047816586"/>
                    </a:ext>
                  </a:extLst>
                </a:gridCol>
                <a:gridCol w="887527">
                  <a:extLst>
                    <a:ext uri="{9D8B030D-6E8A-4147-A177-3AD203B41FA5}">
                      <a16:colId xmlns:a16="http://schemas.microsoft.com/office/drawing/2014/main" val="986876935"/>
                    </a:ext>
                  </a:extLst>
                </a:gridCol>
                <a:gridCol w="949249">
                  <a:extLst>
                    <a:ext uri="{9D8B030D-6E8A-4147-A177-3AD203B41FA5}">
                      <a16:colId xmlns:a16="http://schemas.microsoft.com/office/drawing/2014/main" val="3823344240"/>
                    </a:ext>
                  </a:extLst>
                </a:gridCol>
                <a:gridCol w="151130">
                  <a:extLst>
                    <a:ext uri="{9D8B030D-6E8A-4147-A177-3AD203B41FA5}">
                      <a16:colId xmlns:a16="http://schemas.microsoft.com/office/drawing/2014/main" val="2434263542"/>
                    </a:ext>
                  </a:extLst>
                </a:gridCol>
                <a:gridCol w="808686">
                  <a:extLst>
                    <a:ext uri="{9D8B030D-6E8A-4147-A177-3AD203B41FA5}">
                      <a16:colId xmlns:a16="http://schemas.microsoft.com/office/drawing/2014/main" val="2013808623"/>
                    </a:ext>
                  </a:extLst>
                </a:gridCol>
                <a:gridCol w="852111">
                  <a:extLst>
                    <a:ext uri="{9D8B030D-6E8A-4147-A177-3AD203B41FA5}">
                      <a16:colId xmlns:a16="http://schemas.microsoft.com/office/drawing/2014/main" val="1861297327"/>
                    </a:ext>
                  </a:extLst>
                </a:gridCol>
                <a:gridCol w="839128">
                  <a:extLst>
                    <a:ext uri="{9D8B030D-6E8A-4147-A177-3AD203B41FA5}">
                      <a16:colId xmlns:a16="http://schemas.microsoft.com/office/drawing/2014/main" val="846215984"/>
                    </a:ext>
                  </a:extLst>
                </a:gridCol>
              </a:tblGrid>
              <a:tr h="294350"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865" marR="6286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tuximab</a:t>
                      </a:r>
                      <a:endParaRPr lang="en-US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200" b="1" kern="1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vacizumab</a:t>
                      </a:r>
                      <a:endParaRPr lang="en-US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01938802"/>
                  </a:ext>
                </a:extLst>
              </a:tr>
              <a:tr h="39304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-side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-side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-side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-side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8058671"/>
                  </a:ext>
                </a:extLst>
              </a:tr>
              <a:tr h="233105"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865" marR="6286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50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36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14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 = 60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40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20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155316"/>
                  </a:ext>
                </a:extLst>
              </a:tr>
              <a:tr h="269821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8.0%)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8.3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7.1%)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.0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.0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.0%)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54848567"/>
                  </a:ext>
                </a:extLst>
              </a:tr>
              <a:tr h="269821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 (58.0%)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* (69.4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* (28.6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 (55.5%)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 (57.5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50.0%)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982889629"/>
                  </a:ext>
                </a:extLst>
              </a:tr>
              <a:tr h="269821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24.0%)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6.7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42.9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 (43.3%)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40.0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50.0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3566569348"/>
                  </a:ext>
                </a:extLst>
              </a:tr>
              <a:tr h="269821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10.0%)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5.6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21.4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.7%)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.5%)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.0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/>
                </a:tc>
                <a:extLst>
                  <a:ext uri="{0D108BD9-81ED-4DB2-BD59-A6C34878D82A}">
                    <a16:rowId xmlns:a16="http://schemas.microsoft.com/office/drawing/2014/main" val="258867107"/>
                  </a:ext>
                </a:extLst>
              </a:tr>
              <a:tr h="269821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R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 (66.0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*</a:t>
                      </a: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77.8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*</a:t>
                      </a: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35.7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 (55.5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 (57.5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50%)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694316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5A32A1A-1EF0-2F4D-B148-2ED110BE89CA}"/>
              </a:ext>
            </a:extLst>
          </p:cNvPr>
          <p:cNvSpPr txBox="1"/>
          <p:nvPr/>
        </p:nvSpPr>
        <p:spPr>
          <a:xfrm>
            <a:off x="147469" y="1548865"/>
            <a:ext cx="64285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ble S1. Efficacy of the first-line treatment in patients with mCRC stratified on the basis of molecular-target agent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ocatio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9932C72-203D-3647-A81A-0724EF9C8B1F}"/>
              </a:ext>
            </a:extLst>
          </p:cNvPr>
          <p:cNvSpPr txBox="1"/>
          <p:nvPr/>
        </p:nvSpPr>
        <p:spPr>
          <a:xfrm>
            <a:off x="147469" y="4407100"/>
            <a:ext cx="662011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Abbreviations: CR, complete response; PD, progressive disease; PR, partial response; RD, recommended dose; SD, stable disease; </a:t>
            </a:r>
            <a:r>
              <a:rPr lang="x-none" sz="1050" dirty="0">
                <a:latin typeface="Arial" panose="020B0604020202020204" pitchFamily="34" charset="0"/>
                <a:cs typeface="Arial" panose="020B0604020202020204" pitchFamily="34" charset="0"/>
              </a:rPr>
              <a:t>ORR, </a:t>
            </a:r>
            <a:r>
              <a:rPr lang="x-none" sz="1050">
                <a:latin typeface="Arial" panose="020B0604020202020204" pitchFamily="34" charset="0"/>
                <a:cs typeface="Arial" panose="020B0604020202020204" pitchFamily="34" charset="0"/>
              </a:rPr>
              <a:t>overall response</a:t>
            </a:r>
            <a:r>
              <a:rPr lang="en-IN" sz="105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x-none" sz="105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x-none" sz="1050" dirty="0">
                <a:latin typeface="Arial" panose="020B0604020202020204" pitchFamily="34" charset="0"/>
                <a:cs typeface="Arial" panose="020B0604020202020204" pitchFamily="34" charset="0"/>
              </a:rPr>
              <a:t>-value for difference between tumo</a:t>
            </a:r>
            <a:r>
              <a:rPr lang="en-IN" sz="105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x-none" sz="1050" dirty="0">
                <a:latin typeface="Arial" panose="020B0604020202020204" pitchFamily="34" charset="0"/>
                <a:cs typeface="Arial" panose="020B0604020202020204" pitchFamily="34" charset="0"/>
              </a:rPr>
              <a:t>r side &lt; 0.05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74907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>
            <a:extLst>
              <a:ext uri="{FF2B5EF4-FFF2-40B4-BE49-F238E27FC236}">
                <a16:creationId xmlns:a16="http://schemas.microsoft.com/office/drawing/2014/main" id="{498425B9-E8B8-8645-95B4-BDAD6F6E144E}"/>
              </a:ext>
            </a:extLst>
          </p:cNvPr>
          <p:cNvSpPr txBox="1"/>
          <p:nvPr/>
        </p:nvSpPr>
        <p:spPr>
          <a:xfrm>
            <a:off x="4468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</a:t>
            </a:r>
          </a:p>
        </p:txBody>
      </p:sp>
      <p:sp>
        <p:nvSpPr>
          <p:cNvPr id="71" name="テキスト ボックス 33">
            <a:extLst>
              <a:ext uri="{FF2B5EF4-FFF2-40B4-BE49-F238E27FC236}">
                <a16:creationId xmlns:a16="http://schemas.microsoft.com/office/drawing/2014/main" id="{24523B7E-FD40-CD44-9FBF-1DF5209BC59C}"/>
              </a:ext>
            </a:extLst>
          </p:cNvPr>
          <p:cNvSpPr txBox="1"/>
          <p:nvPr/>
        </p:nvSpPr>
        <p:spPr>
          <a:xfrm rot="16200000">
            <a:off x="-563225" y="4573594"/>
            <a:ext cx="15905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ogression free surviva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40">
            <a:extLst>
              <a:ext uri="{FF2B5EF4-FFF2-40B4-BE49-F238E27FC236}">
                <a16:creationId xmlns:a16="http://schemas.microsoft.com/office/drawing/2014/main" id="{369BD0AE-60BC-7B48-8333-611779A96D74}"/>
              </a:ext>
            </a:extLst>
          </p:cNvPr>
          <p:cNvSpPr txBox="1"/>
          <p:nvPr/>
        </p:nvSpPr>
        <p:spPr>
          <a:xfrm rot="16200000">
            <a:off x="3073421" y="4574848"/>
            <a:ext cx="1059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33">
            <a:extLst>
              <a:ext uri="{FF2B5EF4-FFF2-40B4-BE49-F238E27FC236}">
                <a16:creationId xmlns:a16="http://schemas.microsoft.com/office/drawing/2014/main" id="{CF8D1C84-D4B7-A94D-AC72-909B69D7F3E7}"/>
              </a:ext>
            </a:extLst>
          </p:cNvPr>
          <p:cNvSpPr txBox="1"/>
          <p:nvPr/>
        </p:nvSpPr>
        <p:spPr>
          <a:xfrm rot="16200000">
            <a:off x="-564802" y="7551932"/>
            <a:ext cx="15905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ogression free surviva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40">
            <a:extLst>
              <a:ext uri="{FF2B5EF4-FFF2-40B4-BE49-F238E27FC236}">
                <a16:creationId xmlns:a16="http://schemas.microsoft.com/office/drawing/2014/main" id="{9F4097AA-EAC5-004F-A08D-8E29E84D64B2}"/>
              </a:ext>
            </a:extLst>
          </p:cNvPr>
          <p:cNvSpPr txBox="1"/>
          <p:nvPr/>
        </p:nvSpPr>
        <p:spPr>
          <a:xfrm rot="16200000">
            <a:off x="3058626" y="7520773"/>
            <a:ext cx="1059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16">
            <a:extLst>
              <a:ext uri="{FF2B5EF4-FFF2-40B4-BE49-F238E27FC236}">
                <a16:creationId xmlns:a16="http://schemas.microsoft.com/office/drawing/2014/main" id="{3D21653D-51BD-1348-A09F-7A26BBCBD528}"/>
              </a:ext>
            </a:extLst>
          </p:cNvPr>
          <p:cNvSpPr txBox="1"/>
          <p:nvPr/>
        </p:nvSpPr>
        <p:spPr>
          <a:xfrm>
            <a:off x="135891" y="3276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17">
            <a:extLst>
              <a:ext uri="{FF2B5EF4-FFF2-40B4-BE49-F238E27FC236}">
                <a16:creationId xmlns:a16="http://schemas.microsoft.com/office/drawing/2014/main" id="{DA31E742-0E92-6443-8D56-EB0CA3F46770}"/>
              </a:ext>
            </a:extLst>
          </p:cNvPr>
          <p:cNvSpPr txBox="1"/>
          <p:nvPr/>
        </p:nvSpPr>
        <p:spPr>
          <a:xfrm>
            <a:off x="3482563" y="3276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18">
            <a:extLst>
              <a:ext uri="{FF2B5EF4-FFF2-40B4-BE49-F238E27FC236}">
                <a16:creationId xmlns:a16="http://schemas.microsoft.com/office/drawing/2014/main" id="{0C5F32EB-520F-FB47-91D2-D70824630480}"/>
              </a:ext>
            </a:extLst>
          </p:cNvPr>
          <p:cNvSpPr txBox="1"/>
          <p:nvPr/>
        </p:nvSpPr>
        <p:spPr>
          <a:xfrm>
            <a:off x="135891" y="612528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19">
            <a:extLst>
              <a:ext uri="{FF2B5EF4-FFF2-40B4-BE49-F238E27FC236}">
                <a16:creationId xmlns:a16="http://schemas.microsoft.com/office/drawing/2014/main" id="{0490D454-F39D-A94E-8E79-363930E9F141}"/>
              </a:ext>
            </a:extLst>
          </p:cNvPr>
          <p:cNvSpPr txBox="1"/>
          <p:nvPr/>
        </p:nvSpPr>
        <p:spPr>
          <a:xfrm>
            <a:off x="3482563" y="612528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47">
            <a:extLst>
              <a:ext uri="{FF2B5EF4-FFF2-40B4-BE49-F238E27FC236}">
                <a16:creationId xmlns:a16="http://schemas.microsoft.com/office/drawing/2014/main" id="{1C0D9CC4-0A6C-2848-B1A1-FC863FF56BDC}"/>
              </a:ext>
            </a:extLst>
          </p:cNvPr>
          <p:cNvSpPr txBox="1"/>
          <p:nvPr/>
        </p:nvSpPr>
        <p:spPr>
          <a:xfrm>
            <a:off x="135891" y="60456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48">
            <a:extLst>
              <a:ext uri="{FF2B5EF4-FFF2-40B4-BE49-F238E27FC236}">
                <a16:creationId xmlns:a16="http://schemas.microsoft.com/office/drawing/2014/main" id="{1A8DC731-3F28-0F4E-A461-BBEDDC8AB159}"/>
              </a:ext>
            </a:extLst>
          </p:cNvPr>
          <p:cNvSpPr txBox="1"/>
          <p:nvPr/>
        </p:nvSpPr>
        <p:spPr>
          <a:xfrm>
            <a:off x="3482563" y="60456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7AF6E40-F102-524F-9C00-1C40D8769C9B}"/>
              </a:ext>
            </a:extLst>
          </p:cNvPr>
          <p:cNvSpPr txBox="1"/>
          <p:nvPr/>
        </p:nvSpPr>
        <p:spPr>
          <a:xfrm>
            <a:off x="1499669" y="6202393"/>
            <a:ext cx="1104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Bevacizumab</a:t>
            </a:r>
            <a:endParaRPr lang="x-none" sz="1200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22C7726-44D1-DE43-821D-4702ECD59140}"/>
              </a:ext>
            </a:extLst>
          </p:cNvPr>
          <p:cNvSpPr/>
          <p:nvPr/>
        </p:nvSpPr>
        <p:spPr>
          <a:xfrm>
            <a:off x="1593445" y="3344713"/>
            <a:ext cx="9172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Cetuximab</a:t>
            </a:r>
            <a:endParaRPr lang="x-none" sz="1200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50C46B1D-30E0-6549-BCC7-CCCA222C45C5}"/>
              </a:ext>
            </a:extLst>
          </p:cNvPr>
          <p:cNvSpPr txBox="1"/>
          <p:nvPr/>
        </p:nvSpPr>
        <p:spPr>
          <a:xfrm>
            <a:off x="4791966" y="6188897"/>
            <a:ext cx="1104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Bevacizumab</a:t>
            </a:r>
            <a:endParaRPr lang="x-none" sz="1200" dirty="0"/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6F2A85C9-28FF-9544-B6A4-683DA2C12689}"/>
              </a:ext>
            </a:extLst>
          </p:cNvPr>
          <p:cNvSpPr/>
          <p:nvPr/>
        </p:nvSpPr>
        <p:spPr>
          <a:xfrm>
            <a:off x="4885742" y="3346178"/>
            <a:ext cx="9172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Cetuximab</a:t>
            </a:r>
            <a:endParaRPr lang="x-none" sz="1200" dirty="0"/>
          </a:p>
        </p:txBody>
      </p:sp>
      <p:sp>
        <p:nvSpPr>
          <p:cNvPr id="90" name="テキスト ボックス 40">
            <a:extLst>
              <a:ext uri="{FF2B5EF4-FFF2-40B4-BE49-F238E27FC236}">
                <a16:creationId xmlns:a16="http://schemas.microsoft.com/office/drawing/2014/main" id="{B41B7A8D-940A-3C4C-990D-197C397D7F14}"/>
              </a:ext>
            </a:extLst>
          </p:cNvPr>
          <p:cNvSpPr txBox="1"/>
          <p:nvPr/>
        </p:nvSpPr>
        <p:spPr>
          <a:xfrm rot="16200000">
            <a:off x="3075950" y="1799455"/>
            <a:ext cx="1059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33">
            <a:extLst>
              <a:ext uri="{FF2B5EF4-FFF2-40B4-BE49-F238E27FC236}">
                <a16:creationId xmlns:a16="http://schemas.microsoft.com/office/drawing/2014/main" id="{CBCA93ED-4F6F-A242-8A97-D66DAD71521F}"/>
              </a:ext>
            </a:extLst>
          </p:cNvPr>
          <p:cNvSpPr txBox="1"/>
          <p:nvPr/>
        </p:nvSpPr>
        <p:spPr>
          <a:xfrm rot="16200000">
            <a:off x="-577158" y="1847970"/>
            <a:ext cx="15905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ogression free surviva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75">
            <a:extLst>
              <a:ext uri="{FF2B5EF4-FFF2-40B4-BE49-F238E27FC236}">
                <a16:creationId xmlns:a16="http://schemas.microsoft.com/office/drawing/2014/main" id="{7CCD23F7-9C4F-6146-95BF-06603E50763E}"/>
              </a:ext>
            </a:extLst>
          </p:cNvPr>
          <p:cNvSpPr txBox="1"/>
          <p:nvPr/>
        </p:nvSpPr>
        <p:spPr>
          <a:xfrm>
            <a:off x="1692955" y="2917717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76">
            <a:extLst>
              <a:ext uri="{FF2B5EF4-FFF2-40B4-BE49-F238E27FC236}">
                <a16:creationId xmlns:a16="http://schemas.microsoft.com/office/drawing/2014/main" id="{F7948BE5-83F4-4843-A47C-E9DB376AEAA8}"/>
              </a:ext>
            </a:extLst>
          </p:cNvPr>
          <p:cNvSpPr txBox="1"/>
          <p:nvPr/>
        </p:nvSpPr>
        <p:spPr>
          <a:xfrm>
            <a:off x="5000804" y="2908573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75">
            <a:extLst>
              <a:ext uri="{FF2B5EF4-FFF2-40B4-BE49-F238E27FC236}">
                <a16:creationId xmlns:a16="http://schemas.microsoft.com/office/drawing/2014/main" id="{9DA64456-BEBC-8649-9B2D-DA94C5947DDD}"/>
              </a:ext>
            </a:extLst>
          </p:cNvPr>
          <p:cNvSpPr txBox="1"/>
          <p:nvPr/>
        </p:nvSpPr>
        <p:spPr>
          <a:xfrm>
            <a:off x="1697071" y="5698406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76">
            <a:extLst>
              <a:ext uri="{FF2B5EF4-FFF2-40B4-BE49-F238E27FC236}">
                <a16:creationId xmlns:a16="http://schemas.microsoft.com/office/drawing/2014/main" id="{DAFA84AA-5F40-0041-BD7D-3AA711BC9C9D}"/>
              </a:ext>
            </a:extLst>
          </p:cNvPr>
          <p:cNvSpPr txBox="1"/>
          <p:nvPr/>
        </p:nvSpPr>
        <p:spPr>
          <a:xfrm>
            <a:off x="5000804" y="5689262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76">
            <a:extLst>
              <a:ext uri="{FF2B5EF4-FFF2-40B4-BE49-F238E27FC236}">
                <a16:creationId xmlns:a16="http://schemas.microsoft.com/office/drawing/2014/main" id="{E39DB7E3-53E5-DA42-A238-94A4ACD19C78}"/>
              </a:ext>
            </a:extLst>
          </p:cNvPr>
          <p:cNvSpPr txBox="1"/>
          <p:nvPr/>
        </p:nvSpPr>
        <p:spPr>
          <a:xfrm>
            <a:off x="5000804" y="8609582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3" name="グラフ 2">
            <a:extLst>
              <a:ext uri="{FF2B5EF4-FFF2-40B4-BE49-F238E27FC236}">
                <a16:creationId xmlns:a16="http://schemas.microsoft.com/office/drawing/2014/main" id="{993AC83E-7C37-E642-96E1-5D4F2A94FB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1417401"/>
              </p:ext>
            </p:extLst>
          </p:nvPr>
        </p:nvGraphicFramePr>
        <p:xfrm>
          <a:off x="378969" y="1017114"/>
          <a:ext cx="3047517" cy="19742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8" name="テキスト ボックス 50">
            <a:extLst>
              <a:ext uri="{FF2B5EF4-FFF2-40B4-BE49-F238E27FC236}">
                <a16:creationId xmlns:a16="http://schemas.microsoft.com/office/drawing/2014/main" id="{E16A95BD-D80F-1C42-9F4D-B7F1719D6D14}"/>
              </a:ext>
            </a:extLst>
          </p:cNvPr>
          <p:cNvSpPr txBox="1"/>
          <p:nvPr/>
        </p:nvSpPr>
        <p:spPr>
          <a:xfrm>
            <a:off x="1406290" y="1113789"/>
            <a:ext cx="2096965" cy="7617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900"/>
              </a:lnSpc>
              <a:tabLst>
                <a:tab pos="896938" algn="dec"/>
              </a:tabLst>
            </a:pPr>
            <a:r>
              <a:rPr lang="en-US" altLang="en-US" sz="800" u="sng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  Treatment       Median (months)</a:t>
            </a:r>
          </a:p>
          <a:p>
            <a:pPr>
              <a:lnSpc>
                <a:spcPts val="900"/>
              </a:lnSpc>
              <a:tabLst>
                <a:tab pos="1254125" algn="dec"/>
              </a:tabLst>
            </a:pPr>
            <a:r>
              <a:rPr lang="en-US" altLang="en-US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   Cetuximab	12.6</a:t>
            </a:r>
          </a:p>
          <a:p>
            <a:pPr>
              <a:lnSpc>
                <a:spcPts val="900"/>
              </a:lnSpc>
              <a:tabLst>
                <a:tab pos="1254125" algn="dec"/>
              </a:tabLst>
            </a:pP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   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Bevacizumab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	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10.2</a:t>
            </a:r>
            <a:endParaRPr kumimoji="1" lang="en-US" altLang="ja-JP" sz="8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  <a:p>
            <a:pPr>
              <a:spcBef>
                <a:spcPts val="600"/>
              </a:spcBef>
              <a:tabLst>
                <a:tab pos="1343025" algn="dec"/>
              </a:tabLst>
            </a:pP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HR (95% CI), 0.68 (0.45</a:t>
            </a:r>
            <a:r>
              <a:rPr lang="en-US" altLang="ja-JP" sz="800" dirty="0"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‒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1.02)</a:t>
            </a:r>
          </a:p>
          <a:p>
            <a:pPr>
              <a:tabLst>
                <a:tab pos="1343025" algn="dec"/>
              </a:tabLst>
            </a:pPr>
            <a:r>
              <a:rPr kumimoji="1" lang="en-US" altLang="ja-JP" sz="800" i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P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= 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0.061</a:t>
            </a:r>
            <a:endParaRPr kumimoji="1" lang="ja-JP" altLang="en-US" sz="8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graphicFrame>
        <p:nvGraphicFramePr>
          <p:cNvPr id="103" name="グラフ 4">
            <a:extLst>
              <a:ext uri="{FF2B5EF4-FFF2-40B4-BE49-F238E27FC236}">
                <a16:creationId xmlns:a16="http://schemas.microsoft.com/office/drawing/2014/main" id="{BAD0E446-0397-FC4C-B042-DBA011C47A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658009"/>
              </p:ext>
            </p:extLst>
          </p:nvPr>
        </p:nvGraphicFramePr>
        <p:xfrm>
          <a:off x="392389" y="3696822"/>
          <a:ext cx="3069052" cy="20680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5" name="グラフ 8">
            <a:extLst>
              <a:ext uri="{FF2B5EF4-FFF2-40B4-BE49-F238E27FC236}">
                <a16:creationId xmlns:a16="http://schemas.microsoft.com/office/drawing/2014/main" id="{60EA9BCF-A412-9044-A40C-853B2C10C28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2936850"/>
              </p:ext>
            </p:extLst>
          </p:nvPr>
        </p:nvGraphicFramePr>
        <p:xfrm>
          <a:off x="3802733" y="1033155"/>
          <a:ext cx="3047516" cy="19481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6" name="テキスト ボックス 50">
            <a:extLst>
              <a:ext uri="{FF2B5EF4-FFF2-40B4-BE49-F238E27FC236}">
                <a16:creationId xmlns:a16="http://schemas.microsoft.com/office/drawing/2014/main" id="{3C23BA25-06B3-184B-8572-E72E12CFC2F4}"/>
              </a:ext>
            </a:extLst>
          </p:cNvPr>
          <p:cNvSpPr txBox="1"/>
          <p:nvPr/>
        </p:nvSpPr>
        <p:spPr>
          <a:xfrm>
            <a:off x="4616691" y="1098670"/>
            <a:ext cx="2096965" cy="7617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900"/>
              </a:lnSpc>
              <a:tabLst>
                <a:tab pos="896938" algn="dec"/>
              </a:tabLst>
            </a:pPr>
            <a:r>
              <a:rPr lang="en-US" altLang="en-US" sz="800" u="sng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  Treatment       Median (months)</a:t>
            </a:r>
          </a:p>
          <a:p>
            <a:pPr>
              <a:lnSpc>
                <a:spcPts val="900"/>
              </a:lnSpc>
              <a:tabLst>
                <a:tab pos="1254125" algn="dec"/>
              </a:tabLst>
            </a:pPr>
            <a:r>
              <a:rPr lang="en-US" altLang="en-US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   Cetuximab	38.0</a:t>
            </a:r>
          </a:p>
          <a:p>
            <a:pPr>
              <a:lnSpc>
                <a:spcPts val="900"/>
              </a:lnSpc>
              <a:tabLst>
                <a:tab pos="1254125" algn="dec"/>
              </a:tabLst>
            </a:pP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   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Bevacizumab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	25.6</a:t>
            </a:r>
          </a:p>
          <a:p>
            <a:pPr>
              <a:spcBef>
                <a:spcPts val="600"/>
              </a:spcBef>
              <a:tabLst>
                <a:tab pos="1343025" algn="dec"/>
              </a:tabLst>
            </a:pP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HR (95% CI), 0.65 (0.41</a:t>
            </a:r>
            <a:r>
              <a:rPr lang="en-US" altLang="ja-JP" sz="800" dirty="0"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‒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1.01)</a:t>
            </a:r>
          </a:p>
          <a:p>
            <a:pPr>
              <a:tabLst>
                <a:tab pos="1343025" algn="dec"/>
              </a:tabLst>
            </a:pPr>
            <a:r>
              <a:rPr kumimoji="1" lang="en-US" altLang="ja-JP" sz="800" i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P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= 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0.0584</a:t>
            </a:r>
            <a:endParaRPr kumimoji="1" lang="ja-JP" altLang="en-US" sz="8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cxnSp>
        <p:nvCxnSpPr>
          <p:cNvPr id="127" name="直線コネクタ 73">
            <a:extLst>
              <a:ext uri="{FF2B5EF4-FFF2-40B4-BE49-F238E27FC236}">
                <a16:creationId xmlns:a16="http://schemas.microsoft.com/office/drawing/2014/main" id="{41E659E1-F9BB-E14B-8996-8F693CA27A66}"/>
              </a:ext>
            </a:extLst>
          </p:cNvPr>
          <p:cNvCxnSpPr>
            <a:cxnSpLocks/>
          </p:cNvCxnSpPr>
          <p:nvPr/>
        </p:nvCxnSpPr>
        <p:spPr>
          <a:xfrm>
            <a:off x="4805783" y="1321176"/>
            <a:ext cx="144000" cy="0"/>
          </a:xfrm>
          <a:prstGeom prst="line">
            <a:avLst/>
          </a:prstGeom>
          <a:noFill/>
          <a:ln w="19050" cmpd="sng">
            <a:solidFill>
              <a:srgbClr val="FF0000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8" name="直線コネクタ 74">
            <a:extLst>
              <a:ext uri="{FF2B5EF4-FFF2-40B4-BE49-F238E27FC236}">
                <a16:creationId xmlns:a16="http://schemas.microsoft.com/office/drawing/2014/main" id="{F71580E1-D481-9E49-9932-AF2713414245}"/>
              </a:ext>
            </a:extLst>
          </p:cNvPr>
          <p:cNvCxnSpPr>
            <a:cxnSpLocks/>
          </p:cNvCxnSpPr>
          <p:nvPr/>
        </p:nvCxnSpPr>
        <p:spPr>
          <a:xfrm>
            <a:off x="4805783" y="1433682"/>
            <a:ext cx="144000" cy="0"/>
          </a:xfrm>
          <a:prstGeom prst="line">
            <a:avLst/>
          </a:prstGeom>
          <a:noFill/>
          <a:ln w="19050" cmpd="sng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129" name="グラフ 8">
            <a:extLst>
              <a:ext uri="{FF2B5EF4-FFF2-40B4-BE49-F238E27FC236}">
                <a16:creationId xmlns:a16="http://schemas.microsoft.com/office/drawing/2014/main" id="{AE361867-6C59-D847-99B0-28F3E42EF36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0020948"/>
              </p:ext>
            </p:extLst>
          </p:nvPr>
        </p:nvGraphicFramePr>
        <p:xfrm>
          <a:off x="3788357" y="3881469"/>
          <a:ext cx="3061891" cy="18710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0" name="テキスト ボックス 72">
            <a:extLst>
              <a:ext uri="{FF2B5EF4-FFF2-40B4-BE49-F238E27FC236}">
                <a16:creationId xmlns:a16="http://schemas.microsoft.com/office/drawing/2014/main" id="{E6FBB35C-9170-6A45-B99F-20F4E5A952F9}"/>
              </a:ext>
            </a:extLst>
          </p:cNvPr>
          <p:cNvSpPr txBox="1"/>
          <p:nvPr/>
        </p:nvSpPr>
        <p:spPr>
          <a:xfrm>
            <a:off x="4687950" y="3771363"/>
            <a:ext cx="1834606" cy="7617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900"/>
              </a:lnSpc>
              <a:tabLst>
                <a:tab pos="896938" algn="dec"/>
              </a:tabLst>
            </a:pPr>
            <a:r>
              <a:rPr lang="en-US" altLang="en-US" sz="800" u="sng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umor location       Median (months)</a:t>
            </a:r>
          </a:p>
          <a:p>
            <a:pPr>
              <a:lnSpc>
                <a:spcPts val="900"/>
              </a:lnSpc>
              <a:tabLst>
                <a:tab pos="1343025" algn="dec"/>
              </a:tabLst>
            </a:pPr>
            <a:r>
              <a:rPr lang="en-US" altLang="en-US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Left-sided </a:t>
            </a:r>
            <a:r>
              <a:rPr lang="en-US" altLang="ja-JP" sz="800" dirty="0">
                <a:latin typeface="Arial"/>
                <a:ea typeface="メイリオ"/>
                <a:cs typeface="Arial"/>
              </a:rPr>
              <a:t>mCRC</a:t>
            </a:r>
            <a:r>
              <a:rPr lang="en-US" altLang="en-US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	50.6</a:t>
            </a:r>
          </a:p>
          <a:p>
            <a:pPr>
              <a:lnSpc>
                <a:spcPts val="900"/>
              </a:lnSpc>
              <a:tabLst>
                <a:tab pos="1343025" algn="dec"/>
              </a:tabLst>
            </a:pP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Right-sided </a:t>
            </a:r>
            <a:r>
              <a:rPr lang="en-US" altLang="ja-JP" sz="800" dirty="0">
                <a:latin typeface="Arial"/>
                <a:ea typeface="メイリオ"/>
                <a:cs typeface="Arial"/>
              </a:rPr>
              <a:t>mCRC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	11.3</a:t>
            </a:r>
          </a:p>
          <a:p>
            <a:pPr>
              <a:spcBef>
                <a:spcPts val="600"/>
              </a:spcBef>
              <a:tabLst>
                <a:tab pos="1343025" algn="dec"/>
              </a:tabLst>
            </a:pP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HR (95% CI), 0.34 (0.16</a:t>
            </a:r>
            <a:r>
              <a:rPr lang="en-US" altLang="ja-JP" sz="800" dirty="0"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‒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0.71)</a:t>
            </a:r>
          </a:p>
          <a:p>
            <a:pPr>
              <a:tabLst>
                <a:tab pos="1343025" algn="dec"/>
              </a:tabLst>
            </a:pPr>
            <a:r>
              <a:rPr kumimoji="1" lang="en-US" altLang="ja-JP" sz="800" i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P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= 0.0026</a:t>
            </a:r>
            <a:endParaRPr kumimoji="1" lang="ja-JP" altLang="en-US" sz="8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cxnSp>
        <p:nvCxnSpPr>
          <p:cNvPr id="131" name="直線コネクタ 73">
            <a:extLst>
              <a:ext uri="{FF2B5EF4-FFF2-40B4-BE49-F238E27FC236}">
                <a16:creationId xmlns:a16="http://schemas.microsoft.com/office/drawing/2014/main" id="{4796477D-3E88-334B-9593-4329C530B20A}"/>
              </a:ext>
            </a:extLst>
          </p:cNvPr>
          <p:cNvCxnSpPr>
            <a:cxnSpLocks/>
          </p:cNvCxnSpPr>
          <p:nvPr/>
        </p:nvCxnSpPr>
        <p:spPr>
          <a:xfrm>
            <a:off x="4808217" y="3984131"/>
            <a:ext cx="144000" cy="0"/>
          </a:xfrm>
          <a:prstGeom prst="line">
            <a:avLst/>
          </a:prstGeom>
          <a:noFill/>
          <a:ln w="19050" cmpd="sng">
            <a:solidFill>
              <a:srgbClr val="FF0000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2" name="直線コネクタ 74">
            <a:extLst>
              <a:ext uri="{FF2B5EF4-FFF2-40B4-BE49-F238E27FC236}">
                <a16:creationId xmlns:a16="http://schemas.microsoft.com/office/drawing/2014/main" id="{EFE6DBC8-D316-204D-A386-B6C2E7B43A72}"/>
              </a:ext>
            </a:extLst>
          </p:cNvPr>
          <p:cNvCxnSpPr>
            <a:cxnSpLocks/>
          </p:cNvCxnSpPr>
          <p:nvPr/>
        </p:nvCxnSpPr>
        <p:spPr>
          <a:xfrm>
            <a:off x="4808217" y="4096637"/>
            <a:ext cx="144000" cy="0"/>
          </a:xfrm>
          <a:prstGeom prst="line">
            <a:avLst/>
          </a:prstGeom>
          <a:noFill/>
          <a:ln w="19050" cmpd="sng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" name="テキスト ボックス 72">
            <a:extLst>
              <a:ext uri="{FF2B5EF4-FFF2-40B4-BE49-F238E27FC236}">
                <a16:creationId xmlns:a16="http://schemas.microsoft.com/office/drawing/2014/main" id="{C7EDDA86-A0E1-0147-84E7-8C67CC372B76}"/>
              </a:ext>
            </a:extLst>
          </p:cNvPr>
          <p:cNvSpPr txBox="1"/>
          <p:nvPr/>
        </p:nvSpPr>
        <p:spPr>
          <a:xfrm>
            <a:off x="1480087" y="6789705"/>
            <a:ext cx="1834606" cy="7617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900"/>
              </a:lnSpc>
              <a:tabLst>
                <a:tab pos="896938" algn="dec"/>
              </a:tabLst>
            </a:pPr>
            <a:r>
              <a:rPr lang="en-US" altLang="en-US" sz="800" u="sng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umor location       Median (months)</a:t>
            </a:r>
          </a:p>
          <a:p>
            <a:pPr>
              <a:lnSpc>
                <a:spcPts val="900"/>
              </a:lnSpc>
              <a:tabLst>
                <a:tab pos="1343025" algn="dec"/>
              </a:tabLst>
            </a:pPr>
            <a:r>
              <a:rPr lang="en-US" altLang="en-US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Left-sided </a:t>
            </a:r>
            <a:r>
              <a:rPr lang="en-US" altLang="ja-JP" sz="800" dirty="0">
                <a:latin typeface="Arial"/>
                <a:ea typeface="メイリオ"/>
                <a:cs typeface="Arial"/>
              </a:rPr>
              <a:t>mCRC</a:t>
            </a:r>
            <a:r>
              <a:rPr lang="en-US" altLang="en-US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	11.9</a:t>
            </a:r>
          </a:p>
          <a:p>
            <a:pPr>
              <a:lnSpc>
                <a:spcPts val="900"/>
              </a:lnSpc>
              <a:tabLst>
                <a:tab pos="1343025" algn="dec"/>
              </a:tabLst>
            </a:pP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Right-sided </a:t>
            </a:r>
            <a:r>
              <a:rPr lang="en-US" altLang="ja-JP" sz="800" dirty="0">
                <a:latin typeface="Arial"/>
                <a:ea typeface="メイリオ"/>
                <a:cs typeface="Arial"/>
              </a:rPr>
              <a:t>mCRC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	6.7</a:t>
            </a:r>
          </a:p>
          <a:p>
            <a:pPr>
              <a:spcBef>
                <a:spcPts val="600"/>
              </a:spcBef>
              <a:tabLst>
                <a:tab pos="1343025" algn="dec"/>
              </a:tabLst>
            </a:pP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HR (95% CI), 0.70 (0.40</a:t>
            </a:r>
            <a:r>
              <a:rPr lang="en-US" altLang="ja-JP" sz="800" dirty="0"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‒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1.22)</a:t>
            </a:r>
          </a:p>
          <a:p>
            <a:pPr>
              <a:tabLst>
                <a:tab pos="1343025" algn="dec"/>
              </a:tabLst>
            </a:pPr>
            <a:r>
              <a:rPr kumimoji="1" lang="en-US" altLang="ja-JP" sz="800" i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P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= 0.234</a:t>
            </a:r>
            <a:endParaRPr kumimoji="1" lang="ja-JP" altLang="en-US" sz="8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cxnSp>
        <p:nvCxnSpPr>
          <p:cNvPr id="134" name="直線コネクタ 73">
            <a:extLst>
              <a:ext uri="{FF2B5EF4-FFF2-40B4-BE49-F238E27FC236}">
                <a16:creationId xmlns:a16="http://schemas.microsoft.com/office/drawing/2014/main" id="{766ACFC1-AFF1-8D4C-8F77-D5731A4ED429}"/>
              </a:ext>
            </a:extLst>
          </p:cNvPr>
          <p:cNvCxnSpPr>
            <a:cxnSpLocks/>
          </p:cNvCxnSpPr>
          <p:nvPr/>
        </p:nvCxnSpPr>
        <p:spPr>
          <a:xfrm>
            <a:off x="1621176" y="7011047"/>
            <a:ext cx="144000" cy="0"/>
          </a:xfrm>
          <a:prstGeom prst="line">
            <a:avLst/>
          </a:prstGeom>
          <a:noFill/>
          <a:ln w="19050" cmpd="sng">
            <a:solidFill>
              <a:srgbClr val="FF0000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5" name="直線コネクタ 74">
            <a:extLst>
              <a:ext uri="{FF2B5EF4-FFF2-40B4-BE49-F238E27FC236}">
                <a16:creationId xmlns:a16="http://schemas.microsoft.com/office/drawing/2014/main" id="{14B36071-A5B1-8248-BCCE-B70873787C0D}"/>
              </a:ext>
            </a:extLst>
          </p:cNvPr>
          <p:cNvCxnSpPr>
            <a:cxnSpLocks/>
          </p:cNvCxnSpPr>
          <p:nvPr/>
        </p:nvCxnSpPr>
        <p:spPr>
          <a:xfrm>
            <a:off x="1621176" y="7123553"/>
            <a:ext cx="144000" cy="0"/>
          </a:xfrm>
          <a:prstGeom prst="line">
            <a:avLst/>
          </a:prstGeom>
          <a:noFill/>
          <a:ln w="19050" cmpd="sng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6" name="テキスト ボックス 76">
            <a:extLst>
              <a:ext uri="{FF2B5EF4-FFF2-40B4-BE49-F238E27FC236}">
                <a16:creationId xmlns:a16="http://schemas.microsoft.com/office/drawing/2014/main" id="{567E58D9-CBED-944D-B5AF-78DA1DD7EF93}"/>
              </a:ext>
            </a:extLst>
          </p:cNvPr>
          <p:cNvSpPr txBox="1"/>
          <p:nvPr/>
        </p:nvSpPr>
        <p:spPr>
          <a:xfrm>
            <a:off x="1721982" y="8614674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7" name="グラフ 2">
            <a:extLst>
              <a:ext uri="{FF2B5EF4-FFF2-40B4-BE49-F238E27FC236}">
                <a16:creationId xmlns:a16="http://schemas.microsoft.com/office/drawing/2014/main" id="{88880D3D-059C-2545-9EE6-B16D9FB0E0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5138762"/>
              </p:ext>
            </p:extLst>
          </p:nvPr>
        </p:nvGraphicFramePr>
        <p:xfrm>
          <a:off x="396786" y="6711305"/>
          <a:ext cx="3083477" cy="19582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38" name="テキスト ボックス 72">
            <a:extLst>
              <a:ext uri="{FF2B5EF4-FFF2-40B4-BE49-F238E27FC236}">
                <a16:creationId xmlns:a16="http://schemas.microsoft.com/office/drawing/2014/main" id="{C5300986-D74B-3649-AA64-F75C2986C857}"/>
              </a:ext>
            </a:extLst>
          </p:cNvPr>
          <p:cNvSpPr txBox="1"/>
          <p:nvPr/>
        </p:nvSpPr>
        <p:spPr>
          <a:xfrm>
            <a:off x="4686534" y="6797619"/>
            <a:ext cx="1834606" cy="7617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900"/>
              </a:lnSpc>
              <a:tabLst>
                <a:tab pos="896938" algn="dec"/>
              </a:tabLst>
            </a:pPr>
            <a:r>
              <a:rPr lang="en-US" altLang="en-US" sz="800" u="sng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umor location       Median (months)</a:t>
            </a:r>
          </a:p>
          <a:p>
            <a:pPr>
              <a:lnSpc>
                <a:spcPts val="900"/>
              </a:lnSpc>
              <a:tabLst>
                <a:tab pos="1343025" algn="dec"/>
              </a:tabLst>
            </a:pPr>
            <a:r>
              <a:rPr lang="en-US" altLang="en-US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Left-sided </a:t>
            </a:r>
            <a:r>
              <a:rPr lang="en-US" altLang="ja-JP" sz="800" dirty="0">
                <a:latin typeface="Arial"/>
                <a:ea typeface="メイリオ"/>
                <a:cs typeface="Arial"/>
              </a:rPr>
              <a:t>mCRC</a:t>
            </a:r>
            <a:r>
              <a:rPr lang="en-US" altLang="en-US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	27.8</a:t>
            </a:r>
          </a:p>
          <a:p>
            <a:pPr>
              <a:lnSpc>
                <a:spcPts val="900"/>
              </a:lnSpc>
              <a:tabLst>
                <a:tab pos="1343025" algn="dec"/>
              </a:tabLst>
            </a:pP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Right-sided </a:t>
            </a:r>
            <a:r>
              <a:rPr lang="en-US" altLang="ja-JP" sz="800" dirty="0">
                <a:latin typeface="Arial"/>
                <a:ea typeface="メイリオ"/>
                <a:cs typeface="Arial"/>
              </a:rPr>
              <a:t>mCRC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	19.0</a:t>
            </a:r>
          </a:p>
          <a:p>
            <a:pPr>
              <a:spcBef>
                <a:spcPts val="600"/>
              </a:spcBef>
              <a:tabLst>
                <a:tab pos="1343025" algn="dec"/>
              </a:tabLst>
            </a:pP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HR (95% CI), 0.48 (0.25</a:t>
            </a:r>
            <a:r>
              <a:rPr lang="en-US" altLang="ja-JP" sz="800" dirty="0"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‒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0.90)</a:t>
            </a:r>
          </a:p>
          <a:p>
            <a:pPr>
              <a:tabLst>
                <a:tab pos="1343025" algn="dec"/>
              </a:tabLst>
            </a:pPr>
            <a:r>
              <a:rPr kumimoji="1" lang="en-US" altLang="ja-JP" sz="800" i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P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= 0.0199</a:t>
            </a:r>
            <a:endParaRPr kumimoji="1" lang="ja-JP" altLang="en-US" sz="8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cxnSp>
        <p:nvCxnSpPr>
          <p:cNvPr id="139" name="直線コネクタ 73">
            <a:extLst>
              <a:ext uri="{FF2B5EF4-FFF2-40B4-BE49-F238E27FC236}">
                <a16:creationId xmlns:a16="http://schemas.microsoft.com/office/drawing/2014/main" id="{93BF4DB6-82F8-9F4A-BE00-E77D7A0EDD3B}"/>
              </a:ext>
            </a:extLst>
          </p:cNvPr>
          <p:cNvCxnSpPr>
            <a:cxnSpLocks/>
          </p:cNvCxnSpPr>
          <p:nvPr/>
        </p:nvCxnSpPr>
        <p:spPr>
          <a:xfrm>
            <a:off x="4807208" y="7010921"/>
            <a:ext cx="144000" cy="0"/>
          </a:xfrm>
          <a:prstGeom prst="line">
            <a:avLst/>
          </a:prstGeom>
          <a:noFill/>
          <a:ln w="19050" cmpd="sng">
            <a:solidFill>
              <a:srgbClr val="FF0000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0" name="直線コネクタ 74">
            <a:extLst>
              <a:ext uri="{FF2B5EF4-FFF2-40B4-BE49-F238E27FC236}">
                <a16:creationId xmlns:a16="http://schemas.microsoft.com/office/drawing/2014/main" id="{8ABD4C21-8036-4947-B423-047961A6C945}"/>
              </a:ext>
            </a:extLst>
          </p:cNvPr>
          <p:cNvCxnSpPr>
            <a:cxnSpLocks/>
          </p:cNvCxnSpPr>
          <p:nvPr/>
        </p:nvCxnSpPr>
        <p:spPr>
          <a:xfrm>
            <a:off x="4807208" y="7123427"/>
            <a:ext cx="144000" cy="0"/>
          </a:xfrm>
          <a:prstGeom prst="line">
            <a:avLst/>
          </a:prstGeom>
          <a:noFill/>
          <a:ln w="19050" cmpd="sng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141" name="グラフ 9">
            <a:extLst>
              <a:ext uri="{FF2B5EF4-FFF2-40B4-BE49-F238E27FC236}">
                <a16:creationId xmlns:a16="http://schemas.microsoft.com/office/drawing/2014/main" id="{AF3718DA-ECC6-EF46-B5B0-835670CE70A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9076414"/>
              </p:ext>
            </p:extLst>
          </p:nvPr>
        </p:nvGraphicFramePr>
        <p:xfrm>
          <a:off x="3782926" y="6711305"/>
          <a:ext cx="3075074" cy="19933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55" name="直線コネクタ 73">
            <a:extLst>
              <a:ext uri="{FF2B5EF4-FFF2-40B4-BE49-F238E27FC236}">
                <a16:creationId xmlns:a16="http://schemas.microsoft.com/office/drawing/2014/main" id="{5D0094EF-4BDF-4342-B613-2E75384B7434}"/>
              </a:ext>
            </a:extLst>
          </p:cNvPr>
          <p:cNvCxnSpPr>
            <a:cxnSpLocks/>
          </p:cNvCxnSpPr>
          <p:nvPr/>
        </p:nvCxnSpPr>
        <p:spPr>
          <a:xfrm>
            <a:off x="1635826" y="1332794"/>
            <a:ext cx="144000" cy="0"/>
          </a:xfrm>
          <a:prstGeom prst="line">
            <a:avLst/>
          </a:prstGeom>
          <a:noFill/>
          <a:ln w="19050" cmpd="sng">
            <a:solidFill>
              <a:srgbClr val="FF0000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74">
            <a:extLst>
              <a:ext uri="{FF2B5EF4-FFF2-40B4-BE49-F238E27FC236}">
                <a16:creationId xmlns:a16="http://schemas.microsoft.com/office/drawing/2014/main" id="{078E1691-3912-384B-8AA2-D6CF0CC0B0B8}"/>
              </a:ext>
            </a:extLst>
          </p:cNvPr>
          <p:cNvCxnSpPr>
            <a:cxnSpLocks/>
          </p:cNvCxnSpPr>
          <p:nvPr/>
        </p:nvCxnSpPr>
        <p:spPr>
          <a:xfrm>
            <a:off x="1635826" y="1445300"/>
            <a:ext cx="144000" cy="0"/>
          </a:xfrm>
          <a:prstGeom prst="line">
            <a:avLst/>
          </a:prstGeom>
          <a:noFill/>
          <a:ln w="19050" cmpd="sng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73">
            <a:extLst>
              <a:ext uri="{FF2B5EF4-FFF2-40B4-BE49-F238E27FC236}">
                <a16:creationId xmlns:a16="http://schemas.microsoft.com/office/drawing/2014/main" id="{828EA409-96BC-AB4A-9F3C-E69F31D64B7C}"/>
              </a:ext>
            </a:extLst>
          </p:cNvPr>
          <p:cNvCxnSpPr>
            <a:cxnSpLocks/>
          </p:cNvCxnSpPr>
          <p:nvPr/>
        </p:nvCxnSpPr>
        <p:spPr>
          <a:xfrm>
            <a:off x="1607937" y="3969643"/>
            <a:ext cx="144000" cy="0"/>
          </a:xfrm>
          <a:prstGeom prst="line">
            <a:avLst/>
          </a:prstGeom>
          <a:noFill/>
          <a:ln w="19050" cmpd="sng">
            <a:solidFill>
              <a:srgbClr val="FF0000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74">
            <a:extLst>
              <a:ext uri="{FF2B5EF4-FFF2-40B4-BE49-F238E27FC236}">
                <a16:creationId xmlns:a16="http://schemas.microsoft.com/office/drawing/2014/main" id="{F32579B4-D2E3-CB42-9114-B8AE63AB52C2}"/>
              </a:ext>
            </a:extLst>
          </p:cNvPr>
          <p:cNvCxnSpPr>
            <a:cxnSpLocks/>
          </p:cNvCxnSpPr>
          <p:nvPr/>
        </p:nvCxnSpPr>
        <p:spPr>
          <a:xfrm>
            <a:off x="1607937" y="4082149"/>
            <a:ext cx="144000" cy="0"/>
          </a:xfrm>
          <a:prstGeom prst="line">
            <a:avLst/>
          </a:prstGeom>
          <a:noFill/>
          <a:ln w="19050" cmpd="sng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72">
            <a:extLst>
              <a:ext uri="{FF2B5EF4-FFF2-40B4-BE49-F238E27FC236}">
                <a16:creationId xmlns:a16="http://schemas.microsoft.com/office/drawing/2014/main" id="{4972F6C0-BEE1-2641-920F-5E76F4E4DC7B}"/>
              </a:ext>
            </a:extLst>
          </p:cNvPr>
          <p:cNvSpPr txBox="1"/>
          <p:nvPr/>
        </p:nvSpPr>
        <p:spPr>
          <a:xfrm>
            <a:off x="1480087" y="3755389"/>
            <a:ext cx="1920746" cy="7617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900"/>
              </a:lnSpc>
              <a:tabLst>
                <a:tab pos="896938" algn="dec"/>
              </a:tabLst>
            </a:pPr>
            <a:r>
              <a:rPr lang="en-US" altLang="en-US" sz="800" u="sng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umor location       Median (months)</a:t>
            </a:r>
          </a:p>
          <a:p>
            <a:pPr>
              <a:lnSpc>
                <a:spcPts val="900"/>
              </a:lnSpc>
              <a:tabLst>
                <a:tab pos="1343025" algn="dec"/>
              </a:tabLst>
            </a:pPr>
            <a:r>
              <a:rPr lang="en-US" altLang="en-US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Left-sided </a:t>
            </a:r>
            <a:r>
              <a:rPr lang="en-US" altLang="ja-JP" sz="800" dirty="0">
                <a:latin typeface="Arial"/>
                <a:ea typeface="メイリオ"/>
                <a:cs typeface="Arial"/>
              </a:rPr>
              <a:t>mCRC</a:t>
            </a:r>
            <a:r>
              <a:rPr lang="en-US" altLang="en-US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	15.8</a:t>
            </a:r>
          </a:p>
          <a:p>
            <a:pPr>
              <a:lnSpc>
                <a:spcPts val="900"/>
              </a:lnSpc>
              <a:tabLst>
                <a:tab pos="1343025" algn="dec"/>
              </a:tabLst>
            </a:pP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   Right-sided </a:t>
            </a:r>
            <a:r>
              <a:rPr lang="en-US" altLang="ja-JP" sz="800" dirty="0">
                <a:latin typeface="Arial"/>
                <a:ea typeface="メイリオ"/>
                <a:cs typeface="Arial"/>
              </a:rPr>
              <a:t>mCRC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	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6.8</a:t>
            </a:r>
            <a:endParaRPr kumimoji="1" lang="en-US" altLang="ja-JP" sz="8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  <a:p>
            <a:pPr>
              <a:spcBef>
                <a:spcPts val="600"/>
              </a:spcBef>
              <a:tabLst>
                <a:tab pos="1343025" algn="dec"/>
              </a:tabLst>
            </a:pP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HR (95% CI), </a:t>
            </a:r>
            <a:r>
              <a:rPr lang="nb-NO" sz="800" dirty="0"/>
              <a:t>0.60</a:t>
            </a:r>
            <a:r>
              <a:rPr lang="nb-NO" sz="800" dirty="0">
                <a:latin typeface="ＭＳ Ｐゴシック" charset="-128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(0.30-1.18)</a:t>
            </a:r>
          </a:p>
          <a:p>
            <a:pPr>
              <a:tabLst>
                <a:tab pos="1343025" algn="dec"/>
              </a:tabLst>
            </a:pPr>
            <a:r>
              <a:rPr kumimoji="1" lang="en-US" altLang="ja-JP" sz="800" i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    P</a:t>
            </a:r>
            <a:r>
              <a:rPr kumimoji="1" lang="en-US" altLang="ja-JP" sz="8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= 0.136</a:t>
            </a:r>
            <a:endParaRPr kumimoji="1" lang="ja-JP" altLang="en-US" sz="8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6596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842</TotalTime>
  <Words>635</Words>
  <Application>Microsoft Macintosh PowerPoint</Application>
  <PresentationFormat>On-screen Show (4:3)</PresentationFormat>
  <Paragraphs>12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ＭＳ Ｐゴシック</vt:lpstr>
      <vt:lpstr>Arial</vt:lpstr>
      <vt:lpstr>Calibri</vt:lpstr>
      <vt:lpstr>Calibri Light</vt:lpstr>
      <vt:lpstr>Helvetica</vt:lpstr>
      <vt:lpstr>Times New Roman</vt:lpstr>
      <vt:lpstr>Office テーマ</vt:lpstr>
      <vt:lpstr>Supplementary Information  Clinical impact of primary tumour location, early tumour shrinkage, and depth of response in the treatment of metastatic colorectal cancer with first-line chemotherapy plus cetuximab or bevacizumab 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浅尾哲次</dc:creator>
  <cp:keywords/>
  <dc:description/>
  <cp:lastModifiedBy>佐藤　康史</cp:lastModifiedBy>
  <cp:revision>182</cp:revision>
  <cp:lastPrinted>2020-09-24T04:16:04Z</cp:lastPrinted>
  <dcterms:created xsi:type="dcterms:W3CDTF">2017-10-26T00:46:28Z</dcterms:created>
  <dcterms:modified xsi:type="dcterms:W3CDTF">2020-09-25T05:59:25Z</dcterms:modified>
  <cp:category/>
</cp:coreProperties>
</file>